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6"/>
  </p:notesMasterIdLst>
  <p:sldIdLst>
    <p:sldId id="323" r:id="rId2"/>
    <p:sldId id="281" r:id="rId3"/>
    <p:sldId id="324" r:id="rId4"/>
    <p:sldId id="325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Nicoletta Savalli" initials="NS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B1FE1"/>
    <a:srgbClr val="00FFFF"/>
    <a:srgbClr val="C6605E"/>
    <a:srgbClr val="F8E3BA"/>
    <a:srgbClr val="9790F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488" autoAdjust="0"/>
    <p:restoredTop sz="89734" autoAdjust="0"/>
  </p:normalViewPr>
  <p:slideViewPr>
    <p:cSldViewPr>
      <p:cViewPr varScale="1">
        <p:scale>
          <a:sx n="124" d="100"/>
          <a:sy n="124" d="100"/>
        </p:scale>
        <p:origin x="2194" y="7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5345517982688619"/>
          <c:y val="1.605436425588604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1" u="none" strike="noStrike" kern="1200" spc="0" baseline="0">
              <a:solidFill>
                <a:srgbClr val="FF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4696230187024268"/>
          <c:y val="3.2542549466690579E-2"/>
          <c:w val="0.69659983991362784"/>
          <c:h val="0.83781382748843136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YFP SIGNAL '!$AB$6</c:f>
              <c:strCache>
                <c:ptCount val="1"/>
                <c:pt idx="0">
                  <c:v>C615S/H616R-YFP</c:v>
                </c:pt>
              </c:strCache>
            </c:strRef>
          </c:tx>
          <c:spPr>
            <a:ln w="25400" cap="rnd">
              <a:solidFill>
                <a:srgbClr val="92D050"/>
              </a:solidFill>
              <a:round/>
            </a:ln>
            <a:effectLst/>
          </c:spPr>
          <c:marker>
            <c:symbol val="none"/>
          </c:marker>
          <c:xVal>
            <c:numRef>
              <c:f>'YFP SIGNAL '!$AA$7:$AA$102</c:f>
              <c:numCache>
                <c:formatCode>General</c:formatCode>
                <c:ptCount val="96"/>
                <c:pt idx="0">
                  <c:v>505</c:v>
                </c:pt>
                <c:pt idx="1">
                  <c:v>506</c:v>
                </c:pt>
                <c:pt idx="2">
                  <c:v>507</c:v>
                </c:pt>
                <c:pt idx="3">
                  <c:v>508</c:v>
                </c:pt>
                <c:pt idx="4">
                  <c:v>509</c:v>
                </c:pt>
                <c:pt idx="5">
                  <c:v>510</c:v>
                </c:pt>
                <c:pt idx="6">
                  <c:v>511</c:v>
                </c:pt>
                <c:pt idx="7">
                  <c:v>512</c:v>
                </c:pt>
                <c:pt idx="8">
                  <c:v>513</c:v>
                </c:pt>
                <c:pt idx="9">
                  <c:v>514</c:v>
                </c:pt>
                <c:pt idx="10">
                  <c:v>515</c:v>
                </c:pt>
                <c:pt idx="11">
                  <c:v>516</c:v>
                </c:pt>
                <c:pt idx="12">
                  <c:v>517</c:v>
                </c:pt>
                <c:pt idx="13">
                  <c:v>518</c:v>
                </c:pt>
                <c:pt idx="14">
                  <c:v>519</c:v>
                </c:pt>
                <c:pt idx="15">
                  <c:v>520</c:v>
                </c:pt>
                <c:pt idx="16">
                  <c:v>521</c:v>
                </c:pt>
                <c:pt idx="17">
                  <c:v>522</c:v>
                </c:pt>
                <c:pt idx="18">
                  <c:v>523</c:v>
                </c:pt>
                <c:pt idx="19">
                  <c:v>524</c:v>
                </c:pt>
                <c:pt idx="20">
                  <c:v>525</c:v>
                </c:pt>
                <c:pt idx="21">
                  <c:v>526</c:v>
                </c:pt>
                <c:pt idx="22">
                  <c:v>527</c:v>
                </c:pt>
                <c:pt idx="23">
                  <c:v>528</c:v>
                </c:pt>
                <c:pt idx="24">
                  <c:v>529</c:v>
                </c:pt>
                <c:pt idx="25">
                  <c:v>530</c:v>
                </c:pt>
                <c:pt idx="26">
                  <c:v>531</c:v>
                </c:pt>
                <c:pt idx="27">
                  <c:v>532</c:v>
                </c:pt>
                <c:pt idx="28">
                  <c:v>533</c:v>
                </c:pt>
                <c:pt idx="29">
                  <c:v>534</c:v>
                </c:pt>
                <c:pt idx="30">
                  <c:v>535</c:v>
                </c:pt>
                <c:pt idx="31">
                  <c:v>536</c:v>
                </c:pt>
                <c:pt idx="32">
                  <c:v>537</c:v>
                </c:pt>
                <c:pt idx="33">
                  <c:v>538</c:v>
                </c:pt>
                <c:pt idx="34">
                  <c:v>539</c:v>
                </c:pt>
                <c:pt idx="35">
                  <c:v>540</c:v>
                </c:pt>
                <c:pt idx="36">
                  <c:v>541</c:v>
                </c:pt>
                <c:pt idx="37">
                  <c:v>542</c:v>
                </c:pt>
                <c:pt idx="38">
                  <c:v>543</c:v>
                </c:pt>
                <c:pt idx="39">
                  <c:v>544</c:v>
                </c:pt>
                <c:pt idx="40">
                  <c:v>545</c:v>
                </c:pt>
                <c:pt idx="41">
                  <c:v>546</c:v>
                </c:pt>
                <c:pt idx="42">
                  <c:v>547</c:v>
                </c:pt>
                <c:pt idx="43">
                  <c:v>548</c:v>
                </c:pt>
                <c:pt idx="44">
                  <c:v>549</c:v>
                </c:pt>
                <c:pt idx="45">
                  <c:v>550</c:v>
                </c:pt>
                <c:pt idx="46">
                  <c:v>551</c:v>
                </c:pt>
                <c:pt idx="47">
                  <c:v>552</c:v>
                </c:pt>
                <c:pt idx="48">
                  <c:v>553</c:v>
                </c:pt>
                <c:pt idx="49">
                  <c:v>554</c:v>
                </c:pt>
                <c:pt idx="50">
                  <c:v>555</c:v>
                </c:pt>
                <c:pt idx="51">
                  <c:v>556</c:v>
                </c:pt>
                <c:pt idx="52">
                  <c:v>557</c:v>
                </c:pt>
                <c:pt idx="53">
                  <c:v>558</c:v>
                </c:pt>
                <c:pt idx="54">
                  <c:v>559</c:v>
                </c:pt>
                <c:pt idx="55">
                  <c:v>560</c:v>
                </c:pt>
                <c:pt idx="56">
                  <c:v>561</c:v>
                </c:pt>
                <c:pt idx="57">
                  <c:v>562</c:v>
                </c:pt>
                <c:pt idx="58">
                  <c:v>563</c:v>
                </c:pt>
                <c:pt idx="59">
                  <c:v>564</c:v>
                </c:pt>
                <c:pt idx="60">
                  <c:v>565</c:v>
                </c:pt>
                <c:pt idx="61">
                  <c:v>566</c:v>
                </c:pt>
                <c:pt idx="62">
                  <c:v>567</c:v>
                </c:pt>
                <c:pt idx="63">
                  <c:v>568</c:v>
                </c:pt>
                <c:pt idx="64">
                  <c:v>569</c:v>
                </c:pt>
                <c:pt idx="65">
                  <c:v>570</c:v>
                </c:pt>
                <c:pt idx="66">
                  <c:v>571</c:v>
                </c:pt>
                <c:pt idx="67">
                  <c:v>572</c:v>
                </c:pt>
                <c:pt idx="68">
                  <c:v>573</c:v>
                </c:pt>
                <c:pt idx="69">
                  <c:v>574</c:v>
                </c:pt>
                <c:pt idx="70">
                  <c:v>575</c:v>
                </c:pt>
                <c:pt idx="71">
                  <c:v>576</c:v>
                </c:pt>
                <c:pt idx="72">
                  <c:v>577</c:v>
                </c:pt>
                <c:pt idx="73">
                  <c:v>578</c:v>
                </c:pt>
                <c:pt idx="74">
                  <c:v>579</c:v>
                </c:pt>
                <c:pt idx="75">
                  <c:v>580</c:v>
                </c:pt>
                <c:pt idx="76">
                  <c:v>581</c:v>
                </c:pt>
                <c:pt idx="77">
                  <c:v>582</c:v>
                </c:pt>
                <c:pt idx="78">
                  <c:v>583</c:v>
                </c:pt>
                <c:pt idx="79">
                  <c:v>584</c:v>
                </c:pt>
                <c:pt idx="80">
                  <c:v>585</c:v>
                </c:pt>
                <c:pt idx="81">
                  <c:v>586</c:v>
                </c:pt>
                <c:pt idx="82">
                  <c:v>587</c:v>
                </c:pt>
                <c:pt idx="83">
                  <c:v>588</c:v>
                </c:pt>
                <c:pt idx="84">
                  <c:v>589</c:v>
                </c:pt>
                <c:pt idx="85">
                  <c:v>590</c:v>
                </c:pt>
                <c:pt idx="86">
                  <c:v>591</c:v>
                </c:pt>
                <c:pt idx="87">
                  <c:v>592</c:v>
                </c:pt>
                <c:pt idx="88">
                  <c:v>593</c:v>
                </c:pt>
                <c:pt idx="89">
                  <c:v>594</c:v>
                </c:pt>
                <c:pt idx="90">
                  <c:v>595</c:v>
                </c:pt>
                <c:pt idx="91">
                  <c:v>596</c:v>
                </c:pt>
                <c:pt idx="92">
                  <c:v>597</c:v>
                </c:pt>
                <c:pt idx="93">
                  <c:v>598</c:v>
                </c:pt>
                <c:pt idx="94">
                  <c:v>599</c:v>
                </c:pt>
                <c:pt idx="95">
                  <c:v>600</c:v>
                </c:pt>
              </c:numCache>
            </c:numRef>
          </c:xVal>
          <c:yVal>
            <c:numRef>
              <c:f>'YFP SIGNAL '!$AB$7:$AB$102</c:f>
              <c:numCache>
                <c:formatCode>General</c:formatCode>
                <c:ptCount val="96"/>
                <c:pt idx="0">
                  <c:v>21647290</c:v>
                </c:pt>
                <c:pt idx="1">
                  <c:v>7691330</c:v>
                </c:pt>
                <c:pt idx="2">
                  <c:v>2668600</c:v>
                </c:pt>
                <c:pt idx="3">
                  <c:v>1723470</c:v>
                </c:pt>
                <c:pt idx="4">
                  <c:v>1233390</c:v>
                </c:pt>
                <c:pt idx="5">
                  <c:v>1005750</c:v>
                </c:pt>
                <c:pt idx="6">
                  <c:v>864290</c:v>
                </c:pt>
                <c:pt idx="7">
                  <c:v>770010</c:v>
                </c:pt>
                <c:pt idx="8">
                  <c:v>717490</c:v>
                </c:pt>
                <c:pt idx="9">
                  <c:v>676750</c:v>
                </c:pt>
                <c:pt idx="10">
                  <c:v>662290</c:v>
                </c:pt>
                <c:pt idx="11">
                  <c:v>651520</c:v>
                </c:pt>
                <c:pt idx="12">
                  <c:v>647680</c:v>
                </c:pt>
                <c:pt idx="13">
                  <c:v>649970</c:v>
                </c:pt>
                <c:pt idx="14">
                  <c:v>659910</c:v>
                </c:pt>
                <c:pt idx="15">
                  <c:v>656980</c:v>
                </c:pt>
                <c:pt idx="16">
                  <c:v>666100</c:v>
                </c:pt>
                <c:pt idx="17">
                  <c:v>668310</c:v>
                </c:pt>
                <c:pt idx="18">
                  <c:v>675530</c:v>
                </c:pt>
                <c:pt idx="19">
                  <c:v>670350</c:v>
                </c:pt>
                <c:pt idx="20">
                  <c:v>662180</c:v>
                </c:pt>
                <c:pt idx="21">
                  <c:v>659370</c:v>
                </c:pt>
                <c:pt idx="22">
                  <c:v>649600</c:v>
                </c:pt>
                <c:pt idx="23">
                  <c:v>640560</c:v>
                </c:pt>
                <c:pt idx="24">
                  <c:v>628220</c:v>
                </c:pt>
                <c:pt idx="25">
                  <c:v>604090</c:v>
                </c:pt>
                <c:pt idx="26">
                  <c:v>581030</c:v>
                </c:pt>
                <c:pt idx="27">
                  <c:v>566160</c:v>
                </c:pt>
                <c:pt idx="28">
                  <c:v>547110</c:v>
                </c:pt>
                <c:pt idx="29">
                  <c:v>521220</c:v>
                </c:pt>
                <c:pt idx="30">
                  <c:v>496660</c:v>
                </c:pt>
                <c:pt idx="31">
                  <c:v>470200</c:v>
                </c:pt>
                <c:pt idx="32">
                  <c:v>449670</c:v>
                </c:pt>
                <c:pt idx="33">
                  <c:v>423610</c:v>
                </c:pt>
                <c:pt idx="34">
                  <c:v>407560</c:v>
                </c:pt>
                <c:pt idx="35">
                  <c:v>385520</c:v>
                </c:pt>
                <c:pt idx="36">
                  <c:v>372440</c:v>
                </c:pt>
                <c:pt idx="37">
                  <c:v>351340</c:v>
                </c:pt>
                <c:pt idx="38">
                  <c:v>333530</c:v>
                </c:pt>
                <c:pt idx="39">
                  <c:v>321180</c:v>
                </c:pt>
                <c:pt idx="40">
                  <c:v>313700</c:v>
                </c:pt>
                <c:pt idx="41">
                  <c:v>309510</c:v>
                </c:pt>
                <c:pt idx="42">
                  <c:v>305650</c:v>
                </c:pt>
                <c:pt idx="43">
                  <c:v>303570</c:v>
                </c:pt>
                <c:pt idx="44">
                  <c:v>293040</c:v>
                </c:pt>
                <c:pt idx="45">
                  <c:v>271400</c:v>
                </c:pt>
                <c:pt idx="46">
                  <c:v>249430</c:v>
                </c:pt>
                <c:pt idx="47">
                  <c:v>230280</c:v>
                </c:pt>
                <c:pt idx="48">
                  <c:v>212510</c:v>
                </c:pt>
                <c:pt idx="49">
                  <c:v>205670</c:v>
                </c:pt>
                <c:pt idx="50">
                  <c:v>191960</c:v>
                </c:pt>
                <c:pt idx="51">
                  <c:v>184690</c:v>
                </c:pt>
                <c:pt idx="52">
                  <c:v>176180</c:v>
                </c:pt>
                <c:pt idx="53">
                  <c:v>170140</c:v>
                </c:pt>
                <c:pt idx="54">
                  <c:v>161840</c:v>
                </c:pt>
                <c:pt idx="55">
                  <c:v>158560</c:v>
                </c:pt>
                <c:pt idx="56">
                  <c:v>152900</c:v>
                </c:pt>
                <c:pt idx="57">
                  <c:v>145080</c:v>
                </c:pt>
                <c:pt idx="58">
                  <c:v>142390</c:v>
                </c:pt>
                <c:pt idx="59">
                  <c:v>135890</c:v>
                </c:pt>
                <c:pt idx="60">
                  <c:v>130970</c:v>
                </c:pt>
                <c:pt idx="61">
                  <c:v>127360</c:v>
                </c:pt>
                <c:pt idx="62">
                  <c:v>123440</c:v>
                </c:pt>
                <c:pt idx="63">
                  <c:v>118490</c:v>
                </c:pt>
                <c:pt idx="64">
                  <c:v>116140</c:v>
                </c:pt>
                <c:pt idx="65">
                  <c:v>113660</c:v>
                </c:pt>
                <c:pt idx="66">
                  <c:v>107180</c:v>
                </c:pt>
                <c:pt idx="67">
                  <c:v>102590</c:v>
                </c:pt>
                <c:pt idx="68">
                  <c:v>98900</c:v>
                </c:pt>
                <c:pt idx="69">
                  <c:v>93680</c:v>
                </c:pt>
                <c:pt idx="70">
                  <c:v>92450</c:v>
                </c:pt>
                <c:pt idx="71">
                  <c:v>88640</c:v>
                </c:pt>
                <c:pt idx="72">
                  <c:v>85120</c:v>
                </c:pt>
                <c:pt idx="73">
                  <c:v>80550</c:v>
                </c:pt>
                <c:pt idx="74">
                  <c:v>80940</c:v>
                </c:pt>
                <c:pt idx="75">
                  <c:v>77120</c:v>
                </c:pt>
                <c:pt idx="76">
                  <c:v>76130</c:v>
                </c:pt>
                <c:pt idx="77">
                  <c:v>73330</c:v>
                </c:pt>
                <c:pt idx="78">
                  <c:v>71800</c:v>
                </c:pt>
                <c:pt idx="79">
                  <c:v>68950</c:v>
                </c:pt>
                <c:pt idx="80">
                  <c:v>67520</c:v>
                </c:pt>
                <c:pt idx="81">
                  <c:v>65960</c:v>
                </c:pt>
                <c:pt idx="82">
                  <c:v>63390</c:v>
                </c:pt>
                <c:pt idx="83">
                  <c:v>60650</c:v>
                </c:pt>
                <c:pt idx="84">
                  <c:v>58590</c:v>
                </c:pt>
                <c:pt idx="85">
                  <c:v>57090</c:v>
                </c:pt>
                <c:pt idx="86">
                  <c:v>55620</c:v>
                </c:pt>
                <c:pt idx="87">
                  <c:v>55050</c:v>
                </c:pt>
                <c:pt idx="88">
                  <c:v>52070</c:v>
                </c:pt>
                <c:pt idx="89">
                  <c:v>51970</c:v>
                </c:pt>
                <c:pt idx="90">
                  <c:v>50720</c:v>
                </c:pt>
                <c:pt idx="91">
                  <c:v>49390</c:v>
                </c:pt>
                <c:pt idx="92">
                  <c:v>49340</c:v>
                </c:pt>
                <c:pt idx="93">
                  <c:v>47290</c:v>
                </c:pt>
                <c:pt idx="94">
                  <c:v>45590</c:v>
                </c:pt>
                <c:pt idx="95">
                  <c:v>4556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52E3-4D85-A1E4-E94DAA90A6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41962320"/>
        <c:axId val="1041964400"/>
      </c:scatterChart>
      <c:valAx>
        <c:axId val="1041962320"/>
        <c:scaling>
          <c:orientation val="minMax"/>
          <c:max val="600"/>
          <c:min val="505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041964400"/>
        <c:crosses val="autoZero"/>
        <c:crossBetween val="midCat"/>
        <c:majorUnit val="20"/>
      </c:valAx>
      <c:valAx>
        <c:axId val="1041964400"/>
        <c:scaling>
          <c:orientation val="minMax"/>
          <c:max val="15000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041962320"/>
        <c:crosses val="autoZero"/>
        <c:crossBetween val="midCat"/>
        <c:majorUnit val="2500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786953529565243"/>
          <c:y val="3.225815761536970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1" u="none" strike="noStrike" kern="1200" spc="0" baseline="0">
              <a:solidFill>
                <a:srgbClr val="FF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609669161725155"/>
          <c:y val="4.4411636045494314E-2"/>
          <c:w val="0.81497462817147859"/>
          <c:h val="0.91431758530183727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YFP SIGNAL '!$AE$6</c:f>
              <c:strCache>
                <c:ptCount val="1"/>
                <c:pt idx="0">
                  <c:v>YFP</c:v>
                </c:pt>
              </c:strCache>
            </c:strRef>
          </c:tx>
          <c:spPr>
            <a:ln w="25400" cap="rnd" cmpd="sng">
              <a:solidFill>
                <a:srgbClr val="92D050"/>
              </a:solidFill>
              <a:round/>
            </a:ln>
            <a:effectLst/>
          </c:spPr>
          <c:marker>
            <c:symbol val="none"/>
          </c:marker>
          <c:dPt>
            <c:idx val="28"/>
            <c:marker>
              <c:symbol val="none"/>
            </c:marker>
            <c:bubble3D val="0"/>
            <c:extLst>
              <c:ext xmlns:c16="http://schemas.microsoft.com/office/drawing/2014/chart" uri="{C3380CC4-5D6E-409C-BE32-E72D297353CC}">
                <c16:uniqueId val="{00000000-30C2-4B3E-B6B2-C7AA90CEFFF1}"/>
              </c:ext>
            </c:extLst>
          </c:dPt>
          <c:xVal>
            <c:numRef>
              <c:f>'YFP SIGNAL '!$AD$7:$AD$116</c:f>
              <c:numCache>
                <c:formatCode>General</c:formatCode>
                <c:ptCount val="110"/>
                <c:pt idx="0">
                  <c:v>505</c:v>
                </c:pt>
                <c:pt idx="1">
                  <c:v>506</c:v>
                </c:pt>
                <c:pt idx="2">
                  <c:v>507</c:v>
                </c:pt>
                <c:pt idx="3">
                  <c:v>508</c:v>
                </c:pt>
                <c:pt idx="4">
                  <c:v>509</c:v>
                </c:pt>
                <c:pt idx="5">
                  <c:v>510</c:v>
                </c:pt>
                <c:pt idx="6">
                  <c:v>511</c:v>
                </c:pt>
                <c:pt idx="7">
                  <c:v>512</c:v>
                </c:pt>
                <c:pt idx="8">
                  <c:v>513</c:v>
                </c:pt>
                <c:pt idx="9">
                  <c:v>514</c:v>
                </c:pt>
                <c:pt idx="10">
                  <c:v>515</c:v>
                </c:pt>
                <c:pt idx="11">
                  <c:v>516</c:v>
                </c:pt>
                <c:pt idx="12">
                  <c:v>517</c:v>
                </c:pt>
                <c:pt idx="13">
                  <c:v>518</c:v>
                </c:pt>
                <c:pt idx="14">
                  <c:v>519</c:v>
                </c:pt>
                <c:pt idx="15">
                  <c:v>520</c:v>
                </c:pt>
                <c:pt idx="16">
                  <c:v>521</c:v>
                </c:pt>
                <c:pt idx="17">
                  <c:v>522</c:v>
                </c:pt>
                <c:pt idx="18">
                  <c:v>523</c:v>
                </c:pt>
                <c:pt idx="19">
                  <c:v>524</c:v>
                </c:pt>
                <c:pt idx="20">
                  <c:v>525</c:v>
                </c:pt>
                <c:pt idx="21">
                  <c:v>526</c:v>
                </c:pt>
                <c:pt idx="22">
                  <c:v>527</c:v>
                </c:pt>
                <c:pt idx="23">
                  <c:v>528</c:v>
                </c:pt>
                <c:pt idx="24">
                  <c:v>529</c:v>
                </c:pt>
                <c:pt idx="25">
                  <c:v>530</c:v>
                </c:pt>
                <c:pt idx="26">
                  <c:v>531</c:v>
                </c:pt>
                <c:pt idx="27">
                  <c:v>532</c:v>
                </c:pt>
                <c:pt idx="28">
                  <c:v>533</c:v>
                </c:pt>
                <c:pt idx="29">
                  <c:v>534</c:v>
                </c:pt>
                <c:pt idx="30">
                  <c:v>535</c:v>
                </c:pt>
                <c:pt idx="31">
                  <c:v>536</c:v>
                </c:pt>
                <c:pt idx="32">
                  <c:v>537</c:v>
                </c:pt>
                <c:pt idx="33">
                  <c:v>538</c:v>
                </c:pt>
                <c:pt idx="34">
                  <c:v>539</c:v>
                </c:pt>
                <c:pt idx="35">
                  <c:v>540</c:v>
                </c:pt>
                <c:pt idx="36">
                  <c:v>541</c:v>
                </c:pt>
                <c:pt idx="37">
                  <c:v>542</c:v>
                </c:pt>
                <c:pt idx="38">
                  <c:v>543</c:v>
                </c:pt>
                <c:pt idx="39">
                  <c:v>544</c:v>
                </c:pt>
                <c:pt idx="40">
                  <c:v>545</c:v>
                </c:pt>
                <c:pt idx="41">
                  <c:v>546</c:v>
                </c:pt>
                <c:pt idx="42">
                  <c:v>547</c:v>
                </c:pt>
                <c:pt idx="43">
                  <c:v>548</c:v>
                </c:pt>
                <c:pt idx="44">
                  <c:v>549</c:v>
                </c:pt>
                <c:pt idx="45">
                  <c:v>550</c:v>
                </c:pt>
                <c:pt idx="46">
                  <c:v>551</c:v>
                </c:pt>
                <c:pt idx="47">
                  <c:v>552</c:v>
                </c:pt>
                <c:pt idx="48">
                  <c:v>553</c:v>
                </c:pt>
                <c:pt idx="49">
                  <c:v>554</c:v>
                </c:pt>
                <c:pt idx="50">
                  <c:v>555</c:v>
                </c:pt>
                <c:pt idx="51">
                  <c:v>556</c:v>
                </c:pt>
                <c:pt idx="52">
                  <c:v>557</c:v>
                </c:pt>
                <c:pt idx="53">
                  <c:v>558</c:v>
                </c:pt>
                <c:pt idx="54">
                  <c:v>559</c:v>
                </c:pt>
                <c:pt idx="55">
                  <c:v>560</c:v>
                </c:pt>
                <c:pt idx="56">
                  <c:v>561</c:v>
                </c:pt>
                <c:pt idx="57">
                  <c:v>562</c:v>
                </c:pt>
                <c:pt idx="58">
                  <c:v>563</c:v>
                </c:pt>
                <c:pt idx="59">
                  <c:v>564</c:v>
                </c:pt>
                <c:pt idx="60">
                  <c:v>565</c:v>
                </c:pt>
                <c:pt idx="61">
                  <c:v>566</c:v>
                </c:pt>
                <c:pt idx="62">
                  <c:v>567</c:v>
                </c:pt>
                <c:pt idx="63">
                  <c:v>568</c:v>
                </c:pt>
                <c:pt idx="64">
                  <c:v>569</c:v>
                </c:pt>
                <c:pt idx="65">
                  <c:v>570</c:v>
                </c:pt>
                <c:pt idx="66">
                  <c:v>571</c:v>
                </c:pt>
                <c:pt idx="67">
                  <c:v>572</c:v>
                </c:pt>
                <c:pt idx="68">
                  <c:v>573</c:v>
                </c:pt>
                <c:pt idx="69">
                  <c:v>574</c:v>
                </c:pt>
                <c:pt idx="70">
                  <c:v>575</c:v>
                </c:pt>
                <c:pt idx="71">
                  <c:v>576</c:v>
                </c:pt>
                <c:pt idx="72">
                  <c:v>577</c:v>
                </c:pt>
                <c:pt idx="73">
                  <c:v>578</c:v>
                </c:pt>
                <c:pt idx="74">
                  <c:v>579</c:v>
                </c:pt>
                <c:pt idx="75">
                  <c:v>580</c:v>
                </c:pt>
                <c:pt idx="76">
                  <c:v>581</c:v>
                </c:pt>
                <c:pt idx="77">
                  <c:v>582</c:v>
                </c:pt>
                <c:pt idx="78">
                  <c:v>583</c:v>
                </c:pt>
                <c:pt idx="79">
                  <c:v>584</c:v>
                </c:pt>
                <c:pt idx="80">
                  <c:v>585</c:v>
                </c:pt>
                <c:pt idx="81">
                  <c:v>586</c:v>
                </c:pt>
                <c:pt idx="82">
                  <c:v>587</c:v>
                </c:pt>
                <c:pt idx="83">
                  <c:v>588</c:v>
                </c:pt>
                <c:pt idx="84">
                  <c:v>589</c:v>
                </c:pt>
                <c:pt idx="85">
                  <c:v>590</c:v>
                </c:pt>
                <c:pt idx="86">
                  <c:v>591</c:v>
                </c:pt>
                <c:pt idx="87">
                  <c:v>592</c:v>
                </c:pt>
                <c:pt idx="88">
                  <c:v>593</c:v>
                </c:pt>
                <c:pt idx="89">
                  <c:v>594</c:v>
                </c:pt>
                <c:pt idx="90">
                  <c:v>595</c:v>
                </c:pt>
                <c:pt idx="91">
                  <c:v>596</c:v>
                </c:pt>
                <c:pt idx="92">
                  <c:v>597</c:v>
                </c:pt>
                <c:pt idx="93">
                  <c:v>598</c:v>
                </c:pt>
                <c:pt idx="94">
                  <c:v>599</c:v>
                </c:pt>
                <c:pt idx="95">
                  <c:v>600</c:v>
                </c:pt>
              </c:numCache>
            </c:numRef>
          </c:xVal>
          <c:yVal>
            <c:numRef>
              <c:f>'YFP SIGNAL '!$AE$7:$AE$116</c:f>
              <c:numCache>
                <c:formatCode>General</c:formatCode>
                <c:ptCount val="110"/>
                <c:pt idx="0">
                  <c:v>9622705</c:v>
                </c:pt>
                <c:pt idx="1">
                  <c:v>1670587</c:v>
                </c:pt>
                <c:pt idx="2">
                  <c:v>831463</c:v>
                </c:pt>
                <c:pt idx="3">
                  <c:v>628202</c:v>
                </c:pt>
                <c:pt idx="4">
                  <c:v>574249</c:v>
                </c:pt>
                <c:pt idx="5">
                  <c:v>571478</c:v>
                </c:pt>
                <c:pt idx="6">
                  <c:v>595602</c:v>
                </c:pt>
                <c:pt idx="7">
                  <c:v>648577</c:v>
                </c:pt>
                <c:pt idx="8">
                  <c:v>708398</c:v>
                </c:pt>
                <c:pt idx="9">
                  <c:v>753712</c:v>
                </c:pt>
                <c:pt idx="10">
                  <c:v>842710</c:v>
                </c:pt>
                <c:pt idx="11">
                  <c:v>896337</c:v>
                </c:pt>
                <c:pt idx="12">
                  <c:v>958603</c:v>
                </c:pt>
                <c:pt idx="13">
                  <c:v>1013534</c:v>
                </c:pt>
                <c:pt idx="14">
                  <c:v>1123722</c:v>
                </c:pt>
                <c:pt idx="15">
                  <c:v>1159908</c:v>
                </c:pt>
                <c:pt idx="16">
                  <c:v>1196094</c:v>
                </c:pt>
                <c:pt idx="17">
                  <c:v>1241897</c:v>
                </c:pt>
                <c:pt idx="18">
                  <c:v>1227064</c:v>
                </c:pt>
                <c:pt idx="19">
                  <c:v>1285418</c:v>
                </c:pt>
                <c:pt idx="20">
                  <c:v>1257056</c:v>
                </c:pt>
                <c:pt idx="21">
                  <c:v>1257056</c:v>
                </c:pt>
                <c:pt idx="22">
                  <c:v>1235866</c:v>
                </c:pt>
                <c:pt idx="23">
                  <c:v>1213372</c:v>
                </c:pt>
                <c:pt idx="24">
                  <c:v>1183706</c:v>
                </c:pt>
                <c:pt idx="25">
                  <c:v>1125678</c:v>
                </c:pt>
                <c:pt idx="26">
                  <c:v>1096990</c:v>
                </c:pt>
                <c:pt idx="27">
                  <c:v>1021847</c:v>
                </c:pt>
                <c:pt idx="28">
                  <c:v>1006525</c:v>
                </c:pt>
                <c:pt idx="29">
                  <c:v>911822</c:v>
                </c:pt>
                <c:pt idx="30">
                  <c:v>876451</c:v>
                </c:pt>
                <c:pt idx="31">
                  <c:v>832767</c:v>
                </c:pt>
                <c:pt idx="32">
                  <c:v>777021</c:v>
                </c:pt>
                <c:pt idx="33">
                  <c:v>737901</c:v>
                </c:pt>
                <c:pt idx="34">
                  <c:v>717363</c:v>
                </c:pt>
                <c:pt idx="35">
                  <c:v>653467</c:v>
                </c:pt>
                <c:pt idx="36">
                  <c:v>625268</c:v>
                </c:pt>
                <c:pt idx="37">
                  <c:v>587452</c:v>
                </c:pt>
                <c:pt idx="38">
                  <c:v>545887</c:v>
                </c:pt>
                <c:pt idx="39">
                  <c:v>533825</c:v>
                </c:pt>
                <c:pt idx="40">
                  <c:v>493238</c:v>
                </c:pt>
                <c:pt idx="41">
                  <c:v>471396</c:v>
                </c:pt>
                <c:pt idx="42">
                  <c:v>449228</c:v>
                </c:pt>
                <c:pt idx="43">
                  <c:v>419399</c:v>
                </c:pt>
                <c:pt idx="44">
                  <c:v>406359</c:v>
                </c:pt>
                <c:pt idx="45">
                  <c:v>390059</c:v>
                </c:pt>
                <c:pt idx="46">
                  <c:v>348820</c:v>
                </c:pt>
                <c:pt idx="47">
                  <c:v>351917</c:v>
                </c:pt>
                <c:pt idx="48">
                  <c:v>330564</c:v>
                </c:pt>
                <c:pt idx="49">
                  <c:v>330075</c:v>
                </c:pt>
                <c:pt idx="50">
                  <c:v>308396</c:v>
                </c:pt>
                <c:pt idx="51">
                  <c:v>284761</c:v>
                </c:pt>
                <c:pt idx="52">
                  <c:v>283946</c:v>
                </c:pt>
                <c:pt idx="53">
                  <c:v>270743</c:v>
                </c:pt>
                <c:pt idx="54">
                  <c:v>279219</c:v>
                </c:pt>
                <c:pt idx="55">
                  <c:v>263897</c:v>
                </c:pt>
                <c:pt idx="56">
                  <c:v>254280</c:v>
                </c:pt>
                <c:pt idx="57">
                  <c:v>238469</c:v>
                </c:pt>
                <c:pt idx="58">
                  <c:v>227548</c:v>
                </c:pt>
                <c:pt idx="59">
                  <c:v>206684</c:v>
                </c:pt>
                <c:pt idx="60">
                  <c:v>213530</c:v>
                </c:pt>
                <c:pt idx="61">
                  <c:v>204076</c:v>
                </c:pt>
                <c:pt idx="62">
                  <c:v>196578</c:v>
                </c:pt>
                <c:pt idx="63">
                  <c:v>194296</c:v>
                </c:pt>
                <c:pt idx="64">
                  <c:v>181745</c:v>
                </c:pt>
                <c:pt idx="65">
                  <c:v>171313</c:v>
                </c:pt>
                <c:pt idx="66">
                  <c:v>174247</c:v>
                </c:pt>
                <c:pt idx="67">
                  <c:v>156480</c:v>
                </c:pt>
                <c:pt idx="68">
                  <c:v>161207</c:v>
                </c:pt>
                <c:pt idx="69">
                  <c:v>143277</c:v>
                </c:pt>
                <c:pt idx="70">
                  <c:v>149145</c:v>
                </c:pt>
                <c:pt idx="71">
                  <c:v>134475</c:v>
                </c:pt>
                <c:pt idx="72">
                  <c:v>122250</c:v>
                </c:pt>
                <c:pt idx="73">
                  <c:v>120783</c:v>
                </c:pt>
                <c:pt idx="74">
                  <c:v>120294</c:v>
                </c:pt>
                <c:pt idx="75">
                  <c:v>116871</c:v>
                </c:pt>
                <c:pt idx="76">
                  <c:v>105624</c:v>
                </c:pt>
                <c:pt idx="77">
                  <c:v>97800</c:v>
                </c:pt>
                <c:pt idx="78">
                  <c:v>91280</c:v>
                </c:pt>
                <c:pt idx="79">
                  <c:v>89487</c:v>
                </c:pt>
                <c:pt idx="80">
                  <c:v>83456</c:v>
                </c:pt>
                <c:pt idx="81">
                  <c:v>80685</c:v>
                </c:pt>
                <c:pt idx="82">
                  <c:v>74817</c:v>
                </c:pt>
                <c:pt idx="83">
                  <c:v>71394</c:v>
                </c:pt>
                <c:pt idx="84">
                  <c:v>62755</c:v>
                </c:pt>
                <c:pt idx="85">
                  <c:v>68623</c:v>
                </c:pt>
                <c:pt idx="86">
                  <c:v>63244</c:v>
                </c:pt>
                <c:pt idx="87">
                  <c:v>58843</c:v>
                </c:pt>
                <c:pt idx="88">
                  <c:v>51997</c:v>
                </c:pt>
                <c:pt idx="89">
                  <c:v>49552</c:v>
                </c:pt>
                <c:pt idx="90">
                  <c:v>53953</c:v>
                </c:pt>
                <c:pt idx="91">
                  <c:v>50856</c:v>
                </c:pt>
                <c:pt idx="92">
                  <c:v>50693</c:v>
                </c:pt>
                <c:pt idx="93">
                  <c:v>46781</c:v>
                </c:pt>
                <c:pt idx="94">
                  <c:v>44336</c:v>
                </c:pt>
                <c:pt idx="95">
                  <c:v>4319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30C2-4B3E-B6B2-C7AA90CEFF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21473280"/>
        <c:axId val="821472864"/>
      </c:scatterChart>
      <c:valAx>
        <c:axId val="821473280"/>
        <c:scaling>
          <c:orientation val="minMax"/>
          <c:max val="600"/>
          <c:min val="505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821472864"/>
        <c:crosses val="autoZero"/>
        <c:crossBetween val="midCat"/>
        <c:majorUnit val="20"/>
      </c:valAx>
      <c:valAx>
        <c:axId val="821472864"/>
        <c:scaling>
          <c:orientation val="minMax"/>
          <c:max val="1500000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21473280"/>
        <c:crosses val="autoZero"/>
        <c:crossBetween val="midCat"/>
        <c:majorUnit val="2500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65975646106935004"/>
          <c:y val="3.319502074688796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1" u="none" strike="noStrike" kern="1200" spc="0" baseline="0">
              <a:solidFill>
                <a:srgbClr val="FF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3547675638637289"/>
          <c:y val="3.7002449032706233E-2"/>
          <c:w val="0.81897462817147848"/>
          <c:h val="0.84588764946048411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YFP SIGNAL '!$AG$6</c:f>
              <c:strCache>
                <c:ptCount val="1"/>
                <c:pt idx="0">
                  <c:v>WT-YFP</c:v>
                </c:pt>
              </c:strCache>
            </c:strRef>
          </c:tx>
          <c:spPr>
            <a:ln w="25400" cap="rnd">
              <a:solidFill>
                <a:srgbClr val="92D050"/>
              </a:solidFill>
              <a:round/>
            </a:ln>
            <a:effectLst/>
          </c:spPr>
          <c:marker>
            <c:symbol val="none"/>
          </c:marker>
          <c:xVal>
            <c:numRef>
              <c:f>'YFP SIGNAL '!$AF$7:$AF$102</c:f>
              <c:numCache>
                <c:formatCode>General</c:formatCode>
                <c:ptCount val="96"/>
                <c:pt idx="0">
                  <c:v>505</c:v>
                </c:pt>
                <c:pt idx="1">
                  <c:v>506</c:v>
                </c:pt>
                <c:pt idx="2">
                  <c:v>507</c:v>
                </c:pt>
                <c:pt idx="3">
                  <c:v>508</c:v>
                </c:pt>
                <c:pt idx="4">
                  <c:v>509</c:v>
                </c:pt>
                <c:pt idx="5">
                  <c:v>510</c:v>
                </c:pt>
                <c:pt idx="6">
                  <c:v>511</c:v>
                </c:pt>
                <c:pt idx="7">
                  <c:v>512</c:v>
                </c:pt>
                <c:pt idx="8">
                  <c:v>513</c:v>
                </c:pt>
                <c:pt idx="9">
                  <c:v>514</c:v>
                </c:pt>
                <c:pt idx="10">
                  <c:v>515</c:v>
                </c:pt>
                <c:pt idx="11">
                  <c:v>516</c:v>
                </c:pt>
                <c:pt idx="12">
                  <c:v>517</c:v>
                </c:pt>
                <c:pt idx="13">
                  <c:v>518</c:v>
                </c:pt>
                <c:pt idx="14">
                  <c:v>519</c:v>
                </c:pt>
                <c:pt idx="15">
                  <c:v>520</c:v>
                </c:pt>
                <c:pt idx="16">
                  <c:v>521</c:v>
                </c:pt>
                <c:pt idx="17">
                  <c:v>522</c:v>
                </c:pt>
                <c:pt idx="18">
                  <c:v>523</c:v>
                </c:pt>
                <c:pt idx="19">
                  <c:v>524</c:v>
                </c:pt>
                <c:pt idx="20">
                  <c:v>525</c:v>
                </c:pt>
                <c:pt idx="21">
                  <c:v>526</c:v>
                </c:pt>
                <c:pt idx="22">
                  <c:v>527</c:v>
                </c:pt>
                <c:pt idx="23">
                  <c:v>528</c:v>
                </c:pt>
                <c:pt idx="24">
                  <c:v>529</c:v>
                </c:pt>
                <c:pt idx="25">
                  <c:v>530</c:v>
                </c:pt>
                <c:pt idx="26">
                  <c:v>531</c:v>
                </c:pt>
                <c:pt idx="27">
                  <c:v>532</c:v>
                </c:pt>
                <c:pt idx="28">
                  <c:v>533</c:v>
                </c:pt>
                <c:pt idx="29">
                  <c:v>534</c:v>
                </c:pt>
                <c:pt idx="30">
                  <c:v>535</c:v>
                </c:pt>
                <c:pt idx="31">
                  <c:v>536</c:v>
                </c:pt>
                <c:pt idx="32">
                  <c:v>537</c:v>
                </c:pt>
                <c:pt idx="33">
                  <c:v>538</c:v>
                </c:pt>
                <c:pt idx="34">
                  <c:v>539</c:v>
                </c:pt>
                <c:pt idx="35">
                  <c:v>540</c:v>
                </c:pt>
                <c:pt idx="36">
                  <c:v>541</c:v>
                </c:pt>
                <c:pt idx="37">
                  <c:v>542</c:v>
                </c:pt>
                <c:pt idx="38">
                  <c:v>543</c:v>
                </c:pt>
                <c:pt idx="39">
                  <c:v>544</c:v>
                </c:pt>
                <c:pt idx="40">
                  <c:v>545</c:v>
                </c:pt>
                <c:pt idx="41">
                  <c:v>546</c:v>
                </c:pt>
                <c:pt idx="42">
                  <c:v>547</c:v>
                </c:pt>
                <c:pt idx="43">
                  <c:v>548</c:v>
                </c:pt>
                <c:pt idx="44">
                  <c:v>549</c:v>
                </c:pt>
                <c:pt idx="45">
                  <c:v>550</c:v>
                </c:pt>
                <c:pt idx="46">
                  <c:v>551</c:v>
                </c:pt>
                <c:pt idx="47">
                  <c:v>552</c:v>
                </c:pt>
                <c:pt idx="48">
                  <c:v>553</c:v>
                </c:pt>
                <c:pt idx="49">
                  <c:v>554</c:v>
                </c:pt>
                <c:pt idx="50">
                  <c:v>555</c:v>
                </c:pt>
                <c:pt idx="51">
                  <c:v>556</c:v>
                </c:pt>
                <c:pt idx="52">
                  <c:v>557</c:v>
                </c:pt>
                <c:pt idx="53">
                  <c:v>558</c:v>
                </c:pt>
                <c:pt idx="54">
                  <c:v>559</c:v>
                </c:pt>
                <c:pt idx="55">
                  <c:v>560</c:v>
                </c:pt>
                <c:pt idx="56">
                  <c:v>561</c:v>
                </c:pt>
                <c:pt idx="57">
                  <c:v>562</c:v>
                </c:pt>
                <c:pt idx="58">
                  <c:v>563</c:v>
                </c:pt>
                <c:pt idx="59">
                  <c:v>564</c:v>
                </c:pt>
                <c:pt idx="60">
                  <c:v>565</c:v>
                </c:pt>
                <c:pt idx="61">
                  <c:v>566</c:v>
                </c:pt>
                <c:pt idx="62">
                  <c:v>567</c:v>
                </c:pt>
                <c:pt idx="63">
                  <c:v>568</c:v>
                </c:pt>
                <c:pt idx="64">
                  <c:v>569</c:v>
                </c:pt>
                <c:pt idx="65">
                  <c:v>570</c:v>
                </c:pt>
                <c:pt idx="66">
                  <c:v>571</c:v>
                </c:pt>
                <c:pt idx="67">
                  <c:v>572</c:v>
                </c:pt>
                <c:pt idx="68">
                  <c:v>573</c:v>
                </c:pt>
                <c:pt idx="69">
                  <c:v>574</c:v>
                </c:pt>
                <c:pt idx="70">
                  <c:v>575</c:v>
                </c:pt>
                <c:pt idx="71">
                  <c:v>576</c:v>
                </c:pt>
                <c:pt idx="72">
                  <c:v>577</c:v>
                </c:pt>
                <c:pt idx="73">
                  <c:v>578</c:v>
                </c:pt>
                <c:pt idx="74">
                  <c:v>579</c:v>
                </c:pt>
                <c:pt idx="75">
                  <c:v>580</c:v>
                </c:pt>
                <c:pt idx="76">
                  <c:v>581</c:v>
                </c:pt>
                <c:pt idx="77">
                  <c:v>582</c:v>
                </c:pt>
                <c:pt idx="78">
                  <c:v>583</c:v>
                </c:pt>
                <c:pt idx="79">
                  <c:v>584</c:v>
                </c:pt>
                <c:pt idx="80">
                  <c:v>585</c:v>
                </c:pt>
                <c:pt idx="81">
                  <c:v>586</c:v>
                </c:pt>
                <c:pt idx="82">
                  <c:v>587</c:v>
                </c:pt>
                <c:pt idx="83">
                  <c:v>588</c:v>
                </c:pt>
                <c:pt idx="84">
                  <c:v>589</c:v>
                </c:pt>
                <c:pt idx="85">
                  <c:v>590</c:v>
                </c:pt>
                <c:pt idx="86">
                  <c:v>591</c:v>
                </c:pt>
                <c:pt idx="87">
                  <c:v>592</c:v>
                </c:pt>
                <c:pt idx="88">
                  <c:v>593</c:v>
                </c:pt>
                <c:pt idx="89">
                  <c:v>594</c:v>
                </c:pt>
                <c:pt idx="90">
                  <c:v>595</c:v>
                </c:pt>
                <c:pt idx="91">
                  <c:v>596</c:v>
                </c:pt>
                <c:pt idx="92">
                  <c:v>597</c:v>
                </c:pt>
                <c:pt idx="93">
                  <c:v>598</c:v>
                </c:pt>
                <c:pt idx="94">
                  <c:v>599</c:v>
                </c:pt>
                <c:pt idx="95">
                  <c:v>600</c:v>
                </c:pt>
              </c:numCache>
            </c:numRef>
          </c:xVal>
          <c:yVal>
            <c:numRef>
              <c:f>'YFP SIGNAL '!$AG$7:$AG$102</c:f>
              <c:numCache>
                <c:formatCode>General</c:formatCode>
                <c:ptCount val="96"/>
                <c:pt idx="0">
                  <c:v>21715090</c:v>
                </c:pt>
                <c:pt idx="1">
                  <c:v>8263060</c:v>
                </c:pt>
                <c:pt idx="2">
                  <c:v>2720740</c:v>
                </c:pt>
                <c:pt idx="3">
                  <c:v>1775360</c:v>
                </c:pt>
                <c:pt idx="4">
                  <c:v>1260310</c:v>
                </c:pt>
                <c:pt idx="5">
                  <c:v>1009830</c:v>
                </c:pt>
                <c:pt idx="6">
                  <c:v>880310</c:v>
                </c:pt>
                <c:pt idx="7">
                  <c:v>787140</c:v>
                </c:pt>
                <c:pt idx="8">
                  <c:v>724520</c:v>
                </c:pt>
                <c:pt idx="9">
                  <c:v>696170</c:v>
                </c:pt>
                <c:pt idx="10">
                  <c:v>661380</c:v>
                </c:pt>
                <c:pt idx="11">
                  <c:v>656820</c:v>
                </c:pt>
                <c:pt idx="12">
                  <c:v>656190</c:v>
                </c:pt>
                <c:pt idx="13">
                  <c:v>651490</c:v>
                </c:pt>
                <c:pt idx="14">
                  <c:v>658950</c:v>
                </c:pt>
                <c:pt idx="15">
                  <c:v>671500</c:v>
                </c:pt>
                <c:pt idx="16">
                  <c:v>665580</c:v>
                </c:pt>
                <c:pt idx="17">
                  <c:v>676120</c:v>
                </c:pt>
                <c:pt idx="18">
                  <c:v>674970</c:v>
                </c:pt>
                <c:pt idx="19">
                  <c:v>676670</c:v>
                </c:pt>
                <c:pt idx="20">
                  <c:v>676470</c:v>
                </c:pt>
                <c:pt idx="21">
                  <c:v>669850</c:v>
                </c:pt>
                <c:pt idx="22">
                  <c:v>657000</c:v>
                </c:pt>
                <c:pt idx="23">
                  <c:v>645410</c:v>
                </c:pt>
                <c:pt idx="24">
                  <c:v>625950</c:v>
                </c:pt>
                <c:pt idx="25">
                  <c:v>605300</c:v>
                </c:pt>
                <c:pt idx="26">
                  <c:v>588780</c:v>
                </c:pt>
                <c:pt idx="27">
                  <c:v>567580</c:v>
                </c:pt>
                <c:pt idx="28">
                  <c:v>548420</c:v>
                </c:pt>
                <c:pt idx="29">
                  <c:v>520070</c:v>
                </c:pt>
                <c:pt idx="30">
                  <c:v>498300</c:v>
                </c:pt>
                <c:pt idx="31">
                  <c:v>478010</c:v>
                </c:pt>
                <c:pt idx="32">
                  <c:v>451010</c:v>
                </c:pt>
                <c:pt idx="33">
                  <c:v>428080</c:v>
                </c:pt>
                <c:pt idx="34">
                  <c:v>409060</c:v>
                </c:pt>
                <c:pt idx="35">
                  <c:v>389360</c:v>
                </c:pt>
                <c:pt idx="36">
                  <c:v>370030</c:v>
                </c:pt>
                <c:pt idx="37">
                  <c:v>359140</c:v>
                </c:pt>
                <c:pt idx="38">
                  <c:v>334780</c:v>
                </c:pt>
                <c:pt idx="39">
                  <c:v>323090</c:v>
                </c:pt>
                <c:pt idx="40">
                  <c:v>315760</c:v>
                </c:pt>
                <c:pt idx="41">
                  <c:v>310170</c:v>
                </c:pt>
                <c:pt idx="42">
                  <c:v>310900</c:v>
                </c:pt>
                <c:pt idx="43">
                  <c:v>309050</c:v>
                </c:pt>
                <c:pt idx="44">
                  <c:v>296660</c:v>
                </c:pt>
                <c:pt idx="45">
                  <c:v>273800</c:v>
                </c:pt>
                <c:pt idx="46">
                  <c:v>252320</c:v>
                </c:pt>
                <c:pt idx="47">
                  <c:v>232520</c:v>
                </c:pt>
                <c:pt idx="48">
                  <c:v>216500</c:v>
                </c:pt>
                <c:pt idx="49">
                  <c:v>204020</c:v>
                </c:pt>
                <c:pt idx="50">
                  <c:v>194930</c:v>
                </c:pt>
                <c:pt idx="51">
                  <c:v>191080</c:v>
                </c:pt>
                <c:pt idx="52">
                  <c:v>181610</c:v>
                </c:pt>
                <c:pt idx="53">
                  <c:v>173290</c:v>
                </c:pt>
                <c:pt idx="54">
                  <c:v>166380</c:v>
                </c:pt>
                <c:pt idx="55">
                  <c:v>158850</c:v>
                </c:pt>
                <c:pt idx="56">
                  <c:v>153830</c:v>
                </c:pt>
                <c:pt idx="57">
                  <c:v>149510</c:v>
                </c:pt>
                <c:pt idx="58">
                  <c:v>143210</c:v>
                </c:pt>
                <c:pt idx="59">
                  <c:v>137540</c:v>
                </c:pt>
                <c:pt idx="60">
                  <c:v>135170</c:v>
                </c:pt>
                <c:pt idx="61">
                  <c:v>130420</c:v>
                </c:pt>
                <c:pt idx="62">
                  <c:v>123930</c:v>
                </c:pt>
                <c:pt idx="63">
                  <c:v>121570</c:v>
                </c:pt>
                <c:pt idx="64">
                  <c:v>116180</c:v>
                </c:pt>
                <c:pt idx="65">
                  <c:v>113230</c:v>
                </c:pt>
                <c:pt idx="66">
                  <c:v>108090</c:v>
                </c:pt>
                <c:pt idx="67">
                  <c:v>104110</c:v>
                </c:pt>
                <c:pt idx="68">
                  <c:v>100060</c:v>
                </c:pt>
                <c:pt idx="69">
                  <c:v>96050</c:v>
                </c:pt>
                <c:pt idx="70">
                  <c:v>91700</c:v>
                </c:pt>
                <c:pt idx="71">
                  <c:v>90480</c:v>
                </c:pt>
                <c:pt idx="72">
                  <c:v>85080</c:v>
                </c:pt>
                <c:pt idx="73">
                  <c:v>82850</c:v>
                </c:pt>
                <c:pt idx="74">
                  <c:v>78250</c:v>
                </c:pt>
                <c:pt idx="75">
                  <c:v>78820</c:v>
                </c:pt>
                <c:pt idx="76">
                  <c:v>77580</c:v>
                </c:pt>
                <c:pt idx="77">
                  <c:v>74420</c:v>
                </c:pt>
                <c:pt idx="78">
                  <c:v>73430</c:v>
                </c:pt>
                <c:pt idx="79">
                  <c:v>71220</c:v>
                </c:pt>
                <c:pt idx="80">
                  <c:v>68400</c:v>
                </c:pt>
                <c:pt idx="81">
                  <c:v>64510</c:v>
                </c:pt>
                <c:pt idx="82">
                  <c:v>64090</c:v>
                </c:pt>
                <c:pt idx="83">
                  <c:v>61470</c:v>
                </c:pt>
                <c:pt idx="84">
                  <c:v>59410</c:v>
                </c:pt>
                <c:pt idx="85">
                  <c:v>59740</c:v>
                </c:pt>
                <c:pt idx="86">
                  <c:v>56780</c:v>
                </c:pt>
                <c:pt idx="87">
                  <c:v>55510</c:v>
                </c:pt>
                <c:pt idx="88">
                  <c:v>54480</c:v>
                </c:pt>
                <c:pt idx="89">
                  <c:v>53040</c:v>
                </c:pt>
                <c:pt idx="90">
                  <c:v>52000</c:v>
                </c:pt>
                <c:pt idx="91">
                  <c:v>50760</c:v>
                </c:pt>
                <c:pt idx="92">
                  <c:v>49420</c:v>
                </c:pt>
                <c:pt idx="93">
                  <c:v>48710</c:v>
                </c:pt>
                <c:pt idx="94">
                  <c:v>48430</c:v>
                </c:pt>
                <c:pt idx="95">
                  <c:v>4551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806C-4EAF-8C7C-F6D9CFFD36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41958576"/>
        <c:axId val="1041960240"/>
      </c:scatterChart>
      <c:valAx>
        <c:axId val="1041958576"/>
        <c:scaling>
          <c:orientation val="minMax"/>
          <c:max val="600"/>
          <c:min val="505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041960240"/>
        <c:crosses val="autoZero"/>
        <c:crossBetween val="midCat"/>
        <c:majorUnit val="20"/>
      </c:valAx>
      <c:valAx>
        <c:axId val="1041960240"/>
        <c:scaling>
          <c:orientation val="minMax"/>
          <c:max val="1500000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041958576"/>
        <c:crosses val="autoZero"/>
        <c:crossBetween val="midCat"/>
        <c:majorUnit val="2500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6584</cdr:x>
      <cdr:y>0.72857</cdr:y>
    </cdr:from>
    <cdr:to>
      <cdr:x>0.69793</cdr:x>
      <cdr:y>0.85679</cdr:y>
    </cdr:to>
    <cdr:sp macro="" textlink="">
      <cdr:nvSpPr>
        <cdr:cNvPr id="2" name="TextBox 26"/>
        <cdr:cNvSpPr txBox="1"/>
      </cdr:nvSpPr>
      <cdr:spPr>
        <a:xfrm xmlns:a="http://schemas.openxmlformats.org/drawingml/2006/main">
          <a:off x="656316" y="1399020"/>
          <a:ext cx="1066800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l-GR" sz="1000" b="1" i="1" dirty="0">
              <a:solidFill>
                <a:srgbClr val="0000FF"/>
              </a:solidFill>
              <a:latin typeface="Arial" pitchFamily="34" charset="0"/>
              <a:cs typeface="Arial" pitchFamily="34" charset="0"/>
            </a:rPr>
            <a:t>λ</a:t>
          </a:r>
          <a:r>
            <a:rPr lang="en-US" sz="1000" b="1" i="1" baseline="-25000" dirty="0">
              <a:solidFill>
                <a:srgbClr val="0000FF"/>
              </a:solidFill>
              <a:latin typeface="Arial" pitchFamily="34" charset="0"/>
              <a:cs typeface="Arial" pitchFamily="34" charset="0"/>
            </a:rPr>
            <a:t>ext</a:t>
          </a:r>
          <a:r>
            <a:rPr lang="en-US" sz="1000" b="1" i="1" dirty="0">
              <a:solidFill>
                <a:srgbClr val="0000FF"/>
              </a:solidFill>
              <a:latin typeface="Arial" pitchFamily="34" charset="0"/>
              <a:cs typeface="Arial" pitchFamily="34" charset="0"/>
            </a:rPr>
            <a:t> 500 nm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5FDDBC-5D4D-4B28-B753-53D2BEED2927}" type="datetimeFigureOut">
              <a:rPr lang="en-US" smtClean="0"/>
              <a:pPr/>
              <a:t>3/17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8DD4124-9A8D-4D07-8BAC-E057B27712F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AABE05-C6EB-4175-9E48-0B895D9977FD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810611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algn="just"/>
            <a:r>
              <a:rPr lang="en-US" b="1" dirty="0"/>
              <a:t>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BDA0C44-BCC6-4972-B704-0756F579BFC1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3880436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BF145-73F2-4EA6-9B87-218AC291DE98}" type="datetimeFigureOut">
              <a:rPr lang="en-US" smtClean="0"/>
              <a:pPr/>
              <a:t>3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D8BE2-905C-4E38-B796-57D2B80C2D5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BF145-73F2-4EA6-9B87-218AC291DE98}" type="datetimeFigureOut">
              <a:rPr lang="en-US" smtClean="0"/>
              <a:pPr/>
              <a:t>3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D8BE2-905C-4E38-B796-57D2B80C2D5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BF145-73F2-4EA6-9B87-218AC291DE98}" type="datetimeFigureOut">
              <a:rPr lang="en-US" smtClean="0"/>
              <a:pPr/>
              <a:t>3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D8BE2-905C-4E38-B796-57D2B80C2D5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BF145-73F2-4EA6-9B87-218AC291DE98}" type="datetimeFigureOut">
              <a:rPr lang="en-US" smtClean="0"/>
              <a:pPr/>
              <a:t>3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D8BE2-905C-4E38-B796-57D2B80C2D5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BF145-73F2-4EA6-9B87-218AC291DE98}" type="datetimeFigureOut">
              <a:rPr lang="en-US" smtClean="0"/>
              <a:pPr/>
              <a:t>3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D8BE2-905C-4E38-B796-57D2B80C2D5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BF145-73F2-4EA6-9B87-218AC291DE98}" type="datetimeFigureOut">
              <a:rPr lang="en-US" smtClean="0"/>
              <a:pPr/>
              <a:t>3/1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D8BE2-905C-4E38-B796-57D2B80C2D5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BF145-73F2-4EA6-9B87-218AC291DE98}" type="datetimeFigureOut">
              <a:rPr lang="en-US" smtClean="0"/>
              <a:pPr/>
              <a:t>3/1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D8BE2-905C-4E38-B796-57D2B80C2D5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BF145-73F2-4EA6-9B87-218AC291DE98}" type="datetimeFigureOut">
              <a:rPr lang="en-US" smtClean="0"/>
              <a:pPr/>
              <a:t>3/1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D8BE2-905C-4E38-B796-57D2B80C2D5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BF145-73F2-4EA6-9B87-218AC291DE98}" type="datetimeFigureOut">
              <a:rPr lang="en-US" smtClean="0"/>
              <a:pPr/>
              <a:t>3/1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D8BE2-905C-4E38-B796-57D2B80C2D5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BF145-73F2-4EA6-9B87-218AC291DE98}" type="datetimeFigureOut">
              <a:rPr lang="en-US" smtClean="0"/>
              <a:pPr/>
              <a:t>3/1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D8BE2-905C-4E38-B796-57D2B80C2D5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BF145-73F2-4EA6-9B87-218AC291DE98}" type="datetimeFigureOut">
              <a:rPr lang="en-US" smtClean="0"/>
              <a:pPr/>
              <a:t>3/1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D8BE2-905C-4E38-B796-57D2B80C2D5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2BF145-73F2-4EA6-9B87-218AC291DE98}" type="datetimeFigureOut">
              <a:rPr lang="en-US" smtClean="0"/>
              <a:pPr/>
              <a:t>3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6D8BE2-905C-4E38-B796-57D2B80C2D51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image" Target="../media/image6.jpe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Box 4"/>
          <p:cNvSpPr txBox="1">
            <a:spLocks noChangeArrowheads="1"/>
          </p:cNvSpPr>
          <p:nvPr/>
        </p:nvSpPr>
        <p:spPr bwMode="auto">
          <a:xfrm>
            <a:off x="204861" y="1752600"/>
            <a:ext cx="8829822" cy="24160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just"/>
            <a:r>
              <a:rPr lang="en-US" sz="1400" b="1" i="1" dirty="0">
                <a:solidFill>
                  <a:schemeClr val="accent2"/>
                </a:solidFill>
                <a:latin typeface="Courier New" pitchFamily="49" charset="0"/>
              </a:rPr>
              <a:t>Slo1</a:t>
            </a:r>
            <a:r>
              <a:rPr lang="en-US" sz="1100" dirty="0">
                <a:latin typeface="Courier New" pitchFamily="49" charset="0"/>
              </a:rPr>
              <a:t> </a:t>
            </a:r>
            <a:r>
              <a:rPr lang="en-US" sz="1200" b="1" dirty="0">
                <a:latin typeface="Courier New" pitchFamily="49" charset="0"/>
              </a:rPr>
              <a:t>599</a:t>
            </a:r>
            <a:r>
              <a:rPr lang="en-US" sz="1400" b="1" dirty="0">
                <a:latin typeface="Courier New" pitchFamily="49" charset="0"/>
              </a:rPr>
              <a:t> </a:t>
            </a:r>
            <a:r>
              <a:rPr lang="en-US" sz="1200" b="1" dirty="0">
                <a:solidFill>
                  <a:srgbClr val="9790F4"/>
                </a:solidFill>
                <a:latin typeface="Courier New" pitchFamily="49" charset="0"/>
              </a:rPr>
              <a:t>-------------</a:t>
            </a:r>
            <a:r>
              <a:rPr lang="en-US" sz="1200" dirty="0">
                <a:latin typeface="Courier New" pitchFamily="49" charset="0"/>
              </a:rPr>
              <a:t>ASDAKEV</a:t>
            </a:r>
            <a:r>
              <a:rPr lang="en-US" sz="1200" b="1" i="1" dirty="0">
                <a:solidFill>
                  <a:schemeClr val="tx1">
                    <a:lumMod val="50000"/>
                    <a:lumOff val="50000"/>
                  </a:schemeClr>
                </a:solidFill>
                <a:latin typeface="Courier New" pitchFamily="49" charset="0"/>
              </a:rPr>
              <a:t>K</a:t>
            </a:r>
            <a:r>
              <a:rPr lang="en-US" sz="1200" dirty="0">
                <a:latin typeface="Courier New" pitchFamily="49" charset="0"/>
              </a:rPr>
              <a:t>RAFFY</a:t>
            </a:r>
            <a:r>
              <a:rPr lang="en-US" sz="1400" b="1" dirty="0">
                <a:solidFill>
                  <a:srgbClr val="FF3300"/>
                </a:solidFill>
                <a:latin typeface="Courier New" pitchFamily="49" charset="0"/>
              </a:rPr>
              <a:t>CKACH</a:t>
            </a:r>
            <a:r>
              <a:rPr lang="en-US" sz="1200" dirty="0">
                <a:latin typeface="Courier New" pitchFamily="49" charset="0"/>
              </a:rPr>
              <a:t>DDITDPKRIK</a:t>
            </a:r>
            <a:r>
              <a:rPr lang="en-US" sz="12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Courier New" pitchFamily="49" charset="0"/>
              </a:rPr>
              <a:t>K</a:t>
            </a:r>
            <a:r>
              <a:rPr lang="en-US" sz="1200" dirty="0">
                <a:latin typeface="Courier New" pitchFamily="49" charset="0"/>
              </a:rPr>
              <a:t>CGCKRPKMS</a:t>
            </a:r>
            <a:r>
              <a:rPr lang="en-US" sz="1200" b="1" i="1" dirty="0">
                <a:solidFill>
                  <a:srgbClr val="9790F4"/>
                </a:solidFill>
                <a:latin typeface="Courier New" pitchFamily="49" charset="0"/>
              </a:rPr>
              <a:t>-----</a:t>
            </a:r>
            <a:r>
              <a:rPr lang="en-US" sz="1200" dirty="0">
                <a:latin typeface="Courier New" pitchFamily="49" charset="0"/>
              </a:rPr>
              <a:t>IYKRMRRACCFDCGRSERDCSCMS</a:t>
            </a:r>
          </a:p>
          <a:p>
            <a:pPr algn="just"/>
            <a:r>
              <a:rPr lang="en-US" sz="1400" b="1" i="1" dirty="0">
                <a:solidFill>
                  <a:schemeClr val="accent2"/>
                </a:solidFill>
                <a:latin typeface="Courier New" pitchFamily="49" charset="0"/>
              </a:rPr>
              <a:t>Slo2</a:t>
            </a:r>
            <a:r>
              <a:rPr lang="en-US" sz="1400" b="1" i="1" dirty="0">
                <a:latin typeface="Courier New" pitchFamily="49" charset="0"/>
              </a:rPr>
              <a:t> </a:t>
            </a:r>
            <a:r>
              <a:rPr lang="en-US" sz="1200" b="1" dirty="0">
                <a:latin typeface="Courier New" pitchFamily="49" charset="0"/>
              </a:rPr>
              <a:t>554</a:t>
            </a:r>
            <a:r>
              <a:rPr lang="en-US" sz="1200" b="1" dirty="0">
                <a:solidFill>
                  <a:srgbClr val="92D050"/>
                </a:solidFill>
                <a:latin typeface="Courier New" pitchFamily="49" charset="0"/>
              </a:rPr>
              <a:t> </a:t>
            </a:r>
            <a:r>
              <a:rPr lang="en-US" sz="1200" dirty="0">
                <a:latin typeface="Courier New" pitchFamily="49" charset="0"/>
              </a:rPr>
              <a:t>ITKEENSAFKNQDQQRKSNVSRSFYHGPS</a:t>
            </a:r>
            <a:r>
              <a:rPr lang="en-US" sz="1200" b="1" dirty="0">
                <a:solidFill>
                  <a:srgbClr val="9790F4"/>
                </a:solidFill>
                <a:latin typeface="Courier New" pitchFamily="49" charset="0"/>
              </a:rPr>
              <a:t>----------------</a:t>
            </a:r>
            <a:r>
              <a:rPr lang="en-US" sz="1200" dirty="0">
                <a:latin typeface="Courier New" pitchFamily="49" charset="0"/>
              </a:rPr>
              <a:t>RLPVHS-----IIASMGTV-AIDL</a:t>
            </a:r>
            <a:r>
              <a:rPr lang="en-US" sz="1200" b="1" dirty="0">
                <a:solidFill>
                  <a:srgbClr val="9790F4"/>
                </a:solidFill>
                <a:latin typeface="Courier New" pitchFamily="49" charset="0"/>
              </a:rPr>
              <a:t>----</a:t>
            </a:r>
            <a:r>
              <a:rPr lang="en-US" sz="1200" dirty="0">
                <a:latin typeface="Courier New" pitchFamily="49" charset="0"/>
              </a:rPr>
              <a:t>QDTSC</a:t>
            </a:r>
            <a:r>
              <a:rPr lang="en-US" sz="1200" b="1" dirty="0">
                <a:solidFill>
                  <a:srgbClr val="9790F4"/>
                </a:solidFill>
                <a:latin typeface="Courier New" pitchFamily="49" charset="0"/>
              </a:rPr>
              <a:t>–-</a:t>
            </a:r>
            <a:r>
              <a:rPr lang="en-US" sz="1200" dirty="0">
                <a:latin typeface="Courier New" pitchFamily="49" charset="0"/>
              </a:rPr>
              <a:t> </a:t>
            </a:r>
          </a:p>
          <a:p>
            <a:pPr algn="just"/>
            <a:r>
              <a:rPr lang="en-US" sz="1400" b="1" i="1" dirty="0">
                <a:solidFill>
                  <a:schemeClr val="accent2"/>
                </a:solidFill>
                <a:latin typeface="Courier New" pitchFamily="49" charset="0"/>
              </a:rPr>
              <a:t>Slo3</a:t>
            </a:r>
            <a:r>
              <a:rPr lang="en-US" sz="1400" b="1" dirty="0">
                <a:solidFill>
                  <a:schemeClr val="accent2"/>
                </a:solidFill>
                <a:latin typeface="Courier New" pitchFamily="49" charset="0"/>
              </a:rPr>
              <a:t> </a:t>
            </a:r>
            <a:r>
              <a:rPr lang="en-US" sz="1200" b="1" dirty="0">
                <a:latin typeface="Courier New" pitchFamily="49" charset="0"/>
              </a:rPr>
              <a:t>589</a:t>
            </a:r>
            <a:r>
              <a:rPr lang="en-US" sz="1200" dirty="0">
                <a:latin typeface="Courier New" pitchFamily="49" charset="0"/>
              </a:rPr>
              <a:t> </a:t>
            </a:r>
            <a:r>
              <a:rPr lang="en-US" sz="1200" b="1" dirty="0">
                <a:solidFill>
                  <a:srgbClr val="9790F4"/>
                </a:solidFill>
                <a:latin typeface="Courier New" pitchFamily="49" charset="0"/>
              </a:rPr>
              <a:t>-------------</a:t>
            </a:r>
            <a:r>
              <a:rPr lang="en-US" sz="1200" dirty="0">
                <a:latin typeface="Courier New" pitchFamily="49" charset="0"/>
              </a:rPr>
              <a:t>ADSSKAV</a:t>
            </a:r>
            <a:r>
              <a:rPr lang="en-US" sz="12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Courier New" pitchFamily="49" charset="0"/>
              </a:rPr>
              <a:t>K</a:t>
            </a:r>
            <a:r>
              <a:rPr lang="en-US" sz="1200" dirty="0">
                <a:latin typeface="Courier New" pitchFamily="49" charset="0"/>
              </a:rPr>
              <a:t>RAFFY</a:t>
            </a:r>
            <a:r>
              <a:rPr lang="en-US" sz="1400" b="1" dirty="0">
                <a:solidFill>
                  <a:srgbClr val="FF0000"/>
                </a:solidFill>
                <a:latin typeface="Courier New" pitchFamily="49" charset="0"/>
              </a:rPr>
              <a:t>CSNCH</a:t>
            </a:r>
            <a:r>
              <a:rPr lang="en-US" sz="1200" dirty="0">
                <a:latin typeface="Courier New" pitchFamily="49" charset="0"/>
              </a:rPr>
              <a:t>SDVCNPELIG</a:t>
            </a:r>
            <a:r>
              <a:rPr lang="en-US" sz="12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Courier New" pitchFamily="49" charset="0"/>
              </a:rPr>
              <a:t>K</a:t>
            </a:r>
            <a:r>
              <a:rPr lang="en-US" sz="1200" dirty="0">
                <a:latin typeface="Courier New" pitchFamily="49" charset="0"/>
              </a:rPr>
              <a:t>CNCKIKSRQQLIAPTIMVMKSS-LTDFT</a:t>
            </a:r>
            <a:r>
              <a:rPr lang="en-US" sz="1200" b="1" dirty="0">
                <a:solidFill>
                  <a:srgbClr val="9790F4"/>
                </a:solidFill>
                <a:latin typeface="Courier New" pitchFamily="49" charset="0"/>
              </a:rPr>
              <a:t>---------- </a:t>
            </a:r>
          </a:p>
          <a:p>
            <a:pPr algn="just"/>
            <a:endParaRPr lang="en-US" sz="1400" b="1" i="1" dirty="0">
              <a:solidFill>
                <a:schemeClr val="accent2"/>
              </a:solidFill>
              <a:latin typeface="Courier New" pitchFamily="49" charset="0"/>
            </a:endParaRPr>
          </a:p>
          <a:p>
            <a:pPr algn="just"/>
            <a:r>
              <a:rPr lang="en-US" sz="1400" b="1" i="1" dirty="0">
                <a:solidFill>
                  <a:schemeClr val="accent2"/>
                </a:solidFill>
                <a:latin typeface="Courier New" pitchFamily="49" charset="0"/>
              </a:rPr>
              <a:t>Slo1</a:t>
            </a:r>
            <a:r>
              <a:rPr lang="en-US" sz="1100" dirty="0">
                <a:latin typeface="Courier New" pitchFamily="49" charset="0"/>
              </a:rPr>
              <a:t>      </a:t>
            </a:r>
            <a:r>
              <a:rPr lang="en-US" sz="1200" dirty="0">
                <a:latin typeface="Courier New" pitchFamily="49" charset="0"/>
              </a:rPr>
              <a:t>GRVRGNVDTLERAFPLSS-VSVNDCSTSFRAFEDEQPSTLSPKKKQRNGGMRNSPNTSPKLMRHDPLLIPGNDQIDNM</a:t>
            </a:r>
            <a:r>
              <a:rPr lang="en-US" sz="1200" b="1" dirty="0">
                <a:solidFill>
                  <a:srgbClr val="9790F4"/>
                </a:solidFill>
                <a:latin typeface="Courier New" pitchFamily="49" charset="0"/>
              </a:rPr>
              <a:t>–-</a:t>
            </a:r>
            <a:r>
              <a:rPr lang="en-US" sz="1200" dirty="0">
                <a:latin typeface="Courier New" pitchFamily="49" charset="0"/>
              </a:rPr>
              <a:t> </a:t>
            </a:r>
          </a:p>
          <a:p>
            <a:pPr algn="just"/>
            <a:r>
              <a:rPr lang="en-US" sz="1400" b="1" i="1" dirty="0">
                <a:solidFill>
                  <a:schemeClr val="accent2"/>
                </a:solidFill>
                <a:latin typeface="Courier New" pitchFamily="49" charset="0"/>
              </a:rPr>
              <a:t>Slo2</a:t>
            </a:r>
            <a:r>
              <a:rPr lang="en-US" sz="1100" dirty="0">
                <a:latin typeface="Courier New" pitchFamily="49" charset="0"/>
              </a:rPr>
              <a:t>      </a:t>
            </a:r>
            <a:r>
              <a:rPr lang="en-US" sz="1200" b="1" dirty="0">
                <a:solidFill>
                  <a:srgbClr val="9790F4"/>
                </a:solidFill>
                <a:latin typeface="Courier New" pitchFamily="49" charset="0"/>
              </a:rPr>
              <a:t>-----------------------------</a:t>
            </a:r>
            <a:r>
              <a:rPr lang="en-US" sz="1200" dirty="0">
                <a:latin typeface="Courier New" pitchFamily="49" charset="0"/>
              </a:rPr>
              <a:t>RSA--SGPTLSLPTEGSK</a:t>
            </a:r>
            <a:r>
              <a:rPr lang="en-US" sz="1200" b="1" dirty="0">
                <a:solidFill>
                  <a:srgbClr val="9790F4"/>
                </a:solidFill>
                <a:latin typeface="Courier New" pitchFamily="49" charset="0"/>
              </a:rPr>
              <a:t>---</a:t>
            </a:r>
            <a:r>
              <a:rPr lang="en-US" sz="1200" dirty="0">
                <a:latin typeface="Courier New" pitchFamily="49" charset="0"/>
              </a:rPr>
              <a:t>EIRRPSIAPVLEVADTSSIQTCDLLSDQSE</a:t>
            </a:r>
          </a:p>
          <a:p>
            <a:pPr algn="just"/>
            <a:r>
              <a:rPr lang="en-US" sz="1400" b="1" i="1" dirty="0">
                <a:solidFill>
                  <a:schemeClr val="accent2"/>
                </a:solidFill>
                <a:latin typeface="Courier New" pitchFamily="49" charset="0"/>
              </a:rPr>
              <a:t>Slo3</a:t>
            </a:r>
            <a:r>
              <a:rPr lang="en-US" sz="1100" dirty="0">
                <a:latin typeface="Courier New" pitchFamily="49" charset="0"/>
              </a:rPr>
              <a:t>      </a:t>
            </a:r>
            <a:r>
              <a:rPr lang="en-US" sz="1200" b="1" dirty="0">
                <a:solidFill>
                  <a:srgbClr val="9790F4"/>
                </a:solidFill>
                <a:latin typeface="Courier New" pitchFamily="49" charset="0"/>
              </a:rPr>
              <a:t>--------------</a:t>
            </a:r>
            <a:r>
              <a:rPr lang="en-US" sz="1200" dirty="0">
                <a:latin typeface="Courier New" pitchFamily="49" charset="0"/>
              </a:rPr>
              <a:t>TSSHIHASMSTEIHTCFSREQPSLITIT</a:t>
            </a:r>
            <a:r>
              <a:rPr lang="en-US" sz="1200" b="1" dirty="0">
                <a:solidFill>
                  <a:srgbClr val="9790F4"/>
                </a:solidFill>
                <a:latin typeface="Courier New" pitchFamily="49" charset="0"/>
              </a:rPr>
              <a:t>--------</a:t>
            </a:r>
            <a:r>
              <a:rPr lang="en-US" sz="1200" dirty="0">
                <a:latin typeface="Courier New" pitchFamily="49" charset="0"/>
              </a:rPr>
              <a:t>TNRPT</a:t>
            </a:r>
            <a:r>
              <a:rPr lang="en-US" sz="1200" b="1" dirty="0">
                <a:solidFill>
                  <a:srgbClr val="9790F4"/>
                </a:solidFill>
                <a:latin typeface="Courier New" pitchFamily="49" charset="0"/>
              </a:rPr>
              <a:t>---------------</a:t>
            </a:r>
            <a:r>
              <a:rPr lang="en-US" sz="1200" dirty="0">
                <a:latin typeface="Courier New" pitchFamily="49" charset="0"/>
              </a:rPr>
              <a:t>TNDTVDDT</a:t>
            </a:r>
            <a:r>
              <a:rPr lang="en-US" sz="1200" dirty="0">
                <a:solidFill>
                  <a:srgbClr val="3B1FE1"/>
                </a:solidFill>
                <a:latin typeface="Courier New" pitchFamily="49" charset="0"/>
              </a:rPr>
              <a:t>-</a:t>
            </a:r>
          </a:p>
          <a:p>
            <a:pPr algn="just"/>
            <a:endParaRPr lang="en-US" sz="1100" dirty="0">
              <a:latin typeface="Courier New" pitchFamily="49" charset="0"/>
            </a:endParaRPr>
          </a:p>
          <a:p>
            <a:pPr algn="just"/>
            <a:r>
              <a:rPr lang="en-US" sz="1400" b="1" i="1" dirty="0">
                <a:solidFill>
                  <a:schemeClr val="accent2"/>
                </a:solidFill>
                <a:latin typeface="Courier New" pitchFamily="49" charset="0"/>
              </a:rPr>
              <a:t>Slo1</a:t>
            </a:r>
            <a:r>
              <a:rPr lang="en-US" sz="1100" dirty="0">
                <a:latin typeface="Courier New" pitchFamily="49" charset="0"/>
              </a:rPr>
              <a:t>      </a:t>
            </a:r>
            <a:r>
              <a:rPr lang="en-US" sz="1200" b="1" dirty="0">
                <a:solidFill>
                  <a:srgbClr val="9790F4"/>
                </a:solidFill>
                <a:latin typeface="Courier New" pitchFamily="49" charset="0"/>
              </a:rPr>
              <a:t>---------</a:t>
            </a:r>
            <a:r>
              <a:rPr lang="en-US" sz="1200" dirty="0">
                <a:latin typeface="Courier New" pitchFamily="49" charset="0"/>
              </a:rPr>
              <a:t>DSNVK</a:t>
            </a:r>
            <a:r>
              <a:rPr lang="en-US" sz="1200" b="1" dirty="0">
                <a:solidFill>
                  <a:srgbClr val="9790F4"/>
                </a:solidFill>
                <a:latin typeface="Courier New" pitchFamily="49" charset="0"/>
              </a:rPr>
              <a:t>---</a:t>
            </a:r>
            <a:r>
              <a:rPr lang="en-US" sz="1200" dirty="0">
                <a:latin typeface="Courier New" pitchFamily="49" charset="0"/>
              </a:rPr>
              <a:t>K</a:t>
            </a:r>
            <a:r>
              <a:rPr lang="en-US" sz="1200" b="1" dirty="0">
                <a:solidFill>
                  <a:srgbClr val="9790F4"/>
                </a:solidFill>
                <a:latin typeface="Courier New" pitchFamily="49" charset="0"/>
              </a:rPr>
              <a:t>-------</a:t>
            </a:r>
            <a:r>
              <a:rPr lang="en-US" sz="1200" dirty="0">
                <a:latin typeface="Courier New" pitchFamily="49" charset="0"/>
              </a:rPr>
              <a:t>YDSTG</a:t>
            </a:r>
            <a:r>
              <a:rPr lang="en-US" sz="1400" b="1" dirty="0">
                <a:solidFill>
                  <a:srgbClr val="FF0000"/>
                </a:solidFill>
                <a:latin typeface="Courier New" pitchFamily="49" charset="0"/>
              </a:rPr>
              <a:t>M</a:t>
            </a:r>
            <a:r>
              <a:rPr lang="en-US" sz="1200" dirty="0">
                <a:latin typeface="Courier New" pitchFamily="49" charset="0"/>
              </a:rPr>
              <a:t>F</a:t>
            </a:r>
            <a:r>
              <a:rPr lang="en-US" sz="1200" b="1" dirty="0">
                <a:solidFill>
                  <a:srgbClr val="9790F4"/>
                </a:solidFill>
                <a:latin typeface="Courier New" pitchFamily="49" charset="0"/>
              </a:rPr>
              <a:t>--------</a:t>
            </a:r>
            <a:r>
              <a:rPr lang="en-US" sz="1200" dirty="0">
                <a:latin typeface="Courier New" pitchFamily="49" charset="0"/>
              </a:rPr>
              <a:t>HWCAPKEIEKVIL</a:t>
            </a:r>
            <a:r>
              <a:rPr lang="en-US" sz="1200" b="1" dirty="0">
                <a:latin typeface="Courier New" pitchFamily="49" charset="0"/>
              </a:rPr>
              <a:t>-</a:t>
            </a:r>
            <a:r>
              <a:rPr lang="en-US" sz="1200" dirty="0">
                <a:latin typeface="Courier New" pitchFamily="49" charset="0"/>
              </a:rPr>
              <a:t>TRSE</a:t>
            </a:r>
            <a:r>
              <a:rPr lang="en-US" sz="1200" b="1" dirty="0">
                <a:solidFill>
                  <a:srgbClr val="9790F4"/>
                </a:solidFill>
                <a:latin typeface="Courier New" pitchFamily="49" charset="0"/>
              </a:rPr>
              <a:t>-</a:t>
            </a:r>
            <a:r>
              <a:rPr lang="en-US" sz="1200" dirty="0">
                <a:latin typeface="Courier New" pitchFamily="49" charset="0"/>
              </a:rPr>
              <a:t>AAMTVLS  </a:t>
            </a:r>
            <a:r>
              <a:rPr lang="en-US" sz="1200" b="1" dirty="0">
                <a:latin typeface="Courier New" pitchFamily="49" charset="0"/>
              </a:rPr>
              <a:t>717</a:t>
            </a:r>
          </a:p>
          <a:p>
            <a:pPr algn="just"/>
            <a:r>
              <a:rPr lang="en-US" sz="1400" b="1" i="1" dirty="0">
                <a:solidFill>
                  <a:schemeClr val="accent2"/>
                </a:solidFill>
                <a:latin typeface="Courier New" pitchFamily="49" charset="0"/>
              </a:rPr>
              <a:t>Slo2</a:t>
            </a:r>
            <a:r>
              <a:rPr lang="en-US" sz="1400" i="1" dirty="0">
                <a:latin typeface="Courier New" pitchFamily="49" charset="0"/>
              </a:rPr>
              <a:t> </a:t>
            </a:r>
            <a:r>
              <a:rPr lang="en-US" sz="1100" dirty="0">
                <a:latin typeface="Courier New" pitchFamily="49" charset="0"/>
              </a:rPr>
              <a:t>     </a:t>
            </a:r>
            <a:r>
              <a:rPr lang="en-US" sz="1200" dirty="0">
                <a:latin typeface="Courier New" pitchFamily="49" charset="0"/>
              </a:rPr>
              <a:t>DETTPDEEMSSNLEYAKGYPPYSPYIGSSPTFCHLLHEKVPFCCL-RLDKSCQHNYYEDAKAYGFK</a:t>
            </a:r>
            <a:r>
              <a:rPr lang="en-US" sz="1100" dirty="0">
                <a:latin typeface="Courier New" pitchFamily="49" charset="0"/>
              </a:rPr>
              <a:t>  </a:t>
            </a:r>
            <a:r>
              <a:rPr lang="en-US" sz="1200" b="1" dirty="0">
                <a:latin typeface="Courier New" pitchFamily="49" charset="0"/>
              </a:rPr>
              <a:t>772</a:t>
            </a:r>
          </a:p>
          <a:p>
            <a:pPr algn="just"/>
            <a:r>
              <a:rPr lang="en-US" sz="1400" b="1" i="1" dirty="0">
                <a:solidFill>
                  <a:schemeClr val="accent2"/>
                </a:solidFill>
                <a:latin typeface="Courier New" pitchFamily="49" charset="0"/>
              </a:rPr>
              <a:t>Slo3</a:t>
            </a:r>
            <a:r>
              <a:rPr lang="en-US" sz="1400" b="1" dirty="0">
                <a:solidFill>
                  <a:schemeClr val="accent2"/>
                </a:solidFill>
                <a:latin typeface="Courier New" pitchFamily="49" charset="0"/>
              </a:rPr>
              <a:t> </a:t>
            </a:r>
            <a:r>
              <a:rPr lang="en-US" sz="1100" dirty="0">
                <a:latin typeface="Courier New" pitchFamily="49" charset="0"/>
              </a:rPr>
              <a:t>     </a:t>
            </a:r>
            <a:r>
              <a:rPr lang="en-US" sz="1200" b="1" dirty="0">
                <a:solidFill>
                  <a:srgbClr val="9790F4"/>
                </a:solidFill>
                <a:latin typeface="Courier New" pitchFamily="49" charset="0"/>
              </a:rPr>
              <a:t>---------</a:t>
            </a:r>
            <a:r>
              <a:rPr lang="en-US" sz="1200" dirty="0">
                <a:latin typeface="Courier New" pitchFamily="49" charset="0"/>
              </a:rPr>
              <a:t>D</a:t>
            </a:r>
            <a:r>
              <a:rPr lang="en-US" sz="1200" b="1" dirty="0">
                <a:solidFill>
                  <a:srgbClr val="9790F4"/>
                </a:solidFill>
                <a:latin typeface="Courier New" pitchFamily="49" charset="0"/>
              </a:rPr>
              <a:t>-------</a:t>
            </a:r>
            <a:r>
              <a:rPr lang="en-US" sz="1200" dirty="0">
                <a:latin typeface="Courier New" pitchFamily="49" charset="0"/>
              </a:rPr>
              <a:t>M</a:t>
            </a:r>
            <a:r>
              <a:rPr lang="en-US" sz="1200" b="1" dirty="0">
                <a:solidFill>
                  <a:srgbClr val="9790F4"/>
                </a:solidFill>
                <a:latin typeface="Courier New" pitchFamily="49" charset="0"/>
              </a:rPr>
              <a:t>-------</a:t>
            </a:r>
            <a:r>
              <a:rPr lang="en-US" sz="1200" dirty="0">
                <a:latin typeface="Courier New" pitchFamily="49" charset="0"/>
              </a:rPr>
              <a:t>LDSSG</a:t>
            </a:r>
            <a:r>
              <a:rPr lang="en-US" sz="1400" b="1" dirty="0">
                <a:solidFill>
                  <a:srgbClr val="FF3300"/>
                </a:solidFill>
                <a:latin typeface="Courier New" pitchFamily="49" charset="0"/>
              </a:rPr>
              <a:t>M</a:t>
            </a:r>
            <a:r>
              <a:rPr lang="en-US" sz="1200" dirty="0">
                <a:latin typeface="Courier New" pitchFamily="49" charset="0"/>
              </a:rPr>
              <a:t>F</a:t>
            </a:r>
            <a:r>
              <a:rPr lang="en-US" sz="1200" b="1" dirty="0">
                <a:solidFill>
                  <a:srgbClr val="9790F4"/>
                </a:solidFill>
                <a:latin typeface="Courier New" pitchFamily="49" charset="0"/>
              </a:rPr>
              <a:t>--------</a:t>
            </a:r>
            <a:r>
              <a:rPr lang="en-US" sz="1200" dirty="0">
                <a:latin typeface="Courier New" pitchFamily="49" charset="0"/>
              </a:rPr>
              <a:t>HWCRAMPLDKVVL</a:t>
            </a:r>
            <a:r>
              <a:rPr lang="en-US" sz="1200" dirty="0">
                <a:solidFill>
                  <a:srgbClr val="9790F4"/>
                </a:solidFill>
                <a:latin typeface="Courier New" pitchFamily="49" charset="0"/>
              </a:rPr>
              <a:t>-</a:t>
            </a:r>
            <a:r>
              <a:rPr lang="en-US" sz="1200" dirty="0">
                <a:latin typeface="Courier New" pitchFamily="49" charset="0"/>
              </a:rPr>
              <a:t>KRSE</a:t>
            </a:r>
            <a:r>
              <a:rPr lang="en-US" sz="1200" b="1" dirty="0">
                <a:solidFill>
                  <a:srgbClr val="9790F4"/>
                </a:solidFill>
                <a:latin typeface="Courier New" pitchFamily="49" charset="0"/>
              </a:rPr>
              <a:t>-</a:t>
            </a:r>
            <a:r>
              <a:rPr lang="en-US" sz="1200" dirty="0">
                <a:latin typeface="Courier New" pitchFamily="49" charset="0"/>
              </a:rPr>
              <a:t>KAKHEFQ  </a:t>
            </a:r>
            <a:r>
              <a:rPr lang="en-US" sz="1200" b="1" dirty="0">
                <a:latin typeface="Courier New" pitchFamily="49" charset="0"/>
              </a:rPr>
              <a:t>718</a:t>
            </a:r>
            <a:r>
              <a:rPr lang="en-US" sz="1200" dirty="0">
                <a:latin typeface="Courier New" pitchFamily="49" charset="0"/>
              </a:rPr>
              <a:t> </a:t>
            </a:r>
          </a:p>
        </p:txBody>
      </p:sp>
      <p:sp>
        <p:nvSpPr>
          <p:cNvPr id="3" name="Прямоугольник 2"/>
          <p:cNvSpPr/>
          <p:nvPr/>
        </p:nvSpPr>
        <p:spPr>
          <a:xfrm>
            <a:off x="119283" y="5257800"/>
            <a:ext cx="891540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equence alignment of the linker region of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lo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amily voltage-gated K</a:t>
            </a:r>
            <a:r>
              <a:rPr lang="en-US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hannels proteins. The conserved HRM motif (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KACH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sidues are indicated in red. </a:t>
            </a:r>
          </a:p>
        </p:txBody>
      </p:sp>
    </p:spTree>
    <p:extLst>
      <p:ext uri="{BB962C8B-B14F-4D97-AF65-F5344CB8AC3E}">
        <p14:creationId xmlns:p14="http://schemas.microsoft.com/office/powerpoint/2010/main" val="37998346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4"/>
          <p:cNvGrpSpPr>
            <a:grpSpLocks noChangeAspect="1"/>
          </p:cNvGrpSpPr>
          <p:nvPr/>
        </p:nvGrpSpPr>
        <p:grpSpPr bwMode="auto">
          <a:xfrm>
            <a:off x="5106575" y="1303871"/>
            <a:ext cx="3365500" cy="2944813"/>
            <a:chOff x="3171" y="800"/>
            <a:chExt cx="2120" cy="1855"/>
          </a:xfrm>
        </p:grpSpPr>
        <p:sp>
          <p:nvSpPr>
            <p:cNvPr id="83971" name="AutoShape 3"/>
            <p:cNvSpPr>
              <a:spLocks noChangeAspect="1" noChangeArrowheads="1" noTextEdit="1"/>
            </p:cNvSpPr>
            <p:nvPr/>
          </p:nvSpPr>
          <p:spPr bwMode="auto">
            <a:xfrm>
              <a:off x="3171" y="800"/>
              <a:ext cx="2120" cy="18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974" name="Rectangle 6"/>
            <p:cNvSpPr>
              <a:spLocks noChangeArrowheads="1"/>
            </p:cNvSpPr>
            <p:nvPr/>
          </p:nvSpPr>
          <p:spPr bwMode="auto">
            <a:xfrm>
              <a:off x="3361" y="866"/>
              <a:ext cx="6" cy="1584"/>
            </a:xfrm>
            <a:prstGeom prst="rect">
              <a:avLst/>
            </a:prstGeom>
            <a:solidFill>
              <a:srgbClr val="868686"/>
            </a:solidFill>
            <a:ln w="9525" cap="flat">
              <a:solidFill>
                <a:schemeClr val="accent4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975" name="Freeform 7"/>
            <p:cNvSpPr>
              <a:spLocks noEditPoints="1"/>
            </p:cNvSpPr>
            <p:nvPr/>
          </p:nvSpPr>
          <p:spPr bwMode="auto">
            <a:xfrm>
              <a:off x="3334" y="863"/>
              <a:ext cx="30" cy="1590"/>
            </a:xfrm>
            <a:custGeom>
              <a:avLst/>
              <a:gdLst/>
              <a:ahLst/>
              <a:cxnLst>
                <a:cxn ang="0">
                  <a:pos x="0" y="1584"/>
                </a:cxn>
                <a:cxn ang="0">
                  <a:pos x="30" y="1584"/>
                </a:cxn>
                <a:cxn ang="0">
                  <a:pos x="30" y="1590"/>
                </a:cxn>
                <a:cxn ang="0">
                  <a:pos x="0" y="1590"/>
                </a:cxn>
                <a:cxn ang="0">
                  <a:pos x="0" y="1584"/>
                </a:cxn>
                <a:cxn ang="0">
                  <a:pos x="0" y="1269"/>
                </a:cxn>
                <a:cxn ang="0">
                  <a:pos x="30" y="1269"/>
                </a:cxn>
                <a:cxn ang="0">
                  <a:pos x="30" y="1275"/>
                </a:cxn>
                <a:cxn ang="0">
                  <a:pos x="0" y="1275"/>
                </a:cxn>
                <a:cxn ang="0">
                  <a:pos x="0" y="1269"/>
                </a:cxn>
                <a:cxn ang="0">
                  <a:pos x="0" y="949"/>
                </a:cxn>
                <a:cxn ang="0">
                  <a:pos x="30" y="949"/>
                </a:cxn>
                <a:cxn ang="0">
                  <a:pos x="30" y="955"/>
                </a:cxn>
                <a:cxn ang="0">
                  <a:pos x="0" y="955"/>
                </a:cxn>
                <a:cxn ang="0">
                  <a:pos x="0" y="949"/>
                </a:cxn>
                <a:cxn ang="0">
                  <a:pos x="0" y="635"/>
                </a:cxn>
                <a:cxn ang="0">
                  <a:pos x="30" y="635"/>
                </a:cxn>
                <a:cxn ang="0">
                  <a:pos x="30" y="641"/>
                </a:cxn>
                <a:cxn ang="0">
                  <a:pos x="0" y="641"/>
                </a:cxn>
                <a:cxn ang="0">
                  <a:pos x="0" y="635"/>
                </a:cxn>
                <a:cxn ang="0">
                  <a:pos x="0" y="315"/>
                </a:cxn>
                <a:cxn ang="0">
                  <a:pos x="30" y="315"/>
                </a:cxn>
                <a:cxn ang="0">
                  <a:pos x="30" y="321"/>
                </a:cxn>
                <a:cxn ang="0">
                  <a:pos x="0" y="321"/>
                </a:cxn>
                <a:cxn ang="0">
                  <a:pos x="0" y="315"/>
                </a:cxn>
                <a:cxn ang="0">
                  <a:pos x="0" y="0"/>
                </a:cxn>
                <a:cxn ang="0">
                  <a:pos x="30" y="0"/>
                </a:cxn>
                <a:cxn ang="0">
                  <a:pos x="30" y="6"/>
                </a:cxn>
                <a:cxn ang="0">
                  <a:pos x="0" y="6"/>
                </a:cxn>
                <a:cxn ang="0">
                  <a:pos x="0" y="0"/>
                </a:cxn>
              </a:cxnLst>
              <a:rect l="0" t="0" r="r" b="b"/>
              <a:pathLst>
                <a:path w="30" h="1590">
                  <a:moveTo>
                    <a:pt x="0" y="1584"/>
                  </a:moveTo>
                  <a:lnTo>
                    <a:pt x="30" y="1584"/>
                  </a:lnTo>
                  <a:lnTo>
                    <a:pt x="30" y="1590"/>
                  </a:lnTo>
                  <a:lnTo>
                    <a:pt x="0" y="1590"/>
                  </a:lnTo>
                  <a:lnTo>
                    <a:pt x="0" y="1584"/>
                  </a:lnTo>
                  <a:close/>
                  <a:moveTo>
                    <a:pt x="0" y="1269"/>
                  </a:moveTo>
                  <a:lnTo>
                    <a:pt x="30" y="1269"/>
                  </a:lnTo>
                  <a:lnTo>
                    <a:pt x="30" y="1275"/>
                  </a:lnTo>
                  <a:lnTo>
                    <a:pt x="0" y="1275"/>
                  </a:lnTo>
                  <a:lnTo>
                    <a:pt x="0" y="1269"/>
                  </a:lnTo>
                  <a:close/>
                  <a:moveTo>
                    <a:pt x="0" y="949"/>
                  </a:moveTo>
                  <a:lnTo>
                    <a:pt x="30" y="949"/>
                  </a:lnTo>
                  <a:lnTo>
                    <a:pt x="30" y="955"/>
                  </a:lnTo>
                  <a:lnTo>
                    <a:pt x="0" y="955"/>
                  </a:lnTo>
                  <a:lnTo>
                    <a:pt x="0" y="949"/>
                  </a:lnTo>
                  <a:close/>
                  <a:moveTo>
                    <a:pt x="0" y="635"/>
                  </a:moveTo>
                  <a:lnTo>
                    <a:pt x="30" y="635"/>
                  </a:lnTo>
                  <a:lnTo>
                    <a:pt x="30" y="641"/>
                  </a:lnTo>
                  <a:lnTo>
                    <a:pt x="0" y="641"/>
                  </a:lnTo>
                  <a:lnTo>
                    <a:pt x="0" y="635"/>
                  </a:lnTo>
                  <a:close/>
                  <a:moveTo>
                    <a:pt x="0" y="315"/>
                  </a:moveTo>
                  <a:lnTo>
                    <a:pt x="30" y="315"/>
                  </a:lnTo>
                  <a:lnTo>
                    <a:pt x="30" y="321"/>
                  </a:lnTo>
                  <a:lnTo>
                    <a:pt x="0" y="321"/>
                  </a:lnTo>
                  <a:lnTo>
                    <a:pt x="0" y="315"/>
                  </a:lnTo>
                  <a:close/>
                  <a:moveTo>
                    <a:pt x="0" y="0"/>
                  </a:moveTo>
                  <a:lnTo>
                    <a:pt x="30" y="0"/>
                  </a:lnTo>
                  <a:lnTo>
                    <a:pt x="30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9525" cap="flat">
              <a:solidFill>
                <a:schemeClr val="accent4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976" name="Rectangle 8"/>
            <p:cNvSpPr>
              <a:spLocks noChangeArrowheads="1"/>
            </p:cNvSpPr>
            <p:nvPr/>
          </p:nvSpPr>
          <p:spPr bwMode="auto">
            <a:xfrm>
              <a:off x="3364" y="2447"/>
              <a:ext cx="1788" cy="6"/>
            </a:xfrm>
            <a:prstGeom prst="rect">
              <a:avLst/>
            </a:prstGeom>
            <a:solidFill>
              <a:srgbClr val="868686"/>
            </a:solidFill>
            <a:ln w="9525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977" name="Freeform 9"/>
            <p:cNvSpPr>
              <a:spLocks noEditPoints="1"/>
            </p:cNvSpPr>
            <p:nvPr/>
          </p:nvSpPr>
          <p:spPr bwMode="auto">
            <a:xfrm>
              <a:off x="3361" y="2450"/>
              <a:ext cx="1794" cy="30"/>
            </a:xfrm>
            <a:custGeom>
              <a:avLst/>
              <a:gdLst/>
              <a:ahLst/>
              <a:cxnLst>
                <a:cxn ang="0">
                  <a:pos x="6" y="0"/>
                </a:cxn>
                <a:cxn ang="0">
                  <a:pos x="6" y="30"/>
                </a:cxn>
                <a:cxn ang="0">
                  <a:pos x="0" y="30"/>
                </a:cxn>
                <a:cxn ang="0">
                  <a:pos x="0" y="0"/>
                </a:cxn>
                <a:cxn ang="0">
                  <a:pos x="6" y="0"/>
                </a:cxn>
                <a:cxn ang="0">
                  <a:pos x="363" y="0"/>
                </a:cxn>
                <a:cxn ang="0">
                  <a:pos x="363" y="30"/>
                </a:cxn>
                <a:cxn ang="0">
                  <a:pos x="357" y="30"/>
                </a:cxn>
                <a:cxn ang="0">
                  <a:pos x="357" y="0"/>
                </a:cxn>
                <a:cxn ang="0">
                  <a:pos x="363" y="0"/>
                </a:cxn>
                <a:cxn ang="0">
                  <a:pos x="719" y="0"/>
                </a:cxn>
                <a:cxn ang="0">
                  <a:pos x="719" y="30"/>
                </a:cxn>
                <a:cxn ang="0">
                  <a:pos x="713" y="30"/>
                </a:cxn>
                <a:cxn ang="0">
                  <a:pos x="713" y="0"/>
                </a:cxn>
                <a:cxn ang="0">
                  <a:pos x="719" y="0"/>
                </a:cxn>
                <a:cxn ang="0">
                  <a:pos x="1081" y="0"/>
                </a:cxn>
                <a:cxn ang="0">
                  <a:pos x="1081" y="30"/>
                </a:cxn>
                <a:cxn ang="0">
                  <a:pos x="1075" y="30"/>
                </a:cxn>
                <a:cxn ang="0">
                  <a:pos x="1075" y="0"/>
                </a:cxn>
                <a:cxn ang="0">
                  <a:pos x="1081" y="0"/>
                </a:cxn>
                <a:cxn ang="0">
                  <a:pos x="1438" y="0"/>
                </a:cxn>
                <a:cxn ang="0">
                  <a:pos x="1438" y="30"/>
                </a:cxn>
                <a:cxn ang="0">
                  <a:pos x="1432" y="30"/>
                </a:cxn>
                <a:cxn ang="0">
                  <a:pos x="1432" y="0"/>
                </a:cxn>
                <a:cxn ang="0">
                  <a:pos x="1438" y="0"/>
                </a:cxn>
                <a:cxn ang="0">
                  <a:pos x="1794" y="0"/>
                </a:cxn>
                <a:cxn ang="0">
                  <a:pos x="1794" y="30"/>
                </a:cxn>
                <a:cxn ang="0">
                  <a:pos x="1788" y="30"/>
                </a:cxn>
                <a:cxn ang="0">
                  <a:pos x="1788" y="0"/>
                </a:cxn>
                <a:cxn ang="0">
                  <a:pos x="1794" y="0"/>
                </a:cxn>
              </a:cxnLst>
              <a:rect l="0" t="0" r="r" b="b"/>
              <a:pathLst>
                <a:path w="1794" h="30">
                  <a:moveTo>
                    <a:pt x="6" y="0"/>
                  </a:moveTo>
                  <a:lnTo>
                    <a:pt x="6" y="30"/>
                  </a:lnTo>
                  <a:lnTo>
                    <a:pt x="0" y="30"/>
                  </a:lnTo>
                  <a:lnTo>
                    <a:pt x="0" y="0"/>
                  </a:lnTo>
                  <a:lnTo>
                    <a:pt x="6" y="0"/>
                  </a:lnTo>
                  <a:close/>
                  <a:moveTo>
                    <a:pt x="363" y="0"/>
                  </a:moveTo>
                  <a:lnTo>
                    <a:pt x="363" y="30"/>
                  </a:lnTo>
                  <a:lnTo>
                    <a:pt x="357" y="30"/>
                  </a:lnTo>
                  <a:lnTo>
                    <a:pt x="357" y="0"/>
                  </a:lnTo>
                  <a:lnTo>
                    <a:pt x="363" y="0"/>
                  </a:lnTo>
                  <a:close/>
                  <a:moveTo>
                    <a:pt x="719" y="0"/>
                  </a:moveTo>
                  <a:lnTo>
                    <a:pt x="719" y="30"/>
                  </a:lnTo>
                  <a:lnTo>
                    <a:pt x="713" y="30"/>
                  </a:lnTo>
                  <a:lnTo>
                    <a:pt x="713" y="0"/>
                  </a:lnTo>
                  <a:lnTo>
                    <a:pt x="719" y="0"/>
                  </a:lnTo>
                  <a:close/>
                  <a:moveTo>
                    <a:pt x="1081" y="0"/>
                  </a:moveTo>
                  <a:lnTo>
                    <a:pt x="1081" y="30"/>
                  </a:lnTo>
                  <a:lnTo>
                    <a:pt x="1075" y="30"/>
                  </a:lnTo>
                  <a:lnTo>
                    <a:pt x="1075" y="0"/>
                  </a:lnTo>
                  <a:lnTo>
                    <a:pt x="1081" y="0"/>
                  </a:lnTo>
                  <a:close/>
                  <a:moveTo>
                    <a:pt x="1438" y="0"/>
                  </a:moveTo>
                  <a:lnTo>
                    <a:pt x="1438" y="30"/>
                  </a:lnTo>
                  <a:lnTo>
                    <a:pt x="1432" y="30"/>
                  </a:lnTo>
                  <a:lnTo>
                    <a:pt x="1432" y="0"/>
                  </a:lnTo>
                  <a:lnTo>
                    <a:pt x="1438" y="0"/>
                  </a:lnTo>
                  <a:close/>
                  <a:moveTo>
                    <a:pt x="1794" y="0"/>
                  </a:moveTo>
                  <a:lnTo>
                    <a:pt x="1794" y="30"/>
                  </a:lnTo>
                  <a:lnTo>
                    <a:pt x="1788" y="30"/>
                  </a:lnTo>
                  <a:lnTo>
                    <a:pt x="1788" y="0"/>
                  </a:lnTo>
                  <a:lnTo>
                    <a:pt x="1794" y="0"/>
                  </a:lnTo>
                  <a:close/>
                </a:path>
              </a:pathLst>
            </a:custGeom>
            <a:solidFill>
              <a:srgbClr val="868686"/>
            </a:solidFill>
            <a:ln w="9525" cap="flat">
              <a:solidFill>
                <a:schemeClr val="accent4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978" name="Freeform 10"/>
            <p:cNvSpPr>
              <a:spLocks/>
            </p:cNvSpPr>
            <p:nvPr/>
          </p:nvSpPr>
          <p:spPr bwMode="auto">
            <a:xfrm>
              <a:off x="3355" y="1132"/>
              <a:ext cx="1808" cy="1194"/>
            </a:xfrm>
            <a:custGeom>
              <a:avLst/>
              <a:gdLst/>
              <a:ahLst/>
              <a:cxnLst>
                <a:cxn ang="0">
                  <a:pos x="4582" y="2035"/>
                </a:cxn>
                <a:cxn ang="0">
                  <a:pos x="4301" y="2173"/>
                </a:cxn>
                <a:cxn ang="0">
                  <a:pos x="3925" y="2456"/>
                </a:cxn>
                <a:cxn ang="0">
                  <a:pos x="3593" y="2734"/>
                </a:cxn>
                <a:cxn ang="0">
                  <a:pos x="3402" y="2856"/>
                </a:cxn>
                <a:cxn ang="0">
                  <a:pos x="3256" y="2932"/>
                </a:cxn>
                <a:cxn ang="0">
                  <a:pos x="2971" y="3075"/>
                </a:cxn>
                <a:cxn ang="0">
                  <a:pos x="2827" y="3110"/>
                </a:cxn>
                <a:cxn ang="0">
                  <a:pos x="2685" y="3135"/>
                </a:cxn>
                <a:cxn ang="0">
                  <a:pos x="2587" y="3160"/>
                </a:cxn>
                <a:cxn ang="0">
                  <a:pos x="2390" y="3131"/>
                </a:cxn>
                <a:cxn ang="0">
                  <a:pos x="2208" y="3101"/>
                </a:cxn>
                <a:cxn ang="0">
                  <a:pos x="2060" y="3109"/>
                </a:cxn>
                <a:cxn ang="0">
                  <a:pos x="1919" y="3097"/>
                </a:cxn>
                <a:cxn ang="0">
                  <a:pos x="1719" y="3023"/>
                </a:cxn>
                <a:cxn ang="0">
                  <a:pos x="1572" y="2870"/>
                </a:cxn>
                <a:cxn ang="0">
                  <a:pos x="1378" y="2565"/>
                </a:cxn>
                <a:cxn ang="0">
                  <a:pos x="1188" y="2111"/>
                </a:cxn>
                <a:cxn ang="0">
                  <a:pos x="998" y="1575"/>
                </a:cxn>
                <a:cxn ang="0">
                  <a:pos x="809" y="969"/>
                </a:cxn>
                <a:cxn ang="0">
                  <a:pos x="690" y="599"/>
                </a:cxn>
                <a:cxn ang="0">
                  <a:pos x="573" y="348"/>
                </a:cxn>
                <a:cxn ang="0">
                  <a:pos x="435" y="147"/>
                </a:cxn>
                <a:cxn ang="0">
                  <a:pos x="324" y="56"/>
                </a:cxn>
                <a:cxn ang="0">
                  <a:pos x="294" y="48"/>
                </a:cxn>
                <a:cxn ang="0">
                  <a:pos x="216" y="74"/>
                </a:cxn>
                <a:cxn ang="0">
                  <a:pos x="2" y="60"/>
                </a:cxn>
                <a:cxn ang="0">
                  <a:pos x="215" y="26"/>
                </a:cxn>
                <a:cxn ang="0">
                  <a:pos x="279" y="3"/>
                </a:cxn>
                <a:cxn ang="0">
                  <a:pos x="343" y="12"/>
                </a:cxn>
                <a:cxn ang="0">
                  <a:pos x="469" y="113"/>
                </a:cxn>
                <a:cxn ang="0">
                  <a:pos x="616" y="325"/>
                </a:cxn>
                <a:cxn ang="0">
                  <a:pos x="735" y="584"/>
                </a:cxn>
                <a:cxn ang="0">
                  <a:pos x="854" y="954"/>
                </a:cxn>
                <a:cxn ang="0">
                  <a:pos x="1043" y="1560"/>
                </a:cxn>
                <a:cxn ang="0">
                  <a:pos x="1233" y="2094"/>
                </a:cxn>
                <a:cxn ang="0">
                  <a:pos x="1421" y="2544"/>
                </a:cxn>
                <a:cxn ang="0">
                  <a:pos x="1607" y="2837"/>
                </a:cxn>
                <a:cxn ang="0">
                  <a:pos x="1742" y="2982"/>
                </a:cxn>
                <a:cxn ang="0">
                  <a:pos x="1922" y="3050"/>
                </a:cxn>
                <a:cxn ang="0">
                  <a:pos x="2065" y="3062"/>
                </a:cxn>
                <a:cxn ang="0">
                  <a:pos x="2201" y="3054"/>
                </a:cxn>
                <a:cxn ang="0">
                  <a:pos x="2396" y="3084"/>
                </a:cxn>
                <a:cxn ang="0">
                  <a:pos x="2580" y="3113"/>
                </a:cxn>
                <a:cxn ang="0">
                  <a:pos x="2672" y="3088"/>
                </a:cxn>
                <a:cxn ang="0">
                  <a:pos x="2814" y="3063"/>
                </a:cxn>
                <a:cxn ang="0">
                  <a:pos x="2953" y="3030"/>
                </a:cxn>
                <a:cxn ang="0">
                  <a:pos x="3237" y="2887"/>
                </a:cxn>
                <a:cxn ang="0">
                  <a:pos x="3375" y="2817"/>
                </a:cxn>
                <a:cxn ang="0">
                  <a:pos x="3564" y="2697"/>
                </a:cxn>
                <a:cxn ang="0">
                  <a:pos x="3894" y="2420"/>
                </a:cxn>
                <a:cxn ang="0">
                  <a:pos x="4276" y="2132"/>
                </a:cxn>
                <a:cxn ang="0">
                  <a:pos x="4563" y="1991"/>
                </a:cxn>
                <a:cxn ang="0">
                  <a:pos x="4784" y="1931"/>
                </a:cxn>
              </a:cxnLst>
              <a:rect l="0" t="0" r="r" b="b"/>
              <a:pathLst>
                <a:path w="4789" h="3161">
                  <a:moveTo>
                    <a:pt x="4769" y="1961"/>
                  </a:moveTo>
                  <a:lnTo>
                    <a:pt x="4675" y="1994"/>
                  </a:lnTo>
                  <a:lnTo>
                    <a:pt x="4630" y="2014"/>
                  </a:lnTo>
                  <a:lnTo>
                    <a:pt x="4582" y="2035"/>
                  </a:lnTo>
                  <a:lnTo>
                    <a:pt x="4534" y="2053"/>
                  </a:lnTo>
                  <a:lnTo>
                    <a:pt x="4485" y="2070"/>
                  </a:lnTo>
                  <a:lnTo>
                    <a:pt x="4394" y="2115"/>
                  </a:lnTo>
                  <a:lnTo>
                    <a:pt x="4301" y="2173"/>
                  </a:lnTo>
                  <a:lnTo>
                    <a:pt x="4207" y="2239"/>
                  </a:lnTo>
                  <a:lnTo>
                    <a:pt x="4112" y="2302"/>
                  </a:lnTo>
                  <a:lnTo>
                    <a:pt x="4019" y="2374"/>
                  </a:lnTo>
                  <a:lnTo>
                    <a:pt x="3925" y="2456"/>
                  </a:lnTo>
                  <a:lnTo>
                    <a:pt x="3831" y="2544"/>
                  </a:lnTo>
                  <a:lnTo>
                    <a:pt x="3736" y="2625"/>
                  </a:lnTo>
                  <a:lnTo>
                    <a:pt x="3640" y="2698"/>
                  </a:lnTo>
                  <a:lnTo>
                    <a:pt x="3593" y="2734"/>
                  </a:lnTo>
                  <a:lnTo>
                    <a:pt x="3544" y="2769"/>
                  </a:lnTo>
                  <a:lnTo>
                    <a:pt x="3496" y="2798"/>
                  </a:lnTo>
                  <a:lnTo>
                    <a:pt x="3447" y="2825"/>
                  </a:lnTo>
                  <a:lnTo>
                    <a:pt x="3402" y="2856"/>
                  </a:lnTo>
                  <a:lnTo>
                    <a:pt x="3355" y="2888"/>
                  </a:lnTo>
                  <a:cubicBezTo>
                    <a:pt x="3354" y="2888"/>
                    <a:pt x="3353" y="2889"/>
                    <a:pt x="3352" y="2889"/>
                  </a:cubicBezTo>
                  <a:lnTo>
                    <a:pt x="3305" y="2911"/>
                  </a:lnTo>
                  <a:lnTo>
                    <a:pt x="3256" y="2932"/>
                  </a:lnTo>
                  <a:lnTo>
                    <a:pt x="3163" y="2981"/>
                  </a:lnTo>
                  <a:lnTo>
                    <a:pt x="3069" y="3032"/>
                  </a:lnTo>
                  <a:lnTo>
                    <a:pt x="3020" y="3055"/>
                  </a:lnTo>
                  <a:lnTo>
                    <a:pt x="2971" y="3075"/>
                  </a:lnTo>
                  <a:cubicBezTo>
                    <a:pt x="2970" y="3075"/>
                    <a:pt x="2969" y="3076"/>
                    <a:pt x="2968" y="3076"/>
                  </a:cubicBezTo>
                  <a:lnTo>
                    <a:pt x="2921" y="3087"/>
                  </a:lnTo>
                  <a:lnTo>
                    <a:pt x="2872" y="3097"/>
                  </a:lnTo>
                  <a:lnTo>
                    <a:pt x="2827" y="3110"/>
                  </a:lnTo>
                  <a:lnTo>
                    <a:pt x="2778" y="3122"/>
                  </a:lnTo>
                  <a:lnTo>
                    <a:pt x="2729" y="3129"/>
                  </a:lnTo>
                  <a:lnTo>
                    <a:pt x="2682" y="3135"/>
                  </a:lnTo>
                  <a:lnTo>
                    <a:pt x="2685" y="3135"/>
                  </a:lnTo>
                  <a:lnTo>
                    <a:pt x="2637" y="3149"/>
                  </a:lnTo>
                  <a:lnTo>
                    <a:pt x="2614" y="3156"/>
                  </a:lnTo>
                  <a:cubicBezTo>
                    <a:pt x="2613" y="3157"/>
                    <a:pt x="2611" y="3157"/>
                    <a:pt x="2610" y="3157"/>
                  </a:cubicBezTo>
                  <a:lnTo>
                    <a:pt x="2587" y="3160"/>
                  </a:lnTo>
                  <a:cubicBezTo>
                    <a:pt x="2585" y="3161"/>
                    <a:pt x="2582" y="3161"/>
                    <a:pt x="2580" y="3160"/>
                  </a:cubicBezTo>
                  <a:lnTo>
                    <a:pt x="2533" y="3154"/>
                  </a:lnTo>
                  <a:lnTo>
                    <a:pt x="2483" y="3143"/>
                  </a:lnTo>
                  <a:lnTo>
                    <a:pt x="2390" y="3131"/>
                  </a:lnTo>
                  <a:lnTo>
                    <a:pt x="2295" y="3114"/>
                  </a:lnTo>
                  <a:lnTo>
                    <a:pt x="2248" y="3106"/>
                  </a:lnTo>
                  <a:lnTo>
                    <a:pt x="2202" y="3101"/>
                  </a:lnTo>
                  <a:lnTo>
                    <a:pt x="2208" y="3101"/>
                  </a:lnTo>
                  <a:lnTo>
                    <a:pt x="2161" y="3108"/>
                  </a:lnTo>
                  <a:lnTo>
                    <a:pt x="2112" y="3114"/>
                  </a:lnTo>
                  <a:cubicBezTo>
                    <a:pt x="2111" y="3115"/>
                    <a:pt x="2109" y="3115"/>
                    <a:pt x="2107" y="3114"/>
                  </a:cubicBezTo>
                  <a:lnTo>
                    <a:pt x="2060" y="3109"/>
                  </a:lnTo>
                  <a:lnTo>
                    <a:pt x="2011" y="3101"/>
                  </a:lnTo>
                  <a:lnTo>
                    <a:pt x="2015" y="3101"/>
                  </a:lnTo>
                  <a:lnTo>
                    <a:pt x="1967" y="3100"/>
                  </a:lnTo>
                  <a:lnTo>
                    <a:pt x="1919" y="3097"/>
                  </a:lnTo>
                  <a:cubicBezTo>
                    <a:pt x="1917" y="3097"/>
                    <a:pt x="1916" y="3097"/>
                    <a:pt x="1914" y="3097"/>
                  </a:cubicBezTo>
                  <a:lnTo>
                    <a:pt x="1819" y="3072"/>
                  </a:lnTo>
                  <a:lnTo>
                    <a:pt x="1769" y="3052"/>
                  </a:lnTo>
                  <a:lnTo>
                    <a:pt x="1719" y="3023"/>
                  </a:lnTo>
                  <a:cubicBezTo>
                    <a:pt x="1717" y="3022"/>
                    <a:pt x="1715" y="3021"/>
                    <a:pt x="1714" y="3020"/>
                  </a:cubicBezTo>
                  <a:lnTo>
                    <a:pt x="1667" y="2975"/>
                  </a:lnTo>
                  <a:lnTo>
                    <a:pt x="1619" y="2922"/>
                  </a:lnTo>
                  <a:lnTo>
                    <a:pt x="1572" y="2870"/>
                  </a:lnTo>
                  <a:lnTo>
                    <a:pt x="1523" y="2811"/>
                  </a:lnTo>
                  <a:lnTo>
                    <a:pt x="1475" y="2742"/>
                  </a:lnTo>
                  <a:lnTo>
                    <a:pt x="1426" y="2661"/>
                  </a:lnTo>
                  <a:lnTo>
                    <a:pt x="1378" y="2565"/>
                  </a:lnTo>
                  <a:lnTo>
                    <a:pt x="1331" y="2461"/>
                  </a:lnTo>
                  <a:lnTo>
                    <a:pt x="1283" y="2353"/>
                  </a:lnTo>
                  <a:lnTo>
                    <a:pt x="1235" y="2238"/>
                  </a:lnTo>
                  <a:lnTo>
                    <a:pt x="1188" y="2111"/>
                  </a:lnTo>
                  <a:lnTo>
                    <a:pt x="1140" y="1980"/>
                  </a:lnTo>
                  <a:lnTo>
                    <a:pt x="1093" y="1849"/>
                  </a:lnTo>
                  <a:lnTo>
                    <a:pt x="1045" y="1715"/>
                  </a:lnTo>
                  <a:lnTo>
                    <a:pt x="998" y="1575"/>
                  </a:lnTo>
                  <a:lnTo>
                    <a:pt x="951" y="1428"/>
                  </a:lnTo>
                  <a:lnTo>
                    <a:pt x="903" y="1270"/>
                  </a:lnTo>
                  <a:lnTo>
                    <a:pt x="856" y="1112"/>
                  </a:lnTo>
                  <a:lnTo>
                    <a:pt x="809" y="969"/>
                  </a:lnTo>
                  <a:lnTo>
                    <a:pt x="761" y="827"/>
                  </a:lnTo>
                  <a:lnTo>
                    <a:pt x="737" y="750"/>
                  </a:lnTo>
                  <a:lnTo>
                    <a:pt x="714" y="674"/>
                  </a:lnTo>
                  <a:lnTo>
                    <a:pt x="690" y="599"/>
                  </a:lnTo>
                  <a:lnTo>
                    <a:pt x="667" y="533"/>
                  </a:lnTo>
                  <a:lnTo>
                    <a:pt x="643" y="479"/>
                  </a:lnTo>
                  <a:lnTo>
                    <a:pt x="620" y="433"/>
                  </a:lnTo>
                  <a:lnTo>
                    <a:pt x="573" y="348"/>
                  </a:lnTo>
                  <a:lnTo>
                    <a:pt x="527" y="264"/>
                  </a:lnTo>
                  <a:lnTo>
                    <a:pt x="479" y="194"/>
                  </a:lnTo>
                  <a:lnTo>
                    <a:pt x="458" y="169"/>
                  </a:lnTo>
                  <a:lnTo>
                    <a:pt x="435" y="147"/>
                  </a:lnTo>
                  <a:lnTo>
                    <a:pt x="390" y="111"/>
                  </a:lnTo>
                  <a:lnTo>
                    <a:pt x="342" y="70"/>
                  </a:lnTo>
                  <a:lnTo>
                    <a:pt x="320" y="54"/>
                  </a:lnTo>
                  <a:lnTo>
                    <a:pt x="324" y="56"/>
                  </a:lnTo>
                  <a:lnTo>
                    <a:pt x="301" y="46"/>
                  </a:lnTo>
                  <a:lnTo>
                    <a:pt x="311" y="48"/>
                  </a:lnTo>
                  <a:lnTo>
                    <a:pt x="287" y="49"/>
                  </a:lnTo>
                  <a:lnTo>
                    <a:pt x="294" y="48"/>
                  </a:lnTo>
                  <a:lnTo>
                    <a:pt x="270" y="56"/>
                  </a:lnTo>
                  <a:lnTo>
                    <a:pt x="248" y="66"/>
                  </a:lnTo>
                  <a:lnTo>
                    <a:pt x="222" y="73"/>
                  </a:lnTo>
                  <a:cubicBezTo>
                    <a:pt x="220" y="74"/>
                    <a:pt x="218" y="74"/>
                    <a:pt x="216" y="74"/>
                  </a:cubicBezTo>
                  <a:lnTo>
                    <a:pt x="169" y="75"/>
                  </a:lnTo>
                  <a:lnTo>
                    <a:pt x="120" y="74"/>
                  </a:lnTo>
                  <a:lnTo>
                    <a:pt x="27" y="82"/>
                  </a:lnTo>
                  <a:cubicBezTo>
                    <a:pt x="14" y="83"/>
                    <a:pt x="3" y="74"/>
                    <a:pt x="2" y="60"/>
                  </a:cubicBezTo>
                  <a:cubicBezTo>
                    <a:pt x="0" y="47"/>
                    <a:pt x="10" y="36"/>
                    <a:pt x="23" y="35"/>
                  </a:cubicBezTo>
                  <a:lnTo>
                    <a:pt x="121" y="26"/>
                  </a:lnTo>
                  <a:lnTo>
                    <a:pt x="168" y="27"/>
                  </a:lnTo>
                  <a:lnTo>
                    <a:pt x="215" y="26"/>
                  </a:lnTo>
                  <a:lnTo>
                    <a:pt x="208" y="28"/>
                  </a:lnTo>
                  <a:lnTo>
                    <a:pt x="229" y="21"/>
                  </a:lnTo>
                  <a:lnTo>
                    <a:pt x="255" y="11"/>
                  </a:lnTo>
                  <a:lnTo>
                    <a:pt x="279" y="3"/>
                  </a:lnTo>
                  <a:cubicBezTo>
                    <a:pt x="281" y="2"/>
                    <a:pt x="283" y="2"/>
                    <a:pt x="285" y="1"/>
                  </a:cubicBezTo>
                  <a:lnTo>
                    <a:pt x="309" y="0"/>
                  </a:lnTo>
                  <a:cubicBezTo>
                    <a:pt x="313" y="0"/>
                    <a:pt x="317" y="1"/>
                    <a:pt x="320" y="2"/>
                  </a:cubicBezTo>
                  <a:lnTo>
                    <a:pt x="343" y="12"/>
                  </a:lnTo>
                  <a:cubicBezTo>
                    <a:pt x="345" y="13"/>
                    <a:pt x="346" y="14"/>
                    <a:pt x="347" y="15"/>
                  </a:cubicBezTo>
                  <a:lnTo>
                    <a:pt x="373" y="33"/>
                  </a:lnTo>
                  <a:lnTo>
                    <a:pt x="419" y="74"/>
                  </a:lnTo>
                  <a:lnTo>
                    <a:pt x="469" y="113"/>
                  </a:lnTo>
                  <a:lnTo>
                    <a:pt x="493" y="138"/>
                  </a:lnTo>
                  <a:lnTo>
                    <a:pt x="519" y="167"/>
                  </a:lnTo>
                  <a:lnTo>
                    <a:pt x="568" y="241"/>
                  </a:lnTo>
                  <a:lnTo>
                    <a:pt x="616" y="325"/>
                  </a:lnTo>
                  <a:lnTo>
                    <a:pt x="663" y="412"/>
                  </a:lnTo>
                  <a:lnTo>
                    <a:pt x="688" y="460"/>
                  </a:lnTo>
                  <a:lnTo>
                    <a:pt x="712" y="518"/>
                  </a:lnTo>
                  <a:lnTo>
                    <a:pt x="735" y="584"/>
                  </a:lnTo>
                  <a:lnTo>
                    <a:pt x="759" y="659"/>
                  </a:lnTo>
                  <a:lnTo>
                    <a:pt x="783" y="737"/>
                  </a:lnTo>
                  <a:lnTo>
                    <a:pt x="806" y="812"/>
                  </a:lnTo>
                  <a:lnTo>
                    <a:pt x="854" y="954"/>
                  </a:lnTo>
                  <a:lnTo>
                    <a:pt x="901" y="1098"/>
                  </a:lnTo>
                  <a:lnTo>
                    <a:pt x="949" y="1257"/>
                  </a:lnTo>
                  <a:lnTo>
                    <a:pt x="996" y="1413"/>
                  </a:lnTo>
                  <a:lnTo>
                    <a:pt x="1043" y="1560"/>
                  </a:lnTo>
                  <a:lnTo>
                    <a:pt x="1090" y="1698"/>
                  </a:lnTo>
                  <a:lnTo>
                    <a:pt x="1138" y="1832"/>
                  </a:lnTo>
                  <a:lnTo>
                    <a:pt x="1185" y="1963"/>
                  </a:lnTo>
                  <a:lnTo>
                    <a:pt x="1233" y="2094"/>
                  </a:lnTo>
                  <a:lnTo>
                    <a:pt x="1280" y="2219"/>
                  </a:lnTo>
                  <a:lnTo>
                    <a:pt x="1326" y="2334"/>
                  </a:lnTo>
                  <a:lnTo>
                    <a:pt x="1374" y="2442"/>
                  </a:lnTo>
                  <a:lnTo>
                    <a:pt x="1421" y="2544"/>
                  </a:lnTo>
                  <a:lnTo>
                    <a:pt x="1467" y="2636"/>
                  </a:lnTo>
                  <a:lnTo>
                    <a:pt x="1514" y="2715"/>
                  </a:lnTo>
                  <a:lnTo>
                    <a:pt x="1560" y="2780"/>
                  </a:lnTo>
                  <a:lnTo>
                    <a:pt x="1607" y="2837"/>
                  </a:lnTo>
                  <a:lnTo>
                    <a:pt x="1654" y="2889"/>
                  </a:lnTo>
                  <a:lnTo>
                    <a:pt x="1700" y="2940"/>
                  </a:lnTo>
                  <a:lnTo>
                    <a:pt x="1747" y="2985"/>
                  </a:lnTo>
                  <a:lnTo>
                    <a:pt x="1742" y="2982"/>
                  </a:lnTo>
                  <a:lnTo>
                    <a:pt x="1787" y="3007"/>
                  </a:lnTo>
                  <a:lnTo>
                    <a:pt x="1832" y="3025"/>
                  </a:lnTo>
                  <a:lnTo>
                    <a:pt x="1927" y="3050"/>
                  </a:lnTo>
                  <a:lnTo>
                    <a:pt x="1922" y="3050"/>
                  </a:lnTo>
                  <a:lnTo>
                    <a:pt x="1968" y="3052"/>
                  </a:lnTo>
                  <a:lnTo>
                    <a:pt x="2016" y="3053"/>
                  </a:lnTo>
                  <a:cubicBezTo>
                    <a:pt x="2017" y="3053"/>
                    <a:pt x="2018" y="3054"/>
                    <a:pt x="2019" y="3054"/>
                  </a:cubicBezTo>
                  <a:lnTo>
                    <a:pt x="2065" y="3062"/>
                  </a:lnTo>
                  <a:lnTo>
                    <a:pt x="2112" y="3067"/>
                  </a:lnTo>
                  <a:lnTo>
                    <a:pt x="2106" y="3067"/>
                  </a:lnTo>
                  <a:lnTo>
                    <a:pt x="2154" y="3061"/>
                  </a:lnTo>
                  <a:lnTo>
                    <a:pt x="2201" y="3054"/>
                  </a:lnTo>
                  <a:cubicBezTo>
                    <a:pt x="2203" y="3053"/>
                    <a:pt x="2205" y="3053"/>
                    <a:pt x="2207" y="3054"/>
                  </a:cubicBezTo>
                  <a:lnTo>
                    <a:pt x="2256" y="3059"/>
                  </a:lnTo>
                  <a:lnTo>
                    <a:pt x="2304" y="3067"/>
                  </a:lnTo>
                  <a:lnTo>
                    <a:pt x="2396" y="3084"/>
                  </a:lnTo>
                  <a:lnTo>
                    <a:pt x="2494" y="3096"/>
                  </a:lnTo>
                  <a:lnTo>
                    <a:pt x="2540" y="3107"/>
                  </a:lnTo>
                  <a:lnTo>
                    <a:pt x="2587" y="3113"/>
                  </a:lnTo>
                  <a:lnTo>
                    <a:pt x="2580" y="3113"/>
                  </a:lnTo>
                  <a:lnTo>
                    <a:pt x="2603" y="3110"/>
                  </a:lnTo>
                  <a:lnTo>
                    <a:pt x="2599" y="3111"/>
                  </a:lnTo>
                  <a:lnTo>
                    <a:pt x="2624" y="3102"/>
                  </a:lnTo>
                  <a:lnTo>
                    <a:pt x="2672" y="3088"/>
                  </a:lnTo>
                  <a:cubicBezTo>
                    <a:pt x="2673" y="3088"/>
                    <a:pt x="2674" y="3088"/>
                    <a:pt x="2675" y="3088"/>
                  </a:cubicBezTo>
                  <a:lnTo>
                    <a:pt x="2722" y="3082"/>
                  </a:lnTo>
                  <a:lnTo>
                    <a:pt x="2767" y="3075"/>
                  </a:lnTo>
                  <a:lnTo>
                    <a:pt x="2814" y="3063"/>
                  </a:lnTo>
                  <a:lnTo>
                    <a:pt x="2863" y="3050"/>
                  </a:lnTo>
                  <a:lnTo>
                    <a:pt x="2910" y="3040"/>
                  </a:lnTo>
                  <a:lnTo>
                    <a:pt x="2957" y="3029"/>
                  </a:lnTo>
                  <a:lnTo>
                    <a:pt x="2953" y="3030"/>
                  </a:lnTo>
                  <a:lnTo>
                    <a:pt x="2999" y="3012"/>
                  </a:lnTo>
                  <a:lnTo>
                    <a:pt x="3046" y="2989"/>
                  </a:lnTo>
                  <a:lnTo>
                    <a:pt x="3140" y="2938"/>
                  </a:lnTo>
                  <a:lnTo>
                    <a:pt x="3237" y="2887"/>
                  </a:lnTo>
                  <a:lnTo>
                    <a:pt x="3284" y="2868"/>
                  </a:lnTo>
                  <a:lnTo>
                    <a:pt x="3331" y="2846"/>
                  </a:lnTo>
                  <a:lnTo>
                    <a:pt x="3328" y="2847"/>
                  </a:lnTo>
                  <a:lnTo>
                    <a:pt x="3375" y="2817"/>
                  </a:lnTo>
                  <a:lnTo>
                    <a:pt x="3424" y="2784"/>
                  </a:lnTo>
                  <a:lnTo>
                    <a:pt x="3471" y="2757"/>
                  </a:lnTo>
                  <a:lnTo>
                    <a:pt x="3517" y="2730"/>
                  </a:lnTo>
                  <a:lnTo>
                    <a:pt x="3564" y="2697"/>
                  </a:lnTo>
                  <a:lnTo>
                    <a:pt x="3611" y="2659"/>
                  </a:lnTo>
                  <a:lnTo>
                    <a:pt x="3705" y="2588"/>
                  </a:lnTo>
                  <a:lnTo>
                    <a:pt x="3798" y="2509"/>
                  </a:lnTo>
                  <a:lnTo>
                    <a:pt x="3894" y="2420"/>
                  </a:lnTo>
                  <a:lnTo>
                    <a:pt x="3990" y="2335"/>
                  </a:lnTo>
                  <a:lnTo>
                    <a:pt x="4085" y="2262"/>
                  </a:lnTo>
                  <a:lnTo>
                    <a:pt x="4180" y="2200"/>
                  </a:lnTo>
                  <a:lnTo>
                    <a:pt x="4276" y="2132"/>
                  </a:lnTo>
                  <a:lnTo>
                    <a:pt x="4373" y="2072"/>
                  </a:lnTo>
                  <a:lnTo>
                    <a:pt x="4469" y="2025"/>
                  </a:lnTo>
                  <a:lnTo>
                    <a:pt x="4517" y="2008"/>
                  </a:lnTo>
                  <a:lnTo>
                    <a:pt x="4563" y="1991"/>
                  </a:lnTo>
                  <a:lnTo>
                    <a:pt x="4611" y="1971"/>
                  </a:lnTo>
                  <a:lnTo>
                    <a:pt x="4660" y="1949"/>
                  </a:lnTo>
                  <a:lnTo>
                    <a:pt x="4754" y="1916"/>
                  </a:lnTo>
                  <a:cubicBezTo>
                    <a:pt x="4766" y="1911"/>
                    <a:pt x="4780" y="1918"/>
                    <a:pt x="4784" y="1931"/>
                  </a:cubicBezTo>
                  <a:cubicBezTo>
                    <a:pt x="4789" y="1943"/>
                    <a:pt x="4782" y="1957"/>
                    <a:pt x="4769" y="1961"/>
                  </a:cubicBezTo>
                  <a:close/>
                </a:path>
              </a:pathLst>
            </a:custGeom>
            <a:solidFill>
              <a:srgbClr val="4A7EBB"/>
            </a:solidFill>
            <a:ln w="9525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979" name="Freeform 11"/>
            <p:cNvSpPr>
              <a:spLocks/>
            </p:cNvSpPr>
            <p:nvPr/>
          </p:nvSpPr>
          <p:spPr bwMode="auto">
            <a:xfrm>
              <a:off x="3354" y="1187"/>
              <a:ext cx="1809" cy="1113"/>
            </a:xfrm>
            <a:custGeom>
              <a:avLst/>
              <a:gdLst/>
              <a:ahLst/>
              <a:cxnLst>
                <a:cxn ang="0">
                  <a:pos x="4397" y="2070"/>
                </a:cxn>
                <a:cxn ang="0">
                  <a:pos x="4158" y="2216"/>
                </a:cxn>
                <a:cxn ang="0">
                  <a:pos x="3975" y="2361"/>
                </a:cxn>
                <a:cxn ang="0">
                  <a:pos x="3846" y="2429"/>
                </a:cxn>
                <a:cxn ang="0">
                  <a:pos x="3785" y="2476"/>
                </a:cxn>
                <a:cxn ang="0">
                  <a:pos x="3499" y="2679"/>
                </a:cxn>
                <a:cxn ang="0">
                  <a:pos x="3306" y="2809"/>
                </a:cxn>
                <a:cxn ang="0">
                  <a:pos x="2970" y="2902"/>
                </a:cxn>
                <a:cxn ang="0">
                  <a:pos x="2769" y="2915"/>
                </a:cxn>
                <a:cxn ang="0">
                  <a:pos x="2346" y="2891"/>
                </a:cxn>
                <a:cxn ang="0">
                  <a:pos x="2155" y="2892"/>
                </a:cxn>
                <a:cxn ang="0">
                  <a:pos x="2094" y="2896"/>
                </a:cxn>
                <a:cxn ang="0">
                  <a:pos x="1947" y="2945"/>
                </a:cxn>
                <a:cxn ang="0">
                  <a:pos x="1885" y="2933"/>
                </a:cxn>
                <a:cxn ang="0">
                  <a:pos x="1715" y="2821"/>
                </a:cxn>
                <a:cxn ang="0">
                  <a:pos x="1477" y="2548"/>
                </a:cxn>
                <a:cxn ang="0">
                  <a:pos x="1331" y="2272"/>
                </a:cxn>
                <a:cxn ang="0">
                  <a:pos x="1094" y="1711"/>
                </a:cxn>
                <a:cxn ang="0">
                  <a:pos x="928" y="1279"/>
                </a:cxn>
                <a:cxn ang="0">
                  <a:pos x="810" y="921"/>
                </a:cxn>
                <a:cxn ang="0">
                  <a:pos x="596" y="414"/>
                </a:cxn>
                <a:cxn ang="0">
                  <a:pos x="483" y="255"/>
                </a:cxn>
                <a:cxn ang="0">
                  <a:pos x="322" y="60"/>
                </a:cxn>
                <a:cxn ang="0">
                  <a:pos x="271" y="55"/>
                </a:cxn>
                <a:cxn ang="0">
                  <a:pos x="138" y="131"/>
                </a:cxn>
                <a:cxn ang="0">
                  <a:pos x="8" y="203"/>
                </a:cxn>
                <a:cxn ang="0">
                  <a:pos x="159" y="60"/>
                </a:cxn>
                <a:cxn ang="0">
                  <a:pos x="288" y="0"/>
                </a:cxn>
                <a:cxn ang="0">
                  <a:pos x="377" y="49"/>
                </a:cxn>
                <a:cxn ang="0">
                  <a:pos x="567" y="276"/>
                </a:cxn>
                <a:cxn ang="0">
                  <a:pos x="689" y="511"/>
                </a:cxn>
                <a:cxn ang="0">
                  <a:pos x="902" y="1028"/>
                </a:cxn>
                <a:cxn ang="0">
                  <a:pos x="1020" y="1400"/>
                </a:cxn>
                <a:cxn ang="0">
                  <a:pos x="1234" y="1926"/>
                </a:cxn>
                <a:cxn ang="0">
                  <a:pos x="1446" y="2408"/>
                </a:cxn>
                <a:cxn ang="0">
                  <a:pos x="1609" y="2635"/>
                </a:cxn>
                <a:cxn ang="0">
                  <a:pos x="1792" y="2817"/>
                </a:cxn>
                <a:cxn ang="0">
                  <a:pos x="1929" y="2898"/>
                </a:cxn>
                <a:cxn ang="0">
                  <a:pos x="1961" y="2896"/>
                </a:cxn>
                <a:cxn ang="0">
                  <a:pos x="2109" y="2842"/>
                </a:cxn>
                <a:cxn ang="0">
                  <a:pos x="2203" y="2851"/>
                </a:cxn>
                <a:cxn ang="0">
                  <a:pos x="2489" y="2850"/>
                </a:cxn>
                <a:cxn ang="0">
                  <a:pos x="2870" y="2880"/>
                </a:cxn>
                <a:cxn ang="0">
                  <a:pos x="3100" y="2820"/>
                </a:cxn>
                <a:cxn ang="0">
                  <a:pos x="3329" y="2745"/>
                </a:cxn>
                <a:cxn ang="0">
                  <a:pos x="3568" y="2575"/>
                </a:cxn>
                <a:cxn ang="0">
                  <a:pos x="3801" y="2399"/>
                </a:cxn>
                <a:cxn ang="0">
                  <a:pos x="3876" y="2370"/>
                </a:cxn>
                <a:cxn ang="0">
                  <a:pos x="4037" y="2241"/>
                </a:cxn>
                <a:cxn ang="0">
                  <a:pos x="4231" y="2125"/>
                </a:cxn>
                <a:cxn ang="0">
                  <a:pos x="4561" y="1916"/>
                </a:cxn>
              </a:cxnLst>
              <a:rect l="0" t="0" r="r" b="b"/>
              <a:pathLst>
                <a:path w="4790" h="2946">
                  <a:moveTo>
                    <a:pt x="4775" y="1843"/>
                  </a:moveTo>
                  <a:lnTo>
                    <a:pt x="4681" y="1902"/>
                  </a:lnTo>
                  <a:lnTo>
                    <a:pt x="4585" y="1957"/>
                  </a:lnTo>
                  <a:lnTo>
                    <a:pt x="4490" y="2011"/>
                  </a:lnTo>
                  <a:lnTo>
                    <a:pt x="4397" y="2070"/>
                  </a:lnTo>
                  <a:lnTo>
                    <a:pt x="4351" y="2105"/>
                  </a:lnTo>
                  <a:lnTo>
                    <a:pt x="4304" y="2140"/>
                  </a:lnTo>
                  <a:lnTo>
                    <a:pt x="4254" y="2167"/>
                  </a:lnTo>
                  <a:lnTo>
                    <a:pt x="4205" y="2192"/>
                  </a:lnTo>
                  <a:lnTo>
                    <a:pt x="4158" y="2216"/>
                  </a:lnTo>
                  <a:lnTo>
                    <a:pt x="4111" y="2242"/>
                  </a:lnTo>
                  <a:lnTo>
                    <a:pt x="4115" y="2239"/>
                  </a:lnTo>
                  <a:lnTo>
                    <a:pt x="4068" y="2278"/>
                  </a:lnTo>
                  <a:lnTo>
                    <a:pt x="4021" y="2319"/>
                  </a:lnTo>
                  <a:lnTo>
                    <a:pt x="3975" y="2361"/>
                  </a:lnTo>
                  <a:lnTo>
                    <a:pt x="3925" y="2399"/>
                  </a:lnTo>
                  <a:cubicBezTo>
                    <a:pt x="3924" y="2401"/>
                    <a:pt x="3922" y="2402"/>
                    <a:pt x="3920" y="2402"/>
                  </a:cubicBezTo>
                  <a:lnTo>
                    <a:pt x="3896" y="2413"/>
                  </a:lnTo>
                  <a:lnTo>
                    <a:pt x="3870" y="2421"/>
                  </a:lnTo>
                  <a:lnTo>
                    <a:pt x="3846" y="2429"/>
                  </a:lnTo>
                  <a:lnTo>
                    <a:pt x="3850" y="2427"/>
                  </a:lnTo>
                  <a:lnTo>
                    <a:pt x="3826" y="2439"/>
                  </a:lnTo>
                  <a:lnTo>
                    <a:pt x="3830" y="2436"/>
                  </a:lnTo>
                  <a:lnTo>
                    <a:pt x="3807" y="2454"/>
                  </a:lnTo>
                  <a:lnTo>
                    <a:pt x="3785" y="2476"/>
                  </a:lnTo>
                  <a:lnTo>
                    <a:pt x="3738" y="2519"/>
                  </a:lnTo>
                  <a:lnTo>
                    <a:pt x="3640" y="2588"/>
                  </a:lnTo>
                  <a:lnTo>
                    <a:pt x="3591" y="2616"/>
                  </a:lnTo>
                  <a:lnTo>
                    <a:pt x="3544" y="2644"/>
                  </a:lnTo>
                  <a:lnTo>
                    <a:pt x="3499" y="2679"/>
                  </a:lnTo>
                  <a:lnTo>
                    <a:pt x="3452" y="2717"/>
                  </a:lnTo>
                  <a:lnTo>
                    <a:pt x="3404" y="2754"/>
                  </a:lnTo>
                  <a:lnTo>
                    <a:pt x="3356" y="2786"/>
                  </a:lnTo>
                  <a:cubicBezTo>
                    <a:pt x="3355" y="2786"/>
                    <a:pt x="3354" y="2787"/>
                    <a:pt x="3353" y="2787"/>
                  </a:cubicBezTo>
                  <a:lnTo>
                    <a:pt x="3306" y="2809"/>
                  </a:lnTo>
                  <a:lnTo>
                    <a:pt x="3255" y="2826"/>
                  </a:lnTo>
                  <a:lnTo>
                    <a:pt x="3159" y="2855"/>
                  </a:lnTo>
                  <a:lnTo>
                    <a:pt x="3111" y="2867"/>
                  </a:lnTo>
                  <a:lnTo>
                    <a:pt x="3063" y="2877"/>
                  </a:lnTo>
                  <a:lnTo>
                    <a:pt x="2970" y="2902"/>
                  </a:lnTo>
                  <a:lnTo>
                    <a:pt x="2924" y="2916"/>
                  </a:lnTo>
                  <a:lnTo>
                    <a:pt x="2873" y="2927"/>
                  </a:lnTo>
                  <a:cubicBezTo>
                    <a:pt x="2871" y="2927"/>
                    <a:pt x="2869" y="2928"/>
                    <a:pt x="2867" y="2927"/>
                  </a:cubicBezTo>
                  <a:lnTo>
                    <a:pt x="2820" y="2924"/>
                  </a:lnTo>
                  <a:lnTo>
                    <a:pt x="2769" y="2915"/>
                  </a:lnTo>
                  <a:lnTo>
                    <a:pt x="2676" y="2902"/>
                  </a:lnTo>
                  <a:lnTo>
                    <a:pt x="2583" y="2898"/>
                  </a:lnTo>
                  <a:lnTo>
                    <a:pt x="2489" y="2898"/>
                  </a:lnTo>
                  <a:lnTo>
                    <a:pt x="2393" y="2894"/>
                  </a:lnTo>
                  <a:lnTo>
                    <a:pt x="2346" y="2891"/>
                  </a:lnTo>
                  <a:lnTo>
                    <a:pt x="2300" y="2890"/>
                  </a:lnTo>
                  <a:lnTo>
                    <a:pt x="2256" y="2894"/>
                  </a:lnTo>
                  <a:lnTo>
                    <a:pt x="2207" y="2898"/>
                  </a:lnTo>
                  <a:cubicBezTo>
                    <a:pt x="2206" y="2899"/>
                    <a:pt x="2204" y="2898"/>
                    <a:pt x="2202" y="2898"/>
                  </a:cubicBezTo>
                  <a:lnTo>
                    <a:pt x="2155" y="2892"/>
                  </a:lnTo>
                  <a:lnTo>
                    <a:pt x="2131" y="2889"/>
                  </a:lnTo>
                  <a:lnTo>
                    <a:pt x="2135" y="2889"/>
                  </a:lnTo>
                  <a:lnTo>
                    <a:pt x="2111" y="2890"/>
                  </a:lnTo>
                  <a:lnTo>
                    <a:pt x="2117" y="2889"/>
                  </a:lnTo>
                  <a:lnTo>
                    <a:pt x="2094" y="2896"/>
                  </a:lnTo>
                  <a:lnTo>
                    <a:pt x="2073" y="2906"/>
                  </a:lnTo>
                  <a:lnTo>
                    <a:pt x="2026" y="2926"/>
                  </a:lnTo>
                  <a:lnTo>
                    <a:pt x="1976" y="2941"/>
                  </a:lnTo>
                  <a:cubicBezTo>
                    <a:pt x="1974" y="2942"/>
                    <a:pt x="1973" y="2942"/>
                    <a:pt x="1971" y="2942"/>
                  </a:cubicBezTo>
                  <a:lnTo>
                    <a:pt x="1947" y="2945"/>
                  </a:lnTo>
                  <a:cubicBezTo>
                    <a:pt x="1946" y="2945"/>
                    <a:pt x="1945" y="2946"/>
                    <a:pt x="1943" y="2945"/>
                  </a:cubicBezTo>
                  <a:lnTo>
                    <a:pt x="1920" y="2944"/>
                  </a:lnTo>
                  <a:cubicBezTo>
                    <a:pt x="1918" y="2944"/>
                    <a:pt x="1916" y="2944"/>
                    <a:pt x="1914" y="2943"/>
                  </a:cubicBezTo>
                  <a:lnTo>
                    <a:pt x="1890" y="2935"/>
                  </a:lnTo>
                  <a:cubicBezTo>
                    <a:pt x="1888" y="2935"/>
                    <a:pt x="1887" y="2934"/>
                    <a:pt x="1885" y="2933"/>
                  </a:cubicBezTo>
                  <a:lnTo>
                    <a:pt x="1862" y="2919"/>
                  </a:lnTo>
                  <a:lnTo>
                    <a:pt x="1813" y="2886"/>
                  </a:lnTo>
                  <a:lnTo>
                    <a:pt x="1767" y="2858"/>
                  </a:lnTo>
                  <a:lnTo>
                    <a:pt x="1718" y="2823"/>
                  </a:lnTo>
                  <a:cubicBezTo>
                    <a:pt x="1717" y="2822"/>
                    <a:pt x="1716" y="2822"/>
                    <a:pt x="1715" y="2821"/>
                  </a:cubicBezTo>
                  <a:lnTo>
                    <a:pt x="1668" y="2776"/>
                  </a:lnTo>
                  <a:lnTo>
                    <a:pt x="1620" y="2723"/>
                  </a:lnTo>
                  <a:lnTo>
                    <a:pt x="1572" y="2666"/>
                  </a:lnTo>
                  <a:lnTo>
                    <a:pt x="1524" y="2604"/>
                  </a:lnTo>
                  <a:lnTo>
                    <a:pt x="1477" y="2548"/>
                  </a:lnTo>
                  <a:lnTo>
                    <a:pt x="1452" y="2515"/>
                  </a:lnTo>
                  <a:lnTo>
                    <a:pt x="1427" y="2477"/>
                  </a:lnTo>
                  <a:lnTo>
                    <a:pt x="1403" y="2431"/>
                  </a:lnTo>
                  <a:lnTo>
                    <a:pt x="1379" y="2380"/>
                  </a:lnTo>
                  <a:lnTo>
                    <a:pt x="1331" y="2272"/>
                  </a:lnTo>
                  <a:lnTo>
                    <a:pt x="1284" y="2165"/>
                  </a:lnTo>
                  <a:lnTo>
                    <a:pt x="1236" y="2054"/>
                  </a:lnTo>
                  <a:lnTo>
                    <a:pt x="1189" y="1945"/>
                  </a:lnTo>
                  <a:lnTo>
                    <a:pt x="1141" y="1832"/>
                  </a:lnTo>
                  <a:lnTo>
                    <a:pt x="1094" y="1711"/>
                  </a:lnTo>
                  <a:lnTo>
                    <a:pt x="1046" y="1588"/>
                  </a:lnTo>
                  <a:lnTo>
                    <a:pt x="999" y="1477"/>
                  </a:lnTo>
                  <a:lnTo>
                    <a:pt x="975" y="1419"/>
                  </a:lnTo>
                  <a:lnTo>
                    <a:pt x="952" y="1354"/>
                  </a:lnTo>
                  <a:lnTo>
                    <a:pt x="928" y="1279"/>
                  </a:lnTo>
                  <a:lnTo>
                    <a:pt x="904" y="1197"/>
                  </a:lnTo>
                  <a:lnTo>
                    <a:pt x="880" y="1116"/>
                  </a:lnTo>
                  <a:lnTo>
                    <a:pt x="857" y="1043"/>
                  </a:lnTo>
                  <a:lnTo>
                    <a:pt x="833" y="980"/>
                  </a:lnTo>
                  <a:lnTo>
                    <a:pt x="810" y="921"/>
                  </a:lnTo>
                  <a:lnTo>
                    <a:pt x="762" y="810"/>
                  </a:lnTo>
                  <a:lnTo>
                    <a:pt x="668" y="588"/>
                  </a:lnTo>
                  <a:lnTo>
                    <a:pt x="644" y="530"/>
                  </a:lnTo>
                  <a:lnTo>
                    <a:pt x="620" y="471"/>
                  </a:lnTo>
                  <a:lnTo>
                    <a:pt x="596" y="414"/>
                  </a:lnTo>
                  <a:lnTo>
                    <a:pt x="574" y="367"/>
                  </a:lnTo>
                  <a:lnTo>
                    <a:pt x="551" y="333"/>
                  </a:lnTo>
                  <a:lnTo>
                    <a:pt x="530" y="307"/>
                  </a:lnTo>
                  <a:lnTo>
                    <a:pt x="507" y="283"/>
                  </a:lnTo>
                  <a:lnTo>
                    <a:pt x="483" y="255"/>
                  </a:lnTo>
                  <a:lnTo>
                    <a:pt x="435" y="194"/>
                  </a:lnTo>
                  <a:lnTo>
                    <a:pt x="387" y="137"/>
                  </a:lnTo>
                  <a:lnTo>
                    <a:pt x="340" y="80"/>
                  </a:lnTo>
                  <a:lnTo>
                    <a:pt x="317" y="56"/>
                  </a:lnTo>
                  <a:lnTo>
                    <a:pt x="322" y="60"/>
                  </a:lnTo>
                  <a:lnTo>
                    <a:pt x="299" y="46"/>
                  </a:lnTo>
                  <a:lnTo>
                    <a:pt x="310" y="49"/>
                  </a:lnTo>
                  <a:lnTo>
                    <a:pt x="286" y="48"/>
                  </a:lnTo>
                  <a:lnTo>
                    <a:pt x="295" y="47"/>
                  </a:lnTo>
                  <a:lnTo>
                    <a:pt x="271" y="55"/>
                  </a:lnTo>
                  <a:lnTo>
                    <a:pt x="275" y="53"/>
                  </a:lnTo>
                  <a:lnTo>
                    <a:pt x="228" y="79"/>
                  </a:lnTo>
                  <a:lnTo>
                    <a:pt x="180" y="103"/>
                  </a:lnTo>
                  <a:lnTo>
                    <a:pt x="135" y="133"/>
                  </a:lnTo>
                  <a:lnTo>
                    <a:pt x="138" y="131"/>
                  </a:lnTo>
                  <a:lnTo>
                    <a:pt x="115" y="153"/>
                  </a:lnTo>
                  <a:lnTo>
                    <a:pt x="92" y="178"/>
                  </a:lnTo>
                  <a:lnTo>
                    <a:pt x="45" y="234"/>
                  </a:lnTo>
                  <a:cubicBezTo>
                    <a:pt x="36" y="244"/>
                    <a:pt x="21" y="245"/>
                    <a:pt x="11" y="237"/>
                  </a:cubicBezTo>
                  <a:cubicBezTo>
                    <a:pt x="1" y="228"/>
                    <a:pt x="0" y="213"/>
                    <a:pt x="8" y="203"/>
                  </a:cubicBezTo>
                  <a:lnTo>
                    <a:pt x="57" y="147"/>
                  </a:lnTo>
                  <a:lnTo>
                    <a:pt x="82" y="118"/>
                  </a:lnTo>
                  <a:lnTo>
                    <a:pt x="105" y="96"/>
                  </a:lnTo>
                  <a:cubicBezTo>
                    <a:pt x="106" y="95"/>
                    <a:pt x="107" y="94"/>
                    <a:pt x="108" y="93"/>
                  </a:cubicBezTo>
                  <a:lnTo>
                    <a:pt x="159" y="60"/>
                  </a:lnTo>
                  <a:lnTo>
                    <a:pt x="205" y="37"/>
                  </a:lnTo>
                  <a:lnTo>
                    <a:pt x="252" y="11"/>
                  </a:lnTo>
                  <a:cubicBezTo>
                    <a:pt x="253" y="11"/>
                    <a:pt x="254" y="10"/>
                    <a:pt x="256" y="10"/>
                  </a:cubicBezTo>
                  <a:lnTo>
                    <a:pt x="280" y="2"/>
                  </a:lnTo>
                  <a:cubicBezTo>
                    <a:pt x="283" y="1"/>
                    <a:pt x="286" y="0"/>
                    <a:pt x="288" y="0"/>
                  </a:cubicBezTo>
                  <a:lnTo>
                    <a:pt x="312" y="1"/>
                  </a:lnTo>
                  <a:cubicBezTo>
                    <a:pt x="317" y="2"/>
                    <a:pt x="320" y="3"/>
                    <a:pt x="324" y="5"/>
                  </a:cubicBezTo>
                  <a:lnTo>
                    <a:pt x="347" y="19"/>
                  </a:lnTo>
                  <a:cubicBezTo>
                    <a:pt x="349" y="20"/>
                    <a:pt x="350" y="21"/>
                    <a:pt x="352" y="23"/>
                  </a:cubicBezTo>
                  <a:lnTo>
                    <a:pt x="377" y="49"/>
                  </a:lnTo>
                  <a:lnTo>
                    <a:pt x="424" y="106"/>
                  </a:lnTo>
                  <a:lnTo>
                    <a:pt x="472" y="165"/>
                  </a:lnTo>
                  <a:lnTo>
                    <a:pt x="518" y="224"/>
                  </a:lnTo>
                  <a:lnTo>
                    <a:pt x="542" y="250"/>
                  </a:lnTo>
                  <a:lnTo>
                    <a:pt x="567" y="276"/>
                  </a:lnTo>
                  <a:lnTo>
                    <a:pt x="592" y="306"/>
                  </a:lnTo>
                  <a:lnTo>
                    <a:pt x="617" y="346"/>
                  </a:lnTo>
                  <a:lnTo>
                    <a:pt x="641" y="395"/>
                  </a:lnTo>
                  <a:lnTo>
                    <a:pt x="665" y="452"/>
                  </a:lnTo>
                  <a:lnTo>
                    <a:pt x="689" y="511"/>
                  </a:lnTo>
                  <a:lnTo>
                    <a:pt x="713" y="569"/>
                  </a:lnTo>
                  <a:lnTo>
                    <a:pt x="807" y="791"/>
                  </a:lnTo>
                  <a:lnTo>
                    <a:pt x="855" y="904"/>
                  </a:lnTo>
                  <a:lnTo>
                    <a:pt x="878" y="963"/>
                  </a:lnTo>
                  <a:lnTo>
                    <a:pt x="902" y="1028"/>
                  </a:lnTo>
                  <a:lnTo>
                    <a:pt x="926" y="1103"/>
                  </a:lnTo>
                  <a:lnTo>
                    <a:pt x="951" y="1184"/>
                  </a:lnTo>
                  <a:lnTo>
                    <a:pt x="973" y="1264"/>
                  </a:lnTo>
                  <a:lnTo>
                    <a:pt x="997" y="1337"/>
                  </a:lnTo>
                  <a:lnTo>
                    <a:pt x="1020" y="1400"/>
                  </a:lnTo>
                  <a:lnTo>
                    <a:pt x="1044" y="1458"/>
                  </a:lnTo>
                  <a:lnTo>
                    <a:pt x="1091" y="1571"/>
                  </a:lnTo>
                  <a:lnTo>
                    <a:pt x="1139" y="1694"/>
                  </a:lnTo>
                  <a:lnTo>
                    <a:pt x="1186" y="1813"/>
                  </a:lnTo>
                  <a:lnTo>
                    <a:pt x="1234" y="1926"/>
                  </a:lnTo>
                  <a:lnTo>
                    <a:pt x="1281" y="2035"/>
                  </a:lnTo>
                  <a:lnTo>
                    <a:pt x="1327" y="2146"/>
                  </a:lnTo>
                  <a:lnTo>
                    <a:pt x="1375" y="2253"/>
                  </a:lnTo>
                  <a:lnTo>
                    <a:pt x="1422" y="2359"/>
                  </a:lnTo>
                  <a:lnTo>
                    <a:pt x="1446" y="2408"/>
                  </a:lnTo>
                  <a:lnTo>
                    <a:pt x="1468" y="2450"/>
                  </a:lnTo>
                  <a:lnTo>
                    <a:pt x="1491" y="2486"/>
                  </a:lnTo>
                  <a:lnTo>
                    <a:pt x="1514" y="2517"/>
                  </a:lnTo>
                  <a:lnTo>
                    <a:pt x="1561" y="2575"/>
                  </a:lnTo>
                  <a:lnTo>
                    <a:pt x="1609" y="2635"/>
                  </a:lnTo>
                  <a:lnTo>
                    <a:pt x="1655" y="2690"/>
                  </a:lnTo>
                  <a:lnTo>
                    <a:pt x="1701" y="2741"/>
                  </a:lnTo>
                  <a:lnTo>
                    <a:pt x="1748" y="2786"/>
                  </a:lnTo>
                  <a:lnTo>
                    <a:pt x="1745" y="2784"/>
                  </a:lnTo>
                  <a:lnTo>
                    <a:pt x="1792" y="2817"/>
                  </a:lnTo>
                  <a:lnTo>
                    <a:pt x="1840" y="2846"/>
                  </a:lnTo>
                  <a:lnTo>
                    <a:pt x="1887" y="2878"/>
                  </a:lnTo>
                  <a:lnTo>
                    <a:pt x="1910" y="2892"/>
                  </a:lnTo>
                  <a:lnTo>
                    <a:pt x="1905" y="2890"/>
                  </a:lnTo>
                  <a:lnTo>
                    <a:pt x="1929" y="2898"/>
                  </a:lnTo>
                  <a:lnTo>
                    <a:pt x="1923" y="2896"/>
                  </a:lnTo>
                  <a:lnTo>
                    <a:pt x="1946" y="2897"/>
                  </a:lnTo>
                  <a:lnTo>
                    <a:pt x="1941" y="2898"/>
                  </a:lnTo>
                  <a:lnTo>
                    <a:pt x="1965" y="2895"/>
                  </a:lnTo>
                  <a:lnTo>
                    <a:pt x="1961" y="2896"/>
                  </a:lnTo>
                  <a:lnTo>
                    <a:pt x="2007" y="2881"/>
                  </a:lnTo>
                  <a:lnTo>
                    <a:pt x="2054" y="2861"/>
                  </a:lnTo>
                  <a:lnTo>
                    <a:pt x="2080" y="2851"/>
                  </a:lnTo>
                  <a:lnTo>
                    <a:pt x="2103" y="2844"/>
                  </a:lnTo>
                  <a:cubicBezTo>
                    <a:pt x="2105" y="2843"/>
                    <a:pt x="2107" y="2843"/>
                    <a:pt x="2109" y="2842"/>
                  </a:cubicBezTo>
                  <a:lnTo>
                    <a:pt x="2133" y="2841"/>
                  </a:lnTo>
                  <a:cubicBezTo>
                    <a:pt x="2135" y="2841"/>
                    <a:pt x="2136" y="2841"/>
                    <a:pt x="2137" y="2842"/>
                  </a:cubicBezTo>
                  <a:lnTo>
                    <a:pt x="2162" y="2845"/>
                  </a:lnTo>
                  <a:lnTo>
                    <a:pt x="2209" y="2851"/>
                  </a:lnTo>
                  <a:lnTo>
                    <a:pt x="2203" y="2851"/>
                  </a:lnTo>
                  <a:lnTo>
                    <a:pt x="2251" y="2847"/>
                  </a:lnTo>
                  <a:lnTo>
                    <a:pt x="2301" y="2842"/>
                  </a:lnTo>
                  <a:lnTo>
                    <a:pt x="2349" y="2844"/>
                  </a:lnTo>
                  <a:lnTo>
                    <a:pt x="2395" y="2846"/>
                  </a:lnTo>
                  <a:lnTo>
                    <a:pt x="2489" y="2850"/>
                  </a:lnTo>
                  <a:lnTo>
                    <a:pt x="2585" y="2850"/>
                  </a:lnTo>
                  <a:lnTo>
                    <a:pt x="2683" y="2855"/>
                  </a:lnTo>
                  <a:lnTo>
                    <a:pt x="2778" y="2868"/>
                  </a:lnTo>
                  <a:lnTo>
                    <a:pt x="2823" y="2877"/>
                  </a:lnTo>
                  <a:lnTo>
                    <a:pt x="2870" y="2880"/>
                  </a:lnTo>
                  <a:lnTo>
                    <a:pt x="2864" y="2880"/>
                  </a:lnTo>
                  <a:lnTo>
                    <a:pt x="2909" y="2871"/>
                  </a:lnTo>
                  <a:lnTo>
                    <a:pt x="2957" y="2855"/>
                  </a:lnTo>
                  <a:lnTo>
                    <a:pt x="3053" y="2830"/>
                  </a:lnTo>
                  <a:lnTo>
                    <a:pt x="3100" y="2820"/>
                  </a:lnTo>
                  <a:lnTo>
                    <a:pt x="3145" y="2810"/>
                  </a:lnTo>
                  <a:lnTo>
                    <a:pt x="3240" y="2781"/>
                  </a:lnTo>
                  <a:lnTo>
                    <a:pt x="3285" y="2766"/>
                  </a:lnTo>
                  <a:lnTo>
                    <a:pt x="3332" y="2744"/>
                  </a:lnTo>
                  <a:lnTo>
                    <a:pt x="3329" y="2745"/>
                  </a:lnTo>
                  <a:lnTo>
                    <a:pt x="3375" y="2715"/>
                  </a:lnTo>
                  <a:lnTo>
                    <a:pt x="3421" y="2680"/>
                  </a:lnTo>
                  <a:lnTo>
                    <a:pt x="3470" y="2640"/>
                  </a:lnTo>
                  <a:lnTo>
                    <a:pt x="3519" y="2603"/>
                  </a:lnTo>
                  <a:lnTo>
                    <a:pt x="3568" y="2575"/>
                  </a:lnTo>
                  <a:lnTo>
                    <a:pt x="3613" y="2549"/>
                  </a:lnTo>
                  <a:lnTo>
                    <a:pt x="3705" y="2484"/>
                  </a:lnTo>
                  <a:lnTo>
                    <a:pt x="3752" y="2441"/>
                  </a:lnTo>
                  <a:lnTo>
                    <a:pt x="3778" y="2417"/>
                  </a:lnTo>
                  <a:lnTo>
                    <a:pt x="3801" y="2399"/>
                  </a:lnTo>
                  <a:cubicBezTo>
                    <a:pt x="3802" y="2398"/>
                    <a:pt x="3803" y="2397"/>
                    <a:pt x="3805" y="2396"/>
                  </a:cubicBezTo>
                  <a:lnTo>
                    <a:pt x="3829" y="2384"/>
                  </a:lnTo>
                  <a:cubicBezTo>
                    <a:pt x="3830" y="2383"/>
                    <a:pt x="3831" y="2383"/>
                    <a:pt x="3833" y="2382"/>
                  </a:cubicBezTo>
                  <a:lnTo>
                    <a:pt x="3856" y="2376"/>
                  </a:lnTo>
                  <a:lnTo>
                    <a:pt x="3876" y="2370"/>
                  </a:lnTo>
                  <a:lnTo>
                    <a:pt x="3900" y="2359"/>
                  </a:lnTo>
                  <a:lnTo>
                    <a:pt x="3896" y="2361"/>
                  </a:lnTo>
                  <a:lnTo>
                    <a:pt x="3942" y="2326"/>
                  </a:lnTo>
                  <a:lnTo>
                    <a:pt x="3990" y="2282"/>
                  </a:lnTo>
                  <a:lnTo>
                    <a:pt x="4037" y="2241"/>
                  </a:lnTo>
                  <a:lnTo>
                    <a:pt x="4084" y="2202"/>
                  </a:lnTo>
                  <a:cubicBezTo>
                    <a:pt x="4085" y="2201"/>
                    <a:pt x="4087" y="2200"/>
                    <a:pt x="4088" y="2199"/>
                  </a:cubicBezTo>
                  <a:lnTo>
                    <a:pt x="4137" y="2173"/>
                  </a:lnTo>
                  <a:lnTo>
                    <a:pt x="4184" y="2149"/>
                  </a:lnTo>
                  <a:lnTo>
                    <a:pt x="4231" y="2125"/>
                  </a:lnTo>
                  <a:lnTo>
                    <a:pt x="4275" y="2101"/>
                  </a:lnTo>
                  <a:lnTo>
                    <a:pt x="4322" y="2066"/>
                  </a:lnTo>
                  <a:lnTo>
                    <a:pt x="4372" y="2029"/>
                  </a:lnTo>
                  <a:lnTo>
                    <a:pt x="4467" y="1970"/>
                  </a:lnTo>
                  <a:lnTo>
                    <a:pt x="4561" y="1916"/>
                  </a:lnTo>
                  <a:lnTo>
                    <a:pt x="4656" y="1861"/>
                  </a:lnTo>
                  <a:lnTo>
                    <a:pt x="4750" y="1802"/>
                  </a:lnTo>
                  <a:cubicBezTo>
                    <a:pt x="4761" y="1795"/>
                    <a:pt x="4776" y="1798"/>
                    <a:pt x="4783" y="1810"/>
                  </a:cubicBezTo>
                  <a:cubicBezTo>
                    <a:pt x="4790" y="1821"/>
                    <a:pt x="4786" y="1836"/>
                    <a:pt x="4775" y="1843"/>
                  </a:cubicBezTo>
                  <a:close/>
                </a:path>
              </a:pathLst>
            </a:custGeom>
            <a:solidFill>
              <a:srgbClr val="BE4B48"/>
            </a:solidFill>
            <a:ln w="9525" cap="flat">
              <a:solidFill>
                <a:srgbClr val="BE4B48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980" name="Freeform 12"/>
            <p:cNvSpPr>
              <a:spLocks/>
            </p:cNvSpPr>
            <p:nvPr/>
          </p:nvSpPr>
          <p:spPr bwMode="auto">
            <a:xfrm>
              <a:off x="3354" y="1185"/>
              <a:ext cx="1808" cy="1098"/>
            </a:xfrm>
            <a:custGeom>
              <a:avLst/>
              <a:gdLst/>
              <a:ahLst/>
              <a:cxnLst>
                <a:cxn ang="0">
                  <a:pos x="4624" y="1868"/>
                </a:cxn>
                <a:cxn ang="0">
                  <a:pos x="4485" y="1897"/>
                </a:cxn>
                <a:cxn ang="0">
                  <a:pos x="4303" y="2004"/>
                </a:cxn>
                <a:cxn ang="0">
                  <a:pos x="4207" y="2086"/>
                </a:cxn>
                <a:cxn ang="0">
                  <a:pos x="4019" y="2205"/>
                </a:cxn>
                <a:cxn ang="0">
                  <a:pos x="3736" y="2431"/>
                </a:cxn>
                <a:cxn ang="0">
                  <a:pos x="3450" y="2631"/>
                </a:cxn>
                <a:cxn ang="0">
                  <a:pos x="3306" y="2716"/>
                </a:cxn>
                <a:cxn ang="0">
                  <a:pos x="3164" y="2791"/>
                </a:cxn>
                <a:cxn ang="0">
                  <a:pos x="2922" y="2885"/>
                </a:cxn>
                <a:cxn ang="0">
                  <a:pos x="2776" y="2907"/>
                </a:cxn>
                <a:cxn ang="0">
                  <a:pos x="2584" y="2903"/>
                </a:cxn>
                <a:cxn ang="0">
                  <a:pos x="2300" y="2896"/>
                </a:cxn>
                <a:cxn ang="0">
                  <a:pos x="2015" y="2884"/>
                </a:cxn>
                <a:cxn ang="0">
                  <a:pos x="1824" y="2870"/>
                </a:cxn>
                <a:cxn ang="0">
                  <a:pos x="1767" y="2848"/>
                </a:cxn>
                <a:cxn ang="0">
                  <a:pos x="1621" y="2742"/>
                </a:cxn>
                <a:cxn ang="0">
                  <a:pos x="1475" y="2549"/>
                </a:cxn>
                <a:cxn ang="0">
                  <a:pos x="1284" y="2195"/>
                </a:cxn>
                <a:cxn ang="0">
                  <a:pos x="1094" y="1757"/>
                </a:cxn>
                <a:cxn ang="0">
                  <a:pos x="952" y="1348"/>
                </a:cxn>
                <a:cxn ang="0">
                  <a:pos x="857" y="1041"/>
                </a:cxn>
                <a:cxn ang="0">
                  <a:pos x="715" y="631"/>
                </a:cxn>
                <a:cxn ang="0">
                  <a:pos x="621" y="405"/>
                </a:cxn>
                <a:cxn ang="0">
                  <a:pos x="481" y="178"/>
                </a:cxn>
                <a:cxn ang="0">
                  <a:pos x="389" y="81"/>
                </a:cxn>
                <a:cxn ang="0">
                  <a:pos x="353" y="62"/>
                </a:cxn>
                <a:cxn ang="0">
                  <a:pos x="262" y="48"/>
                </a:cxn>
                <a:cxn ang="0">
                  <a:pos x="225" y="55"/>
                </a:cxn>
                <a:cxn ang="0">
                  <a:pos x="137" y="97"/>
                </a:cxn>
                <a:cxn ang="0">
                  <a:pos x="9" y="175"/>
                </a:cxn>
                <a:cxn ang="0">
                  <a:pos x="106" y="60"/>
                </a:cxn>
                <a:cxn ang="0">
                  <a:pos x="207" y="10"/>
                </a:cxn>
                <a:cxn ang="0">
                  <a:pos x="265" y="1"/>
                </a:cxn>
                <a:cxn ang="0">
                  <a:pos x="364" y="15"/>
                </a:cxn>
                <a:cxn ang="0">
                  <a:pos x="421" y="46"/>
                </a:cxn>
                <a:cxn ang="0">
                  <a:pos x="520" y="149"/>
                </a:cxn>
                <a:cxn ang="0">
                  <a:pos x="664" y="384"/>
                </a:cxn>
                <a:cxn ang="0">
                  <a:pos x="760" y="616"/>
                </a:cxn>
                <a:cxn ang="0">
                  <a:pos x="902" y="1026"/>
                </a:cxn>
                <a:cxn ang="0">
                  <a:pos x="997" y="1333"/>
                </a:cxn>
                <a:cxn ang="0">
                  <a:pos x="1139" y="1738"/>
                </a:cxn>
                <a:cxn ang="0">
                  <a:pos x="1327" y="2174"/>
                </a:cxn>
                <a:cxn ang="0">
                  <a:pos x="1516" y="2523"/>
                </a:cxn>
                <a:cxn ang="0">
                  <a:pos x="1653" y="2707"/>
                </a:cxn>
                <a:cxn ang="0">
                  <a:pos x="1792" y="2807"/>
                </a:cxn>
                <a:cxn ang="0">
                  <a:pos x="1829" y="2823"/>
                </a:cxn>
                <a:cxn ang="0">
                  <a:pos x="2017" y="2836"/>
                </a:cxn>
                <a:cxn ang="0">
                  <a:pos x="2301" y="2848"/>
                </a:cxn>
                <a:cxn ang="0">
                  <a:pos x="2585" y="2855"/>
                </a:cxn>
                <a:cxn ang="0">
                  <a:pos x="2770" y="2860"/>
                </a:cxn>
                <a:cxn ang="0">
                  <a:pos x="2911" y="2838"/>
                </a:cxn>
                <a:cxn ang="0">
                  <a:pos x="3141" y="2750"/>
                </a:cxn>
                <a:cxn ang="0">
                  <a:pos x="3285" y="2673"/>
                </a:cxn>
                <a:cxn ang="0">
                  <a:pos x="3423" y="2591"/>
                </a:cxn>
                <a:cxn ang="0">
                  <a:pos x="3707" y="2394"/>
                </a:cxn>
                <a:cxn ang="0">
                  <a:pos x="3992" y="2166"/>
                </a:cxn>
                <a:cxn ang="0">
                  <a:pos x="4182" y="2045"/>
                </a:cxn>
                <a:cxn ang="0">
                  <a:pos x="4276" y="1965"/>
                </a:cxn>
                <a:cxn ang="0">
                  <a:pos x="4472" y="1850"/>
                </a:cxn>
                <a:cxn ang="0">
                  <a:pos x="4619" y="1821"/>
                </a:cxn>
                <a:cxn ang="0">
                  <a:pos x="4786" y="1814"/>
                </a:cxn>
              </a:cxnLst>
              <a:rect l="0" t="0" r="r" b="b"/>
              <a:pathLst>
                <a:path w="4789" h="2907">
                  <a:moveTo>
                    <a:pt x="4767" y="1843"/>
                  </a:moveTo>
                  <a:lnTo>
                    <a:pt x="4673" y="1863"/>
                  </a:lnTo>
                  <a:lnTo>
                    <a:pt x="4624" y="1868"/>
                  </a:lnTo>
                  <a:lnTo>
                    <a:pt x="4576" y="1873"/>
                  </a:lnTo>
                  <a:lnTo>
                    <a:pt x="4531" y="1883"/>
                  </a:lnTo>
                  <a:lnTo>
                    <a:pt x="4485" y="1897"/>
                  </a:lnTo>
                  <a:lnTo>
                    <a:pt x="4441" y="1916"/>
                  </a:lnTo>
                  <a:lnTo>
                    <a:pt x="4396" y="1940"/>
                  </a:lnTo>
                  <a:lnTo>
                    <a:pt x="4303" y="2004"/>
                  </a:lnTo>
                  <a:lnTo>
                    <a:pt x="4258" y="2044"/>
                  </a:lnTo>
                  <a:lnTo>
                    <a:pt x="4210" y="2084"/>
                  </a:lnTo>
                  <a:cubicBezTo>
                    <a:pt x="4209" y="2085"/>
                    <a:pt x="4208" y="2085"/>
                    <a:pt x="4207" y="2086"/>
                  </a:cubicBezTo>
                  <a:lnTo>
                    <a:pt x="4160" y="2114"/>
                  </a:lnTo>
                  <a:lnTo>
                    <a:pt x="4111" y="2141"/>
                  </a:lnTo>
                  <a:lnTo>
                    <a:pt x="4019" y="2205"/>
                  </a:lnTo>
                  <a:lnTo>
                    <a:pt x="3925" y="2279"/>
                  </a:lnTo>
                  <a:lnTo>
                    <a:pt x="3831" y="2358"/>
                  </a:lnTo>
                  <a:lnTo>
                    <a:pt x="3736" y="2431"/>
                  </a:lnTo>
                  <a:lnTo>
                    <a:pt x="3641" y="2503"/>
                  </a:lnTo>
                  <a:lnTo>
                    <a:pt x="3545" y="2568"/>
                  </a:lnTo>
                  <a:lnTo>
                    <a:pt x="3450" y="2631"/>
                  </a:lnTo>
                  <a:lnTo>
                    <a:pt x="3403" y="2663"/>
                  </a:lnTo>
                  <a:lnTo>
                    <a:pt x="3355" y="2693"/>
                  </a:lnTo>
                  <a:lnTo>
                    <a:pt x="3306" y="2716"/>
                  </a:lnTo>
                  <a:lnTo>
                    <a:pt x="3257" y="2738"/>
                  </a:lnTo>
                  <a:lnTo>
                    <a:pt x="3212" y="2764"/>
                  </a:lnTo>
                  <a:lnTo>
                    <a:pt x="3164" y="2791"/>
                  </a:lnTo>
                  <a:lnTo>
                    <a:pt x="3069" y="2838"/>
                  </a:lnTo>
                  <a:lnTo>
                    <a:pt x="2972" y="2873"/>
                  </a:lnTo>
                  <a:lnTo>
                    <a:pt x="2922" y="2885"/>
                  </a:lnTo>
                  <a:lnTo>
                    <a:pt x="2872" y="2892"/>
                  </a:lnTo>
                  <a:lnTo>
                    <a:pt x="2826" y="2901"/>
                  </a:lnTo>
                  <a:lnTo>
                    <a:pt x="2776" y="2907"/>
                  </a:lnTo>
                  <a:lnTo>
                    <a:pt x="2726" y="2907"/>
                  </a:lnTo>
                  <a:lnTo>
                    <a:pt x="2678" y="2905"/>
                  </a:lnTo>
                  <a:lnTo>
                    <a:pt x="2584" y="2903"/>
                  </a:lnTo>
                  <a:lnTo>
                    <a:pt x="2489" y="2900"/>
                  </a:lnTo>
                  <a:lnTo>
                    <a:pt x="2394" y="2898"/>
                  </a:lnTo>
                  <a:lnTo>
                    <a:pt x="2300" y="2896"/>
                  </a:lnTo>
                  <a:lnTo>
                    <a:pt x="2205" y="2893"/>
                  </a:lnTo>
                  <a:lnTo>
                    <a:pt x="2109" y="2888"/>
                  </a:lnTo>
                  <a:lnTo>
                    <a:pt x="2015" y="2884"/>
                  </a:lnTo>
                  <a:lnTo>
                    <a:pt x="1919" y="2875"/>
                  </a:lnTo>
                  <a:lnTo>
                    <a:pt x="1874" y="2875"/>
                  </a:lnTo>
                  <a:lnTo>
                    <a:pt x="1824" y="2870"/>
                  </a:lnTo>
                  <a:cubicBezTo>
                    <a:pt x="1822" y="2870"/>
                    <a:pt x="1820" y="2870"/>
                    <a:pt x="1817" y="2869"/>
                  </a:cubicBezTo>
                  <a:lnTo>
                    <a:pt x="1770" y="2850"/>
                  </a:lnTo>
                  <a:cubicBezTo>
                    <a:pt x="1769" y="2849"/>
                    <a:pt x="1768" y="2849"/>
                    <a:pt x="1767" y="2848"/>
                  </a:cubicBezTo>
                  <a:lnTo>
                    <a:pt x="1719" y="2820"/>
                  </a:lnTo>
                  <a:lnTo>
                    <a:pt x="1671" y="2786"/>
                  </a:lnTo>
                  <a:lnTo>
                    <a:pt x="1621" y="2742"/>
                  </a:lnTo>
                  <a:lnTo>
                    <a:pt x="1573" y="2687"/>
                  </a:lnTo>
                  <a:lnTo>
                    <a:pt x="1523" y="2624"/>
                  </a:lnTo>
                  <a:lnTo>
                    <a:pt x="1475" y="2549"/>
                  </a:lnTo>
                  <a:lnTo>
                    <a:pt x="1427" y="2470"/>
                  </a:lnTo>
                  <a:lnTo>
                    <a:pt x="1332" y="2294"/>
                  </a:lnTo>
                  <a:lnTo>
                    <a:pt x="1284" y="2195"/>
                  </a:lnTo>
                  <a:lnTo>
                    <a:pt x="1237" y="2091"/>
                  </a:lnTo>
                  <a:lnTo>
                    <a:pt x="1141" y="1872"/>
                  </a:lnTo>
                  <a:lnTo>
                    <a:pt x="1094" y="1757"/>
                  </a:lnTo>
                  <a:lnTo>
                    <a:pt x="1046" y="1633"/>
                  </a:lnTo>
                  <a:lnTo>
                    <a:pt x="999" y="1495"/>
                  </a:lnTo>
                  <a:lnTo>
                    <a:pt x="952" y="1348"/>
                  </a:lnTo>
                  <a:lnTo>
                    <a:pt x="905" y="1193"/>
                  </a:lnTo>
                  <a:lnTo>
                    <a:pt x="881" y="1116"/>
                  </a:lnTo>
                  <a:lnTo>
                    <a:pt x="857" y="1041"/>
                  </a:lnTo>
                  <a:lnTo>
                    <a:pt x="810" y="901"/>
                  </a:lnTo>
                  <a:lnTo>
                    <a:pt x="762" y="768"/>
                  </a:lnTo>
                  <a:lnTo>
                    <a:pt x="715" y="631"/>
                  </a:lnTo>
                  <a:lnTo>
                    <a:pt x="691" y="566"/>
                  </a:lnTo>
                  <a:lnTo>
                    <a:pt x="668" y="505"/>
                  </a:lnTo>
                  <a:lnTo>
                    <a:pt x="621" y="405"/>
                  </a:lnTo>
                  <a:lnTo>
                    <a:pt x="574" y="318"/>
                  </a:lnTo>
                  <a:lnTo>
                    <a:pt x="528" y="242"/>
                  </a:lnTo>
                  <a:lnTo>
                    <a:pt x="481" y="178"/>
                  </a:lnTo>
                  <a:lnTo>
                    <a:pt x="435" y="122"/>
                  </a:lnTo>
                  <a:lnTo>
                    <a:pt x="437" y="124"/>
                  </a:lnTo>
                  <a:lnTo>
                    <a:pt x="389" y="81"/>
                  </a:lnTo>
                  <a:lnTo>
                    <a:pt x="394" y="85"/>
                  </a:lnTo>
                  <a:lnTo>
                    <a:pt x="347" y="60"/>
                  </a:lnTo>
                  <a:lnTo>
                    <a:pt x="353" y="62"/>
                  </a:lnTo>
                  <a:lnTo>
                    <a:pt x="306" y="51"/>
                  </a:lnTo>
                  <a:lnTo>
                    <a:pt x="310" y="51"/>
                  </a:lnTo>
                  <a:lnTo>
                    <a:pt x="262" y="48"/>
                  </a:lnTo>
                  <a:lnTo>
                    <a:pt x="267" y="48"/>
                  </a:lnTo>
                  <a:lnTo>
                    <a:pt x="220" y="56"/>
                  </a:lnTo>
                  <a:lnTo>
                    <a:pt x="225" y="55"/>
                  </a:lnTo>
                  <a:lnTo>
                    <a:pt x="178" y="74"/>
                  </a:lnTo>
                  <a:lnTo>
                    <a:pt x="133" y="99"/>
                  </a:lnTo>
                  <a:lnTo>
                    <a:pt x="137" y="97"/>
                  </a:lnTo>
                  <a:lnTo>
                    <a:pt x="90" y="135"/>
                  </a:lnTo>
                  <a:lnTo>
                    <a:pt x="42" y="177"/>
                  </a:lnTo>
                  <a:cubicBezTo>
                    <a:pt x="33" y="186"/>
                    <a:pt x="17" y="185"/>
                    <a:pt x="9" y="175"/>
                  </a:cubicBezTo>
                  <a:cubicBezTo>
                    <a:pt x="0" y="166"/>
                    <a:pt x="1" y="150"/>
                    <a:pt x="10" y="142"/>
                  </a:cubicBezTo>
                  <a:lnTo>
                    <a:pt x="59" y="98"/>
                  </a:lnTo>
                  <a:lnTo>
                    <a:pt x="106" y="60"/>
                  </a:lnTo>
                  <a:cubicBezTo>
                    <a:pt x="107" y="59"/>
                    <a:pt x="109" y="58"/>
                    <a:pt x="110" y="58"/>
                  </a:cubicBezTo>
                  <a:lnTo>
                    <a:pt x="160" y="29"/>
                  </a:lnTo>
                  <a:lnTo>
                    <a:pt x="207" y="10"/>
                  </a:lnTo>
                  <a:cubicBezTo>
                    <a:pt x="209" y="10"/>
                    <a:pt x="211" y="9"/>
                    <a:pt x="212" y="9"/>
                  </a:cubicBezTo>
                  <a:lnTo>
                    <a:pt x="259" y="1"/>
                  </a:lnTo>
                  <a:cubicBezTo>
                    <a:pt x="261" y="0"/>
                    <a:pt x="263" y="0"/>
                    <a:pt x="265" y="1"/>
                  </a:cubicBezTo>
                  <a:lnTo>
                    <a:pt x="313" y="4"/>
                  </a:lnTo>
                  <a:cubicBezTo>
                    <a:pt x="314" y="4"/>
                    <a:pt x="316" y="4"/>
                    <a:pt x="317" y="4"/>
                  </a:cubicBezTo>
                  <a:lnTo>
                    <a:pt x="364" y="15"/>
                  </a:lnTo>
                  <a:cubicBezTo>
                    <a:pt x="366" y="16"/>
                    <a:pt x="368" y="16"/>
                    <a:pt x="370" y="17"/>
                  </a:cubicBezTo>
                  <a:lnTo>
                    <a:pt x="417" y="42"/>
                  </a:lnTo>
                  <a:cubicBezTo>
                    <a:pt x="418" y="43"/>
                    <a:pt x="420" y="44"/>
                    <a:pt x="421" y="46"/>
                  </a:cubicBezTo>
                  <a:lnTo>
                    <a:pt x="469" y="89"/>
                  </a:lnTo>
                  <a:cubicBezTo>
                    <a:pt x="470" y="89"/>
                    <a:pt x="471" y="90"/>
                    <a:pt x="472" y="91"/>
                  </a:cubicBezTo>
                  <a:lnTo>
                    <a:pt x="520" y="149"/>
                  </a:lnTo>
                  <a:lnTo>
                    <a:pt x="569" y="217"/>
                  </a:lnTo>
                  <a:lnTo>
                    <a:pt x="617" y="295"/>
                  </a:lnTo>
                  <a:lnTo>
                    <a:pt x="664" y="384"/>
                  </a:lnTo>
                  <a:lnTo>
                    <a:pt x="713" y="488"/>
                  </a:lnTo>
                  <a:lnTo>
                    <a:pt x="736" y="549"/>
                  </a:lnTo>
                  <a:lnTo>
                    <a:pt x="760" y="616"/>
                  </a:lnTo>
                  <a:lnTo>
                    <a:pt x="807" y="751"/>
                  </a:lnTo>
                  <a:lnTo>
                    <a:pt x="855" y="886"/>
                  </a:lnTo>
                  <a:lnTo>
                    <a:pt x="902" y="1026"/>
                  </a:lnTo>
                  <a:lnTo>
                    <a:pt x="926" y="1101"/>
                  </a:lnTo>
                  <a:lnTo>
                    <a:pt x="950" y="1179"/>
                  </a:lnTo>
                  <a:lnTo>
                    <a:pt x="997" y="1333"/>
                  </a:lnTo>
                  <a:lnTo>
                    <a:pt x="1044" y="1480"/>
                  </a:lnTo>
                  <a:lnTo>
                    <a:pt x="1091" y="1616"/>
                  </a:lnTo>
                  <a:lnTo>
                    <a:pt x="1139" y="1738"/>
                  </a:lnTo>
                  <a:lnTo>
                    <a:pt x="1185" y="1853"/>
                  </a:lnTo>
                  <a:lnTo>
                    <a:pt x="1280" y="2072"/>
                  </a:lnTo>
                  <a:lnTo>
                    <a:pt x="1327" y="2174"/>
                  </a:lnTo>
                  <a:lnTo>
                    <a:pt x="1375" y="2271"/>
                  </a:lnTo>
                  <a:lnTo>
                    <a:pt x="1468" y="2445"/>
                  </a:lnTo>
                  <a:lnTo>
                    <a:pt x="1516" y="2523"/>
                  </a:lnTo>
                  <a:lnTo>
                    <a:pt x="1561" y="2595"/>
                  </a:lnTo>
                  <a:lnTo>
                    <a:pt x="1608" y="2656"/>
                  </a:lnTo>
                  <a:lnTo>
                    <a:pt x="1653" y="2707"/>
                  </a:lnTo>
                  <a:lnTo>
                    <a:pt x="1698" y="2747"/>
                  </a:lnTo>
                  <a:lnTo>
                    <a:pt x="1744" y="2779"/>
                  </a:lnTo>
                  <a:lnTo>
                    <a:pt x="1792" y="2807"/>
                  </a:lnTo>
                  <a:lnTo>
                    <a:pt x="1788" y="2805"/>
                  </a:lnTo>
                  <a:lnTo>
                    <a:pt x="1835" y="2824"/>
                  </a:lnTo>
                  <a:lnTo>
                    <a:pt x="1829" y="2823"/>
                  </a:lnTo>
                  <a:lnTo>
                    <a:pt x="1874" y="2827"/>
                  </a:lnTo>
                  <a:lnTo>
                    <a:pt x="1924" y="2828"/>
                  </a:lnTo>
                  <a:lnTo>
                    <a:pt x="2017" y="2836"/>
                  </a:lnTo>
                  <a:lnTo>
                    <a:pt x="2112" y="2841"/>
                  </a:lnTo>
                  <a:lnTo>
                    <a:pt x="2206" y="2845"/>
                  </a:lnTo>
                  <a:lnTo>
                    <a:pt x="2301" y="2848"/>
                  </a:lnTo>
                  <a:lnTo>
                    <a:pt x="2395" y="2850"/>
                  </a:lnTo>
                  <a:lnTo>
                    <a:pt x="2490" y="2852"/>
                  </a:lnTo>
                  <a:lnTo>
                    <a:pt x="2585" y="2855"/>
                  </a:lnTo>
                  <a:lnTo>
                    <a:pt x="2680" y="2857"/>
                  </a:lnTo>
                  <a:lnTo>
                    <a:pt x="2726" y="2859"/>
                  </a:lnTo>
                  <a:lnTo>
                    <a:pt x="2770" y="2860"/>
                  </a:lnTo>
                  <a:lnTo>
                    <a:pt x="2817" y="2854"/>
                  </a:lnTo>
                  <a:lnTo>
                    <a:pt x="2865" y="2845"/>
                  </a:lnTo>
                  <a:lnTo>
                    <a:pt x="2911" y="2838"/>
                  </a:lnTo>
                  <a:lnTo>
                    <a:pt x="2955" y="2828"/>
                  </a:lnTo>
                  <a:lnTo>
                    <a:pt x="3048" y="2795"/>
                  </a:lnTo>
                  <a:lnTo>
                    <a:pt x="3141" y="2750"/>
                  </a:lnTo>
                  <a:lnTo>
                    <a:pt x="3189" y="2723"/>
                  </a:lnTo>
                  <a:lnTo>
                    <a:pt x="3237" y="2695"/>
                  </a:lnTo>
                  <a:lnTo>
                    <a:pt x="3285" y="2673"/>
                  </a:lnTo>
                  <a:lnTo>
                    <a:pt x="3330" y="2652"/>
                  </a:lnTo>
                  <a:lnTo>
                    <a:pt x="3376" y="2624"/>
                  </a:lnTo>
                  <a:lnTo>
                    <a:pt x="3423" y="2591"/>
                  </a:lnTo>
                  <a:lnTo>
                    <a:pt x="3518" y="2529"/>
                  </a:lnTo>
                  <a:lnTo>
                    <a:pt x="3612" y="2464"/>
                  </a:lnTo>
                  <a:lnTo>
                    <a:pt x="3707" y="2394"/>
                  </a:lnTo>
                  <a:lnTo>
                    <a:pt x="3800" y="2321"/>
                  </a:lnTo>
                  <a:lnTo>
                    <a:pt x="3896" y="2242"/>
                  </a:lnTo>
                  <a:lnTo>
                    <a:pt x="3992" y="2166"/>
                  </a:lnTo>
                  <a:lnTo>
                    <a:pt x="4088" y="2098"/>
                  </a:lnTo>
                  <a:lnTo>
                    <a:pt x="4135" y="2073"/>
                  </a:lnTo>
                  <a:lnTo>
                    <a:pt x="4182" y="2045"/>
                  </a:lnTo>
                  <a:lnTo>
                    <a:pt x="4179" y="2047"/>
                  </a:lnTo>
                  <a:lnTo>
                    <a:pt x="4227" y="2007"/>
                  </a:lnTo>
                  <a:lnTo>
                    <a:pt x="4276" y="1965"/>
                  </a:lnTo>
                  <a:lnTo>
                    <a:pt x="4373" y="1898"/>
                  </a:lnTo>
                  <a:lnTo>
                    <a:pt x="4422" y="1871"/>
                  </a:lnTo>
                  <a:lnTo>
                    <a:pt x="4472" y="1850"/>
                  </a:lnTo>
                  <a:lnTo>
                    <a:pt x="4521" y="1836"/>
                  </a:lnTo>
                  <a:lnTo>
                    <a:pt x="4571" y="1826"/>
                  </a:lnTo>
                  <a:lnTo>
                    <a:pt x="4619" y="1821"/>
                  </a:lnTo>
                  <a:lnTo>
                    <a:pt x="4663" y="1816"/>
                  </a:lnTo>
                  <a:lnTo>
                    <a:pt x="4757" y="1796"/>
                  </a:lnTo>
                  <a:cubicBezTo>
                    <a:pt x="4770" y="1793"/>
                    <a:pt x="4783" y="1802"/>
                    <a:pt x="4786" y="1814"/>
                  </a:cubicBezTo>
                  <a:cubicBezTo>
                    <a:pt x="4789" y="1827"/>
                    <a:pt x="4780" y="1840"/>
                    <a:pt x="4767" y="1843"/>
                  </a:cubicBezTo>
                  <a:close/>
                </a:path>
              </a:pathLst>
            </a:custGeom>
            <a:solidFill>
              <a:srgbClr val="98B954"/>
            </a:solidFill>
            <a:ln w="9525" cap="flat">
              <a:solidFill>
                <a:srgbClr val="98B954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981" name="Rectangle 13"/>
            <p:cNvSpPr>
              <a:spLocks noChangeArrowheads="1"/>
            </p:cNvSpPr>
            <p:nvPr/>
          </p:nvSpPr>
          <p:spPr bwMode="auto">
            <a:xfrm>
              <a:off x="3191" y="2386"/>
              <a:ext cx="35" cy="1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kumimoji="0" 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982" name="Rectangle 14"/>
            <p:cNvSpPr>
              <a:spLocks noChangeArrowheads="1"/>
            </p:cNvSpPr>
            <p:nvPr/>
          </p:nvSpPr>
          <p:spPr bwMode="auto">
            <a:xfrm>
              <a:off x="3221" y="2386"/>
              <a:ext cx="63" cy="1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itchFamily="34" charset="0"/>
                </a:rPr>
                <a:t>4</a:t>
              </a:r>
              <a:endParaRPr kumimoji="0" lang="en-US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983" name="Rectangle 15"/>
            <p:cNvSpPr>
              <a:spLocks noChangeArrowheads="1"/>
            </p:cNvSpPr>
            <p:nvPr/>
          </p:nvSpPr>
          <p:spPr bwMode="auto">
            <a:xfrm>
              <a:off x="3191" y="2069"/>
              <a:ext cx="35" cy="1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3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kumimoji="0" 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984" name="Rectangle 16"/>
            <p:cNvSpPr>
              <a:spLocks noChangeArrowheads="1"/>
            </p:cNvSpPr>
            <p:nvPr/>
          </p:nvSpPr>
          <p:spPr bwMode="auto">
            <a:xfrm>
              <a:off x="3221" y="2069"/>
              <a:ext cx="63" cy="1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itchFamily="34" charset="0"/>
                </a:rPr>
                <a:t>2</a:t>
              </a:r>
              <a:endParaRPr kumimoji="0" lang="en-US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985" name="Rectangle 17"/>
            <p:cNvSpPr>
              <a:spLocks noChangeArrowheads="1"/>
            </p:cNvSpPr>
            <p:nvPr/>
          </p:nvSpPr>
          <p:spPr bwMode="auto">
            <a:xfrm>
              <a:off x="3218" y="1752"/>
              <a:ext cx="63" cy="1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itchFamily="34" charset="0"/>
                </a:rPr>
                <a:t>0</a:t>
              </a:r>
              <a:endParaRPr kumimoji="0" lang="en-US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986" name="Rectangle 18"/>
            <p:cNvSpPr>
              <a:spLocks noChangeArrowheads="1"/>
            </p:cNvSpPr>
            <p:nvPr/>
          </p:nvSpPr>
          <p:spPr bwMode="auto">
            <a:xfrm>
              <a:off x="3218" y="1435"/>
              <a:ext cx="63" cy="1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itchFamily="34" charset="0"/>
                </a:rPr>
                <a:t>2</a:t>
              </a:r>
              <a:endParaRPr kumimoji="0" lang="en-US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987" name="Rectangle 19"/>
            <p:cNvSpPr>
              <a:spLocks noChangeArrowheads="1"/>
            </p:cNvSpPr>
            <p:nvPr/>
          </p:nvSpPr>
          <p:spPr bwMode="auto">
            <a:xfrm>
              <a:off x="3218" y="1118"/>
              <a:ext cx="63" cy="1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itchFamily="34" charset="0"/>
                </a:rPr>
                <a:t>4</a:t>
              </a:r>
              <a:endParaRPr kumimoji="0" lang="en-US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988" name="Rectangle 20"/>
            <p:cNvSpPr>
              <a:spLocks noChangeArrowheads="1"/>
            </p:cNvSpPr>
            <p:nvPr/>
          </p:nvSpPr>
          <p:spPr bwMode="auto">
            <a:xfrm>
              <a:off x="3218" y="801"/>
              <a:ext cx="63" cy="1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itchFamily="34" charset="0"/>
                </a:rPr>
                <a:t>6</a:t>
              </a:r>
              <a:endParaRPr kumimoji="0" lang="en-US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989" name="Rectangle 21"/>
            <p:cNvSpPr>
              <a:spLocks noChangeArrowheads="1"/>
            </p:cNvSpPr>
            <p:nvPr/>
          </p:nvSpPr>
          <p:spPr bwMode="auto">
            <a:xfrm>
              <a:off x="3283" y="2517"/>
              <a:ext cx="188" cy="1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itchFamily="34" charset="0"/>
                </a:rPr>
                <a:t>190</a:t>
              </a:r>
              <a:endParaRPr kumimoji="0" lang="en-US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990" name="Rectangle 22"/>
            <p:cNvSpPr>
              <a:spLocks noChangeArrowheads="1"/>
            </p:cNvSpPr>
            <p:nvPr/>
          </p:nvSpPr>
          <p:spPr bwMode="auto">
            <a:xfrm>
              <a:off x="3640" y="2517"/>
              <a:ext cx="188" cy="1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itchFamily="34" charset="0"/>
                </a:rPr>
                <a:t>200</a:t>
              </a:r>
              <a:endParaRPr kumimoji="0" lang="en-US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991" name="Rectangle 23"/>
            <p:cNvSpPr>
              <a:spLocks noChangeArrowheads="1"/>
            </p:cNvSpPr>
            <p:nvPr/>
          </p:nvSpPr>
          <p:spPr bwMode="auto">
            <a:xfrm>
              <a:off x="3998" y="2517"/>
              <a:ext cx="188" cy="1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itchFamily="34" charset="0"/>
                </a:rPr>
                <a:t>210</a:t>
              </a:r>
              <a:endParaRPr kumimoji="0" lang="en-US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992" name="Rectangle 24"/>
            <p:cNvSpPr>
              <a:spLocks noChangeArrowheads="1"/>
            </p:cNvSpPr>
            <p:nvPr/>
          </p:nvSpPr>
          <p:spPr bwMode="auto">
            <a:xfrm>
              <a:off x="4355" y="2517"/>
              <a:ext cx="188" cy="1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itchFamily="34" charset="0"/>
                </a:rPr>
                <a:t>220</a:t>
              </a:r>
              <a:endParaRPr kumimoji="0" lang="en-US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993" name="Rectangle 25"/>
            <p:cNvSpPr>
              <a:spLocks noChangeArrowheads="1"/>
            </p:cNvSpPr>
            <p:nvPr/>
          </p:nvSpPr>
          <p:spPr bwMode="auto">
            <a:xfrm>
              <a:off x="4712" y="2517"/>
              <a:ext cx="188" cy="1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itchFamily="34" charset="0"/>
                </a:rPr>
                <a:t>230</a:t>
              </a:r>
              <a:endParaRPr kumimoji="0" lang="en-US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994" name="Rectangle 26"/>
            <p:cNvSpPr>
              <a:spLocks noChangeArrowheads="1"/>
            </p:cNvSpPr>
            <p:nvPr/>
          </p:nvSpPr>
          <p:spPr bwMode="auto">
            <a:xfrm>
              <a:off x="5070" y="2517"/>
              <a:ext cx="188" cy="1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itchFamily="34" charset="0"/>
                </a:rPr>
                <a:t>240</a:t>
              </a:r>
              <a:endParaRPr kumimoji="0" lang="en-US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cxnSp>
        <p:nvCxnSpPr>
          <p:cNvPr id="9" name="Straight Connector 8"/>
          <p:cNvCxnSpPr/>
          <p:nvPr/>
        </p:nvCxnSpPr>
        <p:spPr>
          <a:xfrm flipV="1">
            <a:off x="5454648" y="2900975"/>
            <a:ext cx="2829592" cy="14076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" name="Picture 2"/>
          <p:cNvPicPr>
            <a:picLocks noChangeAspect="1" noChangeArrowheads="1"/>
          </p:cNvPicPr>
          <p:nvPr/>
        </p:nvPicPr>
        <p:blipFill>
          <a:blip r:embed="rId3" cstate="print">
            <a:lum bright="12000" contrast="-54000"/>
            <a:grayscl/>
          </a:blip>
          <a:srcRect r="20348" b="-1401"/>
          <a:stretch>
            <a:fillRect/>
          </a:stretch>
        </p:blipFill>
        <p:spPr bwMode="auto">
          <a:xfrm>
            <a:off x="999831" y="1883069"/>
            <a:ext cx="1467097" cy="248714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2" name="Text Box 65"/>
          <p:cNvSpPr txBox="1">
            <a:spLocks noChangeArrowheads="1"/>
          </p:cNvSpPr>
          <p:nvPr/>
        </p:nvSpPr>
        <p:spPr bwMode="auto">
          <a:xfrm rot="19440000">
            <a:off x="1157090" y="1605596"/>
            <a:ext cx="278923" cy="2211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0" tIns="0" rIns="0" bIns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itchFamily="34" charset="0"/>
              </a:rPr>
              <a:t>WT</a:t>
            </a:r>
          </a:p>
        </p:txBody>
      </p:sp>
      <p:sp>
        <p:nvSpPr>
          <p:cNvPr id="13" name="Text Box 66"/>
          <p:cNvSpPr txBox="1">
            <a:spLocks noChangeArrowheads="1"/>
          </p:cNvSpPr>
          <p:nvPr/>
        </p:nvSpPr>
        <p:spPr bwMode="auto">
          <a:xfrm rot="19440000">
            <a:off x="2011547" y="1386059"/>
            <a:ext cx="1155766" cy="2211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0" tIns="0" rIns="0" bIns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itchFamily="34" charset="0"/>
              </a:rPr>
              <a:t>C615S/H616R</a:t>
            </a:r>
          </a:p>
        </p:txBody>
      </p:sp>
      <p:sp>
        <p:nvSpPr>
          <p:cNvPr id="14" name="Text Box 68"/>
          <p:cNvSpPr txBox="1">
            <a:spLocks noChangeArrowheads="1"/>
          </p:cNvSpPr>
          <p:nvPr/>
        </p:nvSpPr>
        <p:spPr bwMode="auto">
          <a:xfrm rot="19440000">
            <a:off x="1684104" y="1638575"/>
            <a:ext cx="149080" cy="2211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0" tIns="0" rIns="0" bIns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itchFamily="34" charset="0"/>
              </a:rPr>
              <a:t>M</a:t>
            </a:r>
          </a:p>
        </p:txBody>
      </p:sp>
      <p:sp>
        <p:nvSpPr>
          <p:cNvPr id="22" name="Text Box 61"/>
          <p:cNvSpPr txBox="1">
            <a:spLocks noChangeArrowheads="1"/>
          </p:cNvSpPr>
          <p:nvPr/>
        </p:nvSpPr>
        <p:spPr bwMode="auto">
          <a:xfrm>
            <a:off x="2853349" y="2302643"/>
            <a:ext cx="16991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lIns="0" tIns="0" rIns="0" bIns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itchFamily="34" charset="0"/>
              </a:rPr>
              <a:t>95</a:t>
            </a:r>
          </a:p>
        </p:txBody>
      </p:sp>
      <p:sp>
        <p:nvSpPr>
          <p:cNvPr id="23" name="Text Box 62"/>
          <p:cNvSpPr txBox="1">
            <a:spLocks noChangeArrowheads="1"/>
          </p:cNvSpPr>
          <p:nvPr/>
        </p:nvSpPr>
        <p:spPr bwMode="auto">
          <a:xfrm>
            <a:off x="2853349" y="2511781"/>
            <a:ext cx="16991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lIns="0" tIns="0" rIns="0" bIns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itchFamily="34" charset="0"/>
              </a:rPr>
              <a:t>72</a:t>
            </a:r>
          </a:p>
        </p:txBody>
      </p:sp>
      <p:sp>
        <p:nvSpPr>
          <p:cNvPr id="24" name="Text Box 63"/>
          <p:cNvSpPr txBox="1">
            <a:spLocks noChangeArrowheads="1"/>
          </p:cNvSpPr>
          <p:nvPr/>
        </p:nvSpPr>
        <p:spPr bwMode="auto">
          <a:xfrm>
            <a:off x="2853349" y="2787106"/>
            <a:ext cx="16991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lIns="0" tIns="0" rIns="0" bIns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itchFamily="34" charset="0"/>
              </a:rPr>
              <a:t>55</a:t>
            </a:r>
          </a:p>
        </p:txBody>
      </p:sp>
      <p:sp>
        <p:nvSpPr>
          <p:cNvPr id="25" name="Text Box 64"/>
          <p:cNvSpPr txBox="1">
            <a:spLocks noChangeArrowheads="1"/>
          </p:cNvSpPr>
          <p:nvPr/>
        </p:nvSpPr>
        <p:spPr bwMode="auto">
          <a:xfrm>
            <a:off x="2853349" y="3268053"/>
            <a:ext cx="16991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lIns="0" tIns="0" rIns="0" bIns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itchFamily="34" charset="0"/>
              </a:rPr>
              <a:t>36</a:t>
            </a:r>
          </a:p>
        </p:txBody>
      </p:sp>
      <p:sp>
        <p:nvSpPr>
          <p:cNvPr id="26" name="Text Box 67"/>
          <p:cNvSpPr txBox="1">
            <a:spLocks noChangeArrowheads="1"/>
          </p:cNvSpPr>
          <p:nvPr/>
        </p:nvSpPr>
        <p:spPr bwMode="auto">
          <a:xfrm>
            <a:off x="689945" y="1646237"/>
            <a:ext cx="328616" cy="2211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0" tIns="0" rIns="0" bIns="0">
            <a:spAutoFit/>
          </a:bodyPr>
          <a:lstStyle/>
          <a:p>
            <a:r>
              <a:rPr lang="en-US" sz="1400" b="1" dirty="0" err="1">
                <a:latin typeface="Arial" panose="020B0604020202020204" pitchFamily="34" charset="0"/>
                <a:cs typeface="Arial" pitchFamily="34" charset="0"/>
              </a:rPr>
              <a:t>kDa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 Box 61"/>
          <p:cNvSpPr txBox="1">
            <a:spLocks noChangeArrowheads="1"/>
          </p:cNvSpPr>
          <p:nvPr/>
        </p:nvSpPr>
        <p:spPr bwMode="auto">
          <a:xfrm>
            <a:off x="2753962" y="2124035"/>
            <a:ext cx="25487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lIns="0" tIns="0" rIns="0" bIns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itchFamily="34" charset="0"/>
              </a:rPr>
              <a:t>130</a:t>
            </a:r>
          </a:p>
        </p:txBody>
      </p:sp>
      <p:sp>
        <p:nvSpPr>
          <p:cNvPr id="28" name="Text Box 61"/>
          <p:cNvSpPr txBox="1">
            <a:spLocks noChangeArrowheads="1"/>
          </p:cNvSpPr>
          <p:nvPr/>
        </p:nvSpPr>
        <p:spPr bwMode="auto">
          <a:xfrm>
            <a:off x="2753962" y="1955696"/>
            <a:ext cx="25487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lIns="0" tIns="0" rIns="0" bIns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itchFamily="34" charset="0"/>
              </a:rPr>
              <a:t>250</a:t>
            </a:r>
          </a:p>
        </p:txBody>
      </p:sp>
      <p:sp>
        <p:nvSpPr>
          <p:cNvPr id="29" name="Text Box 64"/>
          <p:cNvSpPr txBox="1">
            <a:spLocks noChangeArrowheads="1"/>
          </p:cNvSpPr>
          <p:nvPr/>
        </p:nvSpPr>
        <p:spPr bwMode="auto">
          <a:xfrm>
            <a:off x="2853349" y="4117356"/>
            <a:ext cx="16991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lIns="0" tIns="0" rIns="0" bIns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itchFamily="34" charset="0"/>
              </a:rPr>
              <a:t>25</a:t>
            </a:r>
          </a:p>
        </p:txBody>
      </p:sp>
      <p:sp>
        <p:nvSpPr>
          <p:cNvPr id="31" name="Text Box 66"/>
          <p:cNvSpPr txBox="1">
            <a:spLocks noChangeArrowheads="1"/>
          </p:cNvSpPr>
          <p:nvPr/>
        </p:nvSpPr>
        <p:spPr bwMode="auto">
          <a:xfrm rot="19440000">
            <a:off x="3743735" y="1477371"/>
            <a:ext cx="577081" cy="2211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0" tIns="0" rIns="0" bIns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itchFamily="34" charset="0"/>
              </a:rPr>
              <a:t>M691A</a:t>
            </a:r>
          </a:p>
        </p:txBody>
      </p:sp>
      <p:sp>
        <p:nvSpPr>
          <p:cNvPr id="41" name="Rectangle 27"/>
          <p:cNvSpPr>
            <a:spLocks noChangeArrowheads="1"/>
          </p:cNvSpPr>
          <p:nvPr/>
        </p:nvSpPr>
        <p:spPr bwMode="auto">
          <a:xfrm rot="16200000">
            <a:off x="3608338" y="2551751"/>
            <a:ext cx="268877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l-GR" sz="1400" b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Δ</a:t>
            </a:r>
            <a:r>
              <a:rPr lang="en-US" sz="1400" b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Molar Absorption (M</a:t>
            </a:r>
            <a:r>
              <a:rPr lang="en-US" sz="1400" b="1" baseline="300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-1</a:t>
            </a:r>
            <a:r>
              <a:rPr lang="en-US" sz="1400" b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 cm</a:t>
            </a:r>
            <a:r>
              <a:rPr lang="en-US" sz="1400" b="1" baseline="300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-1</a:t>
            </a:r>
            <a:r>
              <a:rPr lang="en-US" sz="1400" b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) </a:t>
            </a:r>
            <a:endParaRPr lang="el-GR" sz="1400" b="1" baseline="30000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 Box 318"/>
          <p:cNvSpPr txBox="1">
            <a:spLocks noChangeArrowheads="1"/>
          </p:cNvSpPr>
          <p:nvPr/>
        </p:nvSpPr>
        <p:spPr bwMode="auto">
          <a:xfrm>
            <a:off x="5314337" y="4252846"/>
            <a:ext cx="3061903" cy="3159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itchFamily="34" charset="0"/>
              </a:rPr>
              <a:t>Wavelength (nm)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293274" y="838200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4716159" y="838200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cxnSp>
        <p:nvCxnSpPr>
          <p:cNvPr id="34" name="Straight Connector 33"/>
          <p:cNvCxnSpPr/>
          <p:nvPr/>
        </p:nvCxnSpPr>
        <p:spPr>
          <a:xfrm>
            <a:off x="7302972" y="995404"/>
            <a:ext cx="274320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7293545" y="1193366"/>
            <a:ext cx="274320" cy="0"/>
          </a:xfrm>
          <a:prstGeom prst="line">
            <a:avLst/>
          </a:prstGeom>
          <a:ln w="38100">
            <a:solidFill>
              <a:srgbClr val="0066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>
            <a:off x="7302972" y="1391328"/>
            <a:ext cx="274320" cy="0"/>
          </a:xfrm>
          <a:prstGeom prst="line">
            <a:avLst/>
          </a:prstGeom>
          <a:ln w="38100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7566947" y="844576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7566947" y="1042539"/>
            <a:ext cx="13404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itchFamily="34" charset="0"/>
              </a:rPr>
              <a:t>C615S/H616R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7585801" y="1234665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itchFamily="34" charset="0"/>
              </a:rPr>
              <a:t>M691A</a:t>
            </a:r>
          </a:p>
        </p:txBody>
      </p:sp>
      <p:pic>
        <p:nvPicPr>
          <p:cNvPr id="52" name="Picture 2"/>
          <p:cNvPicPr>
            <a:picLocks noChangeAspect="1" noChangeArrowheads="1"/>
          </p:cNvPicPr>
          <p:nvPr/>
        </p:nvPicPr>
        <p:blipFill>
          <a:blip r:embed="rId4" cstate="print">
            <a:grayscl/>
            <a:lum bright="-30000" contrast="44000"/>
          </a:blip>
          <a:srcRect l="76782" r="2580" b="33962"/>
          <a:stretch>
            <a:fillRect/>
          </a:stretch>
        </p:blipFill>
        <p:spPr bwMode="auto">
          <a:xfrm>
            <a:off x="3047455" y="1826507"/>
            <a:ext cx="1055748" cy="24619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3" name="Text Box 68"/>
          <p:cNvSpPr txBox="1">
            <a:spLocks noChangeArrowheads="1"/>
          </p:cNvSpPr>
          <p:nvPr/>
        </p:nvSpPr>
        <p:spPr bwMode="auto">
          <a:xfrm rot="19440000">
            <a:off x="3258376" y="1584785"/>
            <a:ext cx="149080" cy="2211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0" tIns="0" rIns="0" bIns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itchFamily="34" charset="0"/>
              </a:rPr>
              <a:t>M</a:t>
            </a:r>
          </a:p>
        </p:txBody>
      </p:sp>
      <p:sp>
        <p:nvSpPr>
          <p:cNvPr id="54" name="Text Box 67"/>
          <p:cNvSpPr txBox="1">
            <a:spLocks noChangeArrowheads="1"/>
          </p:cNvSpPr>
          <p:nvPr/>
        </p:nvSpPr>
        <p:spPr bwMode="auto">
          <a:xfrm>
            <a:off x="2726134" y="1599102"/>
            <a:ext cx="328616" cy="2211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0" tIns="0" rIns="0" bIns="0">
            <a:spAutoFit/>
          </a:bodyPr>
          <a:lstStyle/>
          <a:p>
            <a:r>
              <a:rPr lang="en-US" sz="1400" b="1" dirty="0" err="1">
                <a:latin typeface="Arial" panose="020B0604020202020204" pitchFamily="34" charset="0"/>
                <a:cs typeface="Arial" pitchFamily="34" charset="0"/>
              </a:rPr>
              <a:t>kDa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Text Box 61"/>
          <p:cNvSpPr txBox="1">
            <a:spLocks noChangeArrowheads="1"/>
          </p:cNvSpPr>
          <p:nvPr/>
        </p:nvSpPr>
        <p:spPr bwMode="auto">
          <a:xfrm>
            <a:off x="794101" y="2406339"/>
            <a:ext cx="16991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lIns="0" tIns="0" rIns="0" bIns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itchFamily="34" charset="0"/>
              </a:rPr>
              <a:t>95</a:t>
            </a:r>
          </a:p>
        </p:txBody>
      </p:sp>
      <p:sp>
        <p:nvSpPr>
          <p:cNvPr id="56" name="Text Box 62"/>
          <p:cNvSpPr txBox="1">
            <a:spLocks noChangeArrowheads="1"/>
          </p:cNvSpPr>
          <p:nvPr/>
        </p:nvSpPr>
        <p:spPr bwMode="auto">
          <a:xfrm>
            <a:off x="794101" y="2615477"/>
            <a:ext cx="16991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lIns="0" tIns="0" rIns="0" bIns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itchFamily="34" charset="0"/>
              </a:rPr>
              <a:t>72</a:t>
            </a:r>
          </a:p>
        </p:txBody>
      </p:sp>
      <p:sp>
        <p:nvSpPr>
          <p:cNvPr id="57" name="Text Box 63"/>
          <p:cNvSpPr txBox="1">
            <a:spLocks noChangeArrowheads="1"/>
          </p:cNvSpPr>
          <p:nvPr/>
        </p:nvSpPr>
        <p:spPr bwMode="auto">
          <a:xfrm>
            <a:off x="794101" y="2994499"/>
            <a:ext cx="16991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lIns="0" tIns="0" rIns="0" bIns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itchFamily="34" charset="0"/>
              </a:rPr>
              <a:t>55</a:t>
            </a:r>
          </a:p>
        </p:txBody>
      </p:sp>
      <p:sp>
        <p:nvSpPr>
          <p:cNvPr id="58" name="Text Box 64"/>
          <p:cNvSpPr txBox="1">
            <a:spLocks noChangeArrowheads="1"/>
          </p:cNvSpPr>
          <p:nvPr/>
        </p:nvSpPr>
        <p:spPr bwMode="auto">
          <a:xfrm>
            <a:off x="794101" y="3659845"/>
            <a:ext cx="16991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lIns="0" tIns="0" rIns="0" bIns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itchFamily="34" charset="0"/>
              </a:rPr>
              <a:t>36</a:t>
            </a:r>
          </a:p>
        </p:txBody>
      </p:sp>
      <p:sp>
        <p:nvSpPr>
          <p:cNvPr id="59" name="Text Box 61"/>
          <p:cNvSpPr txBox="1">
            <a:spLocks noChangeArrowheads="1"/>
          </p:cNvSpPr>
          <p:nvPr/>
        </p:nvSpPr>
        <p:spPr bwMode="auto">
          <a:xfrm>
            <a:off x="690404" y="2171169"/>
            <a:ext cx="25487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lIns="0" tIns="0" rIns="0" bIns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itchFamily="34" charset="0"/>
              </a:rPr>
              <a:t>130</a:t>
            </a:r>
          </a:p>
        </p:txBody>
      </p:sp>
      <p:sp>
        <p:nvSpPr>
          <p:cNvPr id="60" name="Text Box 61"/>
          <p:cNvSpPr txBox="1">
            <a:spLocks noChangeArrowheads="1"/>
          </p:cNvSpPr>
          <p:nvPr/>
        </p:nvSpPr>
        <p:spPr bwMode="auto">
          <a:xfrm>
            <a:off x="690404" y="1927414"/>
            <a:ext cx="25487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lIns="0" tIns="0" rIns="0" bIns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itchFamily="34" charset="0"/>
              </a:rPr>
              <a:t>250</a:t>
            </a:r>
          </a:p>
        </p:txBody>
      </p:sp>
      <p:sp>
        <p:nvSpPr>
          <p:cNvPr id="61" name="Text Box 64"/>
          <p:cNvSpPr txBox="1">
            <a:spLocks noChangeArrowheads="1"/>
          </p:cNvSpPr>
          <p:nvPr/>
        </p:nvSpPr>
        <p:spPr bwMode="auto">
          <a:xfrm>
            <a:off x="794101" y="4124403"/>
            <a:ext cx="16991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lIns="0" tIns="0" rIns="0" bIns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itchFamily="34" charset="0"/>
              </a:rPr>
              <a:t>25</a:t>
            </a:r>
          </a:p>
        </p:txBody>
      </p:sp>
      <p:sp>
        <p:nvSpPr>
          <p:cNvPr id="4" name="Прямоугольник 3"/>
          <p:cNvSpPr/>
          <p:nvPr/>
        </p:nvSpPr>
        <p:spPr>
          <a:xfrm>
            <a:off x="51254" y="5312082"/>
            <a:ext cx="8915399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me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binding mutations do not affect the overall structure of the BK gating ring.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2.5% SDS-PAGE of purified BK C-terminal domain (WT, mutants C615S/H616R and M691A): 5 µg of protein were loaded in each lane; the M lanes show protein MW standards.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perimposed Circular Dichroism (CD) spectra of WT and mutants gating ring. Mutations pertinent to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me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dulation of BK channels (C615S/H616R and M691A) did not alter the overall structure of the GR. Secondary structure compositions are reported in Table 1.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Line 150"/>
          <p:cNvSpPr>
            <a:spLocks noChangeShapeType="1"/>
          </p:cNvSpPr>
          <p:nvPr/>
        </p:nvSpPr>
        <p:spPr bwMode="auto">
          <a:xfrm flipV="1">
            <a:off x="4838819" y="2587366"/>
            <a:ext cx="628650" cy="4762"/>
          </a:xfrm>
          <a:prstGeom prst="line">
            <a:avLst/>
          </a:prstGeom>
          <a:noFill/>
          <a:ln w="76200">
            <a:solidFill>
              <a:srgbClr val="92D050"/>
            </a:solidFill>
            <a:round/>
            <a:headEnd/>
            <a:tailEnd/>
          </a:ln>
        </p:spPr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6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1143000" y="990600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0" name="Text Box 148"/>
          <p:cNvSpPr txBox="1">
            <a:spLocks noChangeArrowheads="1"/>
          </p:cNvSpPr>
          <p:nvPr/>
        </p:nvSpPr>
        <p:spPr bwMode="auto">
          <a:xfrm>
            <a:off x="1612512" y="2301137"/>
            <a:ext cx="538402" cy="2173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1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itchFamily="34" charset="0"/>
              </a:rPr>
              <a:t>I598 </a:t>
            </a:r>
            <a:endParaRPr kumimoji="0" lang="en-US" sz="1600" b="1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cs typeface="Arial" pitchFamily="34" charset="0"/>
            </a:endParaRPr>
          </a:p>
        </p:txBody>
      </p:sp>
      <p:sp>
        <p:nvSpPr>
          <p:cNvPr id="62" name="Line 150"/>
          <p:cNvSpPr>
            <a:spLocks noChangeShapeType="1"/>
          </p:cNvSpPr>
          <p:nvPr/>
        </p:nvSpPr>
        <p:spPr bwMode="auto">
          <a:xfrm flipV="1">
            <a:off x="1895203" y="2612418"/>
            <a:ext cx="628650" cy="4762"/>
          </a:xfrm>
          <a:prstGeom prst="line">
            <a:avLst/>
          </a:prstGeom>
          <a:noFill/>
          <a:ln w="76200">
            <a:solidFill>
              <a:srgbClr val="92D050"/>
            </a:solidFill>
            <a:round/>
            <a:headEnd/>
            <a:tailEnd/>
          </a:ln>
        </p:spPr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6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63" name="Rectangle 151"/>
          <p:cNvSpPr>
            <a:spLocks noChangeArrowheads="1"/>
          </p:cNvSpPr>
          <p:nvPr/>
        </p:nvSpPr>
        <p:spPr bwMode="auto">
          <a:xfrm>
            <a:off x="2265568" y="2452777"/>
            <a:ext cx="2856592" cy="274675"/>
          </a:xfrm>
          <a:prstGeom prst="rect">
            <a:avLst/>
          </a:prstGeom>
          <a:solidFill>
            <a:srgbClr val="3399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anchor="ctr"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6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64" name="Text Box 152"/>
          <p:cNvSpPr txBox="1">
            <a:spLocks noChangeArrowheads="1"/>
          </p:cNvSpPr>
          <p:nvPr/>
        </p:nvSpPr>
        <p:spPr bwMode="auto">
          <a:xfrm>
            <a:off x="2652594" y="2144040"/>
            <a:ext cx="630238" cy="190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itchFamily="34" charset="0"/>
              </a:rPr>
              <a:t>RK2</a:t>
            </a:r>
            <a:endParaRPr kumimoji="0" lang="en-US" sz="16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Rectangle 153"/>
          <p:cNvSpPr>
            <a:spLocks noChangeArrowheads="1"/>
          </p:cNvSpPr>
          <p:nvPr/>
        </p:nvSpPr>
        <p:spPr bwMode="auto">
          <a:xfrm>
            <a:off x="4562422" y="2454366"/>
            <a:ext cx="71219" cy="260562"/>
          </a:xfrm>
          <a:prstGeom prst="rect">
            <a:avLst/>
          </a:prstGeom>
          <a:solidFill>
            <a:srgbClr val="FF0000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6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69" name="Text Box 148"/>
          <p:cNvSpPr txBox="1">
            <a:spLocks noChangeArrowheads="1"/>
          </p:cNvSpPr>
          <p:nvPr/>
        </p:nvSpPr>
        <p:spPr bwMode="auto">
          <a:xfrm>
            <a:off x="5341956" y="2301137"/>
            <a:ext cx="654809" cy="23523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1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itchFamily="34" charset="0"/>
              </a:rPr>
              <a:t>S717</a:t>
            </a:r>
            <a:endParaRPr kumimoji="0" lang="en-US" sz="1600" b="1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Rectangle 153"/>
          <p:cNvSpPr>
            <a:spLocks noChangeArrowheads="1"/>
          </p:cNvSpPr>
          <p:nvPr/>
        </p:nvSpPr>
        <p:spPr bwMode="auto">
          <a:xfrm>
            <a:off x="2508153" y="2454366"/>
            <a:ext cx="71219" cy="260562"/>
          </a:xfrm>
          <a:prstGeom prst="rect">
            <a:avLst/>
          </a:prstGeom>
          <a:solidFill>
            <a:srgbClr val="FF0000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6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72" name="Rectangle 71"/>
          <p:cNvSpPr/>
          <p:nvPr/>
        </p:nvSpPr>
        <p:spPr>
          <a:xfrm>
            <a:off x="2085805" y="1838104"/>
            <a:ext cx="137409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1" i="1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itchFamily="34" charset="0"/>
              </a:rPr>
              <a:t>612</a:t>
            </a:r>
            <a:r>
              <a:rPr kumimoji="0" lang="en-US" sz="16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cs typeface="Arial" pitchFamily="34" charset="0"/>
              </a:rPr>
              <a:t>CKACH</a:t>
            </a:r>
            <a:r>
              <a:rPr kumimoji="0" lang="en-US" sz="1600" b="1" i="1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cs typeface="Arial" pitchFamily="34" charset="0"/>
              </a:rPr>
              <a:t>616</a:t>
            </a:r>
            <a:endParaRPr kumimoji="0" lang="en-US" sz="1600" b="1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4170178" y="1838104"/>
            <a:ext cx="9492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itchFamily="34" charset="0"/>
              </a:rPr>
              <a:t>Met-691</a:t>
            </a:r>
            <a:endParaRPr kumimoji="0" lang="en-US" sz="1600" b="1" i="1" u="none" strike="noStrike" kern="1200" cap="none" spc="0" normalizeH="0" baseline="3000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1" name="Straight Arrow Connector 80"/>
          <p:cNvCxnSpPr/>
          <p:nvPr/>
        </p:nvCxnSpPr>
        <p:spPr>
          <a:xfrm rot="-360000" flipH="1">
            <a:off x="2554320" y="2163781"/>
            <a:ext cx="25052" cy="250520"/>
          </a:xfrm>
          <a:prstGeom prst="straightConnector1">
            <a:avLst/>
          </a:prstGeom>
          <a:ln w="28575">
            <a:solidFill>
              <a:srgbClr val="FF0000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Arrow Connector 83"/>
          <p:cNvCxnSpPr/>
          <p:nvPr/>
        </p:nvCxnSpPr>
        <p:spPr>
          <a:xfrm rot="-360000" flipH="1">
            <a:off x="4596062" y="2163781"/>
            <a:ext cx="25052" cy="250520"/>
          </a:xfrm>
          <a:prstGeom prst="straightConnector1">
            <a:avLst/>
          </a:prstGeom>
          <a:ln w="28575">
            <a:solidFill>
              <a:srgbClr val="FF0000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 Box 61"/>
          <p:cNvSpPr txBox="1">
            <a:spLocks noChangeArrowheads="1"/>
          </p:cNvSpPr>
          <p:nvPr/>
        </p:nvSpPr>
        <p:spPr bwMode="auto">
          <a:xfrm>
            <a:off x="8029565" y="1999751"/>
            <a:ext cx="23564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lIns="0" tIns="0" rIns="0" bIns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itchFamily="34" charset="0"/>
              </a:rPr>
              <a:t>130</a:t>
            </a:r>
          </a:p>
        </p:txBody>
      </p:sp>
      <p:sp>
        <p:nvSpPr>
          <p:cNvPr id="32" name="Text Box 61"/>
          <p:cNvSpPr txBox="1">
            <a:spLocks noChangeArrowheads="1"/>
          </p:cNvSpPr>
          <p:nvPr/>
        </p:nvSpPr>
        <p:spPr bwMode="auto">
          <a:xfrm>
            <a:off x="8021019" y="2332432"/>
            <a:ext cx="157094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lIns="0" tIns="0" rIns="0" bIns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itchFamily="34" charset="0"/>
              </a:rPr>
              <a:t>95</a:t>
            </a:r>
          </a:p>
        </p:txBody>
      </p:sp>
      <p:sp>
        <p:nvSpPr>
          <p:cNvPr id="34" name="Text Box 61"/>
          <p:cNvSpPr txBox="1">
            <a:spLocks noChangeArrowheads="1"/>
          </p:cNvSpPr>
          <p:nvPr/>
        </p:nvSpPr>
        <p:spPr bwMode="auto">
          <a:xfrm>
            <a:off x="8029565" y="2671389"/>
            <a:ext cx="157094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lIns="0" tIns="0" rIns="0" bIns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itchFamily="34" charset="0"/>
              </a:rPr>
              <a:t>72</a:t>
            </a:r>
          </a:p>
        </p:txBody>
      </p:sp>
      <p:sp>
        <p:nvSpPr>
          <p:cNvPr id="35" name="Text Box 61"/>
          <p:cNvSpPr txBox="1">
            <a:spLocks noChangeArrowheads="1"/>
          </p:cNvSpPr>
          <p:nvPr/>
        </p:nvSpPr>
        <p:spPr bwMode="auto">
          <a:xfrm>
            <a:off x="8029565" y="3100265"/>
            <a:ext cx="157094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lIns="0" tIns="0" rIns="0" bIns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itchFamily="34" charset="0"/>
              </a:rPr>
              <a:t>55</a:t>
            </a:r>
          </a:p>
        </p:txBody>
      </p:sp>
      <p:pic>
        <p:nvPicPr>
          <p:cNvPr id="36" name="Picture 3"/>
          <p:cNvPicPr>
            <a:picLocks noChangeAspect="1" noChangeArrowheads="1"/>
          </p:cNvPicPr>
          <p:nvPr/>
        </p:nvPicPr>
        <p:blipFill>
          <a:blip r:embed="rId3" cstate="print">
            <a:grayscl/>
            <a:lum bright="-22000" contrast="60000"/>
          </a:blip>
          <a:srcRect t="6980" r="45736" b="215"/>
          <a:stretch>
            <a:fillRect/>
          </a:stretch>
        </p:blipFill>
        <p:spPr bwMode="auto">
          <a:xfrm>
            <a:off x="6928515" y="1804519"/>
            <a:ext cx="1076774" cy="18814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7" name="Text Box 66"/>
          <p:cNvSpPr txBox="1">
            <a:spLocks noChangeArrowheads="1"/>
          </p:cNvSpPr>
          <p:nvPr/>
        </p:nvSpPr>
        <p:spPr bwMode="auto">
          <a:xfrm rot="19440000">
            <a:off x="7094169" y="1321501"/>
            <a:ext cx="1155766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0" tIns="0" rIns="0" bIns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itchFamily="34" charset="0"/>
              </a:rPr>
              <a:t>CT/STREX</a:t>
            </a:r>
          </a:p>
        </p:txBody>
      </p:sp>
      <p:sp>
        <p:nvSpPr>
          <p:cNvPr id="38" name="Text Box 68"/>
          <p:cNvSpPr txBox="1">
            <a:spLocks noChangeArrowheads="1"/>
          </p:cNvSpPr>
          <p:nvPr/>
        </p:nvSpPr>
        <p:spPr bwMode="auto">
          <a:xfrm rot="21240000">
            <a:off x="7647408" y="1600118"/>
            <a:ext cx="149080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0" tIns="0" rIns="0" bIns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itchFamily="34" charset="0"/>
              </a:rPr>
              <a:t>M</a:t>
            </a:r>
          </a:p>
        </p:txBody>
      </p:sp>
      <p:sp>
        <p:nvSpPr>
          <p:cNvPr id="39" name="Text Box 184"/>
          <p:cNvSpPr txBox="1">
            <a:spLocks noChangeArrowheads="1"/>
          </p:cNvSpPr>
          <p:nvPr/>
        </p:nvSpPr>
        <p:spPr bwMode="auto">
          <a:xfrm>
            <a:off x="8016429" y="1603984"/>
            <a:ext cx="280526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 lIns="0" tIns="0" rIns="0" bIns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itchFamily="34" charset="0"/>
              </a:rPr>
              <a:t>kDa</a:t>
            </a: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1" name="Straight Connector 40"/>
          <p:cNvCxnSpPr/>
          <p:nvPr/>
        </p:nvCxnSpPr>
        <p:spPr>
          <a:xfrm flipH="1">
            <a:off x="1729565" y="2720146"/>
            <a:ext cx="1926266" cy="1981200"/>
          </a:xfrm>
          <a:prstGeom prst="line">
            <a:avLst/>
          </a:prstGeom>
          <a:ln/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 rot="-5220000" flipH="1">
            <a:off x="3607082" y="2793667"/>
            <a:ext cx="1981200" cy="1981200"/>
          </a:xfrm>
          <a:prstGeom prst="line">
            <a:avLst/>
          </a:prstGeom>
          <a:ln/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>
            <a:off x="6271454" y="1043746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1" name="Rectangle 50"/>
          <p:cNvSpPr/>
          <p:nvPr/>
        </p:nvSpPr>
        <p:spPr>
          <a:xfrm>
            <a:off x="3340398" y="2464000"/>
            <a:ext cx="609600" cy="246888"/>
          </a:xfrm>
          <a:prstGeom prst="rect">
            <a:avLst/>
          </a:prstGeom>
          <a:solidFill>
            <a:srgbClr val="00FFFF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3251640" y="2447245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itchFamily="34" charset="0"/>
              </a:rPr>
              <a:t>STREX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1683495" y="4669447"/>
            <a:ext cx="382417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1" i="1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632</a:t>
            </a:r>
            <a:r>
              <a:rPr kumimoji="0" lang="en-US" sz="16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KMSIYKRMRRACCFDCGRSERDCSCMSGRVRGNVDTLERAFPLSSVSVNDCSTSFRAF</a:t>
            </a:r>
            <a:r>
              <a:rPr kumimoji="0" lang="en-US" sz="1600" b="1" i="1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rPr>
              <a:t>690</a:t>
            </a:r>
            <a:endParaRPr kumimoji="0" lang="en-US" sz="1600" b="1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ea typeface="+mn-ea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52400" y="6058000"/>
            <a:ext cx="8763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(A)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artoon shows the purified STREX sequence (56 aa) inserted in the C-terminus of the human BK channel.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2.5% SDS-PAGE of purified BK C-terminal domain , which includes a splice variant called "STREX" in its structure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6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967953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457200" y="2236879"/>
            <a:ext cx="21031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i="1" dirty="0">
                <a:latin typeface="Arial" panose="020B0604020202020204" pitchFamily="34" charset="0"/>
                <a:cs typeface="Arial" pitchFamily="34" charset="0"/>
              </a:rPr>
              <a:t>   YFP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535957" y="2236878"/>
            <a:ext cx="20723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i="1" dirty="0">
                <a:latin typeface="Arial" panose="020B0604020202020204" pitchFamily="34" charset="0"/>
                <a:cs typeface="Arial" pitchFamily="34" charset="0"/>
              </a:rPr>
              <a:t>        WT BK- YFP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6629400" y="2236878"/>
            <a:ext cx="20857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i="1" dirty="0">
                <a:latin typeface="Arial" panose="020B0604020202020204" pitchFamily="34" charset="0"/>
                <a:cs typeface="Arial" pitchFamily="34" charset="0"/>
              </a:rPr>
              <a:t>C615S/H616R BK- YFP</a:t>
            </a:r>
          </a:p>
        </p:txBody>
      </p:sp>
      <p:sp>
        <p:nvSpPr>
          <p:cNvPr id="3" name="TextBox 2"/>
          <p:cNvSpPr txBox="1"/>
          <p:nvPr/>
        </p:nvSpPr>
        <p:spPr>
          <a:xfrm flipH="1">
            <a:off x="0" y="5715000"/>
            <a:ext cx="906780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Expression of the human BK channel in HEK293 cells. Lanes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-C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K293 cells transfected with  WT BK-YFP, and  C615S/H616R BK-YFP, YFP alone (control) respectively. Lanes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D-F 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uorescence spectra of the HEK293 cells lysates, which expressed with YFP alone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D),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BK-YFP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C615S/H616R BK-YFP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expression level of channel proteins was assessed using the fluorescence intensity of the YFP signal, which revealed an emission peak at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27(</a:t>
            </a:r>
            <a:r>
              <a:rPr lang="en-US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λem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27 n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 and excitation at 500 nm (</a:t>
            </a:r>
            <a:r>
              <a:rPr lang="en-US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λext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00 n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</p:txBody>
      </p:sp>
      <p:graphicFrame>
        <p:nvGraphicFramePr>
          <p:cNvPr id="22" name="Диаграмма 2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6463469"/>
              </p:ext>
            </p:extLst>
          </p:nvPr>
        </p:nvGraphicFramePr>
        <p:xfrm>
          <a:off x="6597597" y="3243441"/>
          <a:ext cx="2394003" cy="19202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5" name="Диаграмма 2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24237326"/>
              </p:ext>
            </p:extLst>
          </p:nvPr>
        </p:nvGraphicFramePr>
        <p:xfrm>
          <a:off x="586079" y="3243441"/>
          <a:ext cx="2468880" cy="19202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6" name="Диаграмма 2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38787106"/>
              </p:ext>
            </p:extLst>
          </p:nvPr>
        </p:nvGraphicFramePr>
        <p:xfrm>
          <a:off x="3430786" y="3243441"/>
          <a:ext cx="2468880" cy="19202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7" name="TextBox 26"/>
          <p:cNvSpPr txBox="1"/>
          <p:nvPr/>
        </p:nvSpPr>
        <p:spPr>
          <a:xfrm>
            <a:off x="1271879" y="4630281"/>
            <a:ext cx="1066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b="1" i="1" dirty="0">
                <a:solidFill>
                  <a:srgbClr val="0000FF"/>
                </a:solidFill>
                <a:latin typeface="Arial" pitchFamily="34" charset="0"/>
                <a:cs typeface="Arial" pitchFamily="34" charset="0"/>
              </a:rPr>
              <a:t>λ</a:t>
            </a:r>
            <a:r>
              <a:rPr lang="en-US" sz="1000" b="1" i="1" baseline="-25000" dirty="0">
                <a:solidFill>
                  <a:srgbClr val="0000FF"/>
                </a:solidFill>
                <a:latin typeface="Arial" pitchFamily="34" charset="0"/>
                <a:cs typeface="Arial" pitchFamily="34" charset="0"/>
              </a:rPr>
              <a:t>ext</a:t>
            </a:r>
            <a:r>
              <a:rPr lang="en-US" sz="1000" b="1" i="1" dirty="0">
                <a:solidFill>
                  <a:srgbClr val="0000FF"/>
                </a:solidFill>
                <a:latin typeface="Arial" pitchFamily="34" charset="0"/>
                <a:cs typeface="Arial" pitchFamily="34" charset="0"/>
              </a:rPr>
              <a:t> 500 nm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7169759" y="4630281"/>
            <a:ext cx="1066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b="1" i="1" dirty="0">
                <a:solidFill>
                  <a:srgbClr val="0000FF"/>
                </a:solidFill>
                <a:latin typeface="Arial" pitchFamily="34" charset="0"/>
                <a:cs typeface="Arial" pitchFamily="34" charset="0"/>
              </a:rPr>
              <a:t>λ</a:t>
            </a:r>
            <a:r>
              <a:rPr lang="en-US" sz="1000" b="1" i="1" baseline="-25000" dirty="0">
                <a:solidFill>
                  <a:srgbClr val="0000FF"/>
                </a:solidFill>
                <a:latin typeface="Arial" pitchFamily="34" charset="0"/>
                <a:cs typeface="Arial" pitchFamily="34" charset="0"/>
              </a:rPr>
              <a:t>ext</a:t>
            </a:r>
            <a:r>
              <a:rPr lang="en-US" sz="1000" b="1" i="1" dirty="0">
                <a:solidFill>
                  <a:srgbClr val="0000FF"/>
                </a:solidFill>
                <a:latin typeface="Arial" pitchFamily="34" charset="0"/>
                <a:cs typeface="Arial" pitchFamily="34" charset="0"/>
              </a:rPr>
              <a:t> 500 nm</a:t>
            </a:r>
          </a:p>
        </p:txBody>
      </p:sp>
      <p:sp>
        <p:nvSpPr>
          <p:cNvPr id="29" name="TextBox 28"/>
          <p:cNvSpPr txBox="1"/>
          <p:nvPr/>
        </p:nvSpPr>
        <p:spPr>
          <a:xfrm rot="16200000">
            <a:off x="-427530" y="3827652"/>
            <a:ext cx="169164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luorescence , CPS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692759" y="5163681"/>
            <a:ext cx="82988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Wavelength, nm 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311774" y="76200"/>
            <a:ext cx="3740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" name="TextBox 3"/>
          <p:cNvSpPr txBox="1"/>
          <p:nvPr/>
        </p:nvSpPr>
        <p:spPr>
          <a:xfrm flipH="1">
            <a:off x="3124200" y="76200"/>
            <a:ext cx="33287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" name="TextBox 5"/>
          <p:cNvSpPr txBox="1"/>
          <p:nvPr/>
        </p:nvSpPr>
        <p:spPr>
          <a:xfrm flipH="1">
            <a:off x="311759" y="2743200"/>
            <a:ext cx="533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260835" y="2801481"/>
            <a:ext cx="3556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343021" y="2877681"/>
            <a:ext cx="2933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6284612" y="307032"/>
            <a:ext cx="457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 flipH="1">
            <a:off x="6324600" y="76200"/>
            <a:ext cx="1870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23" name="Picture 6" descr="D:\AAA_TALEH\EXPERIMANTAL DATA\FLUORESCENCE EXPERIMENTS\STEADY STATE\11-07-16\Taleh Nov 07 2016\PAX\BK WT.jpg"/>
          <p:cNvPicPr preferRelativeResize="0">
            <a:picLocks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6659880" y="416910"/>
            <a:ext cx="2103120" cy="1737360"/>
          </a:xfrm>
          <a:prstGeom prst="rect">
            <a:avLst/>
          </a:prstGeom>
          <a:noFill/>
        </p:spPr>
      </p:pic>
      <p:pic>
        <p:nvPicPr>
          <p:cNvPr id="24" name="Picture 7" descr="D:\AAA_TALEH\EXPERIMANTAL DATA\FLUORESCENCE EXPERIMENTS\STEADY STATE\11-07-16\Taleh Nov 07 2016\PAX\MUTANT.jpg"/>
          <p:cNvPicPr preferRelativeResize="0">
            <a:picLocks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505200" y="493110"/>
            <a:ext cx="2103120" cy="1737360"/>
          </a:xfrm>
          <a:prstGeom prst="rect">
            <a:avLst/>
          </a:prstGeom>
          <a:noFill/>
        </p:spPr>
      </p:pic>
      <p:pic>
        <p:nvPicPr>
          <p:cNvPr id="31" name="Picture 8" descr="D:\AAA_TALEH\EXPERIMANTAL DATA\FLUORESCENCE EXPERIMENTS\STEADY STATE\11-07-16\Taleh Nov 07 2016\PAX\YFP.jpg"/>
          <p:cNvPicPr preferRelativeResize="0">
            <a:picLocks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457200" y="493110"/>
            <a:ext cx="2103120" cy="1737360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3762734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885</TotalTime>
  <Words>476</Words>
  <Application>Microsoft Office PowerPoint</Application>
  <PresentationFormat>On-screen Show (4:3)</PresentationFormat>
  <Paragraphs>93</Paragraphs>
  <Slides>4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ourier New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Taleh Yusifov</dc:creator>
  <cp:lastModifiedBy>MDPI</cp:lastModifiedBy>
  <cp:revision>1110</cp:revision>
  <dcterms:created xsi:type="dcterms:W3CDTF">2015-10-02T22:06:41Z</dcterms:created>
  <dcterms:modified xsi:type="dcterms:W3CDTF">2025-03-17T11:08:56Z</dcterms:modified>
</cp:coreProperties>
</file>